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1341" r:id="rId2"/>
    <p:sldId id="1330" r:id="rId3"/>
    <p:sldId id="1338" r:id="rId4"/>
    <p:sldId id="134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484CBB-C873-4CDA-8720-4841B522FC7B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11782A-EDF0-4411-9120-4179BAE63A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947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0057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886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37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D0DA9-5973-425B-A8AF-5544279B47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19590C-C2C5-4DE4-A465-30BDD417F7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C2E20-3369-48CC-92D8-C1622CD14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C591F-155D-4EFC-9DE0-E9F487CD9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B0585B-5820-4FD9-AA3D-59CF1ADB6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156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65566-7066-4B5A-AB13-0167FA925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3C7A15-2EB0-4557-9039-2C45DA9861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E0A9A4-42B6-4A65-9CEE-C3C5BD979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797F0C-B8F7-4122-BC89-34839CD63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A7B3C-C9C0-4857-B55D-9AF926130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973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2650AA-24B6-4C0B-BC91-B18B5DF665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72AD0E-2F9D-4B30-8587-0B37E6FE6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C0ED33-5D62-4BA1-A13C-FB653AC70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B4F16-1324-49AD-BE6D-5596FFE62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7CD20F-04BF-4DB4-A490-B945C8F75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997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117B5-E373-4855-8661-698781FBB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37A98-A63D-4F73-B000-6B67DD90E9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D75689-7DA3-482A-8D79-A576E2987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F37ABA-733F-47A8-8AEC-BF0E965AD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4BB5AB-9BE3-440D-BEB9-25C790A23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977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0AF58-074C-48E6-83BA-13AD613B2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B84E3C-62A6-4B11-A1A1-0ACC9E220F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C31B3B-1615-46C1-8E0F-44FFBCB51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1F8716-A5E9-4ADD-B7B5-CB639BC4E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054C66-0DE0-46B0-BFD9-79C459629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10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EDC61-E154-4258-919A-9B3B4CA1E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746C1-6902-48AA-822A-965255A760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0E3A00-CFDE-450F-946E-BFF6401D7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2E4862-DBEC-4540-BC6B-D951A9F29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ADC10-DD9E-4CB4-B323-39CB9BB93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3B3062-2E79-42B8-A122-007103C66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27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B5D27-2C73-4CDF-8C35-351ACD34B1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A7CBD9-B183-4E8C-BB2C-A2A833FEBF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4CDA20-943D-48F1-ACBC-7D4593EFB6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AC5725-854F-4EA8-BDEE-A38D343A8F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171B6E-BCBA-49C5-912B-18EB55583A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5BF85F-4141-49BB-BAD1-3A510D5AF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349397-7886-4C68-9159-E1872116A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A5ED91-8530-4C0B-84B9-A0FF03B22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12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2912C5-33E0-4F4F-B515-E759948B0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FF810A-7D8E-42C9-9D45-ED887245E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59C258-8281-4102-85E9-88A38CF57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F2FD51-EC63-4AB0-9756-4956973B8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580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4DC6F0F-DCF6-4283-87A5-30E010863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C50B49-5A54-4FC3-B15F-E31AAA800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FF0B52-A0C5-447A-9F63-53240FB46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062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31251B-9CDE-47DA-B185-14E483D531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4530A6-762D-46B9-B46A-7DD33759F6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CDEAB5-AF65-4115-AE34-549CAF626D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878207-015C-4D2B-A0C9-D65669CA4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229ACE-0EE9-46EE-9DF6-63DB16A16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40BC5D-F0EF-4FEF-80A5-B606557CB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350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00FA0-2820-4CFC-93EC-B7A0E6380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125776-E4CA-44FB-BE70-25CDAE0455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13ADB3-11C8-48FD-AC97-4B74B2191D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D437CD-2802-4039-A471-6E2753284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75EE9-A116-443C-A57C-6922E68A3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72F9C6-9CA7-4A88-9699-6C74AEBD0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82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AA371E-956E-437A-BF8D-49F8669B5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910E1F-61F9-4292-A756-CDD2F831F9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DEA11C-A23D-416F-9D47-34258D90BC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7B4BC-6BA3-42D0-A577-5114AE25250A}" type="datetimeFigureOut">
              <a:rPr lang="en-US" smtClean="0"/>
              <a:t>8/1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5059CC-AF4B-491B-B6C6-E8C3BAB4AB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07CBD-CED2-4A8A-B666-92F6E63336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185B96-413E-4A9C-88AD-D59CC7B3CA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467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39510F-4057-4CC8-A972-922BA8239C5A}"/>
              </a:ext>
            </a:extLst>
          </p:cNvPr>
          <p:cNvSpPr txBox="1"/>
          <p:nvPr/>
        </p:nvSpPr>
        <p:spPr>
          <a:xfrm>
            <a:off x="1049153" y="2156060"/>
            <a:ext cx="89899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 File: An illustration of an example of a 2-person mixture profile of which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R (EFM) &gt; 1000*LR (STRmix)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play of the per-locus LRs and profiles LRs obtained from EFM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orts assigned to a POI corresponding to the minor contributor.</a:t>
            </a:r>
          </a:p>
        </p:txBody>
      </p:sp>
    </p:spTree>
    <p:extLst>
      <p:ext uri="{BB962C8B-B14F-4D97-AF65-F5344CB8AC3E}">
        <p14:creationId xmlns:p14="http://schemas.microsoft.com/office/powerpoint/2010/main" val="1108729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LR (EFM) &gt;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5D198B0E-EE30-429F-8A9C-C18CAF2F4C59}"/>
              </a:ext>
            </a:extLst>
          </p:cNvPr>
          <p:cNvSpPr/>
          <p:nvPr/>
        </p:nvSpPr>
        <p:spPr>
          <a:xfrm>
            <a:off x="-172604" y="5193073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D09F604-1B72-42CE-9295-0F8F329CD30D}"/>
              </a:ext>
            </a:extLst>
          </p:cNvPr>
          <p:cNvSpPr/>
          <p:nvPr/>
        </p:nvSpPr>
        <p:spPr>
          <a:xfrm rot="16200000">
            <a:off x="-2179876" y="3161604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8C3B51F0-E0BE-473A-A87D-D2A33C1FD884}"/>
              </a:ext>
            </a:extLst>
          </p:cNvPr>
          <p:cNvGrpSpPr/>
          <p:nvPr/>
        </p:nvGrpSpPr>
        <p:grpSpPr>
          <a:xfrm>
            <a:off x="342802" y="1419320"/>
            <a:ext cx="3931920" cy="3796106"/>
            <a:chOff x="403625" y="1397524"/>
            <a:chExt cx="3931920" cy="3796106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03F29B9D-9928-4621-834A-B9401E043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0558EB21-2902-40F0-9863-EF5CC027660A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18370ABE-4D55-4C0B-B15A-2719744DC043}"/>
              </a:ext>
            </a:extLst>
          </p:cNvPr>
          <p:cNvGrpSpPr/>
          <p:nvPr/>
        </p:nvGrpSpPr>
        <p:grpSpPr>
          <a:xfrm>
            <a:off x="633371" y="1489629"/>
            <a:ext cx="2096781" cy="869929"/>
            <a:chOff x="5304134" y="5819738"/>
            <a:chExt cx="2096781" cy="869929"/>
          </a:xfrm>
          <a:noFill/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6DB947C2-BCA7-49FA-9BA6-CAEDF07AFDB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1E797BC3-64B5-441B-9A3C-C53F4D353EA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E518EA43-7D06-4AA0-84A3-9C8234078DE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27DBE9A-74B3-4C56-AFB8-AB76E7AAB7A7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3134308-4798-487A-9589-18002DEEB95F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D13913E-549D-421A-82F1-9018E4A4001F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Rounded Rectangle 6">
            <a:extLst>
              <a:ext uri="{FF2B5EF4-FFF2-40B4-BE49-F238E27FC236}">
                <a16:creationId xmlns:a16="http://schemas.microsoft.com/office/drawing/2014/main" id="{D44CE71C-D386-417F-A0E5-F9F1089E3F2F}"/>
              </a:ext>
            </a:extLst>
          </p:cNvPr>
          <p:cNvSpPr/>
          <p:nvPr/>
        </p:nvSpPr>
        <p:spPr>
          <a:xfrm>
            <a:off x="657598" y="707978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51B7E92F-B10B-4288-8431-F9BAD9E6E703}"/>
              </a:ext>
            </a:extLst>
          </p:cNvPr>
          <p:cNvCxnSpPr>
            <a:cxnSpLocks/>
          </p:cNvCxnSpPr>
          <p:nvPr/>
        </p:nvCxnSpPr>
        <p:spPr>
          <a:xfrm flipV="1">
            <a:off x="699900" y="1510404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Oval 59">
            <a:extLst>
              <a:ext uri="{FF2B5EF4-FFF2-40B4-BE49-F238E27FC236}">
                <a16:creationId xmlns:a16="http://schemas.microsoft.com/office/drawing/2014/main" id="{B25A4E5A-8995-4FDB-B75B-D28DF6A4E6C2}"/>
              </a:ext>
            </a:extLst>
          </p:cNvPr>
          <p:cNvSpPr/>
          <p:nvPr/>
        </p:nvSpPr>
        <p:spPr>
          <a:xfrm>
            <a:off x="1060286" y="3593108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064E220A-7E42-42A3-B420-6E8B8B611D95}"/>
              </a:ext>
            </a:extLst>
          </p:cNvPr>
          <p:cNvCxnSpPr>
            <a:cxnSpLocks/>
          </p:cNvCxnSpPr>
          <p:nvPr/>
        </p:nvCxnSpPr>
        <p:spPr>
          <a:xfrm flipH="1">
            <a:off x="1379030" y="3748074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3" name="Table 2">
            <a:extLst>
              <a:ext uri="{FF2B5EF4-FFF2-40B4-BE49-F238E27FC236}">
                <a16:creationId xmlns:a16="http://schemas.microsoft.com/office/drawing/2014/main" id="{6C9C0C58-A576-43C7-A0EF-86B307B12DA3}"/>
              </a:ext>
            </a:extLst>
          </p:cNvPr>
          <p:cNvGraphicFramePr>
            <a:graphicFrameLocks noGrp="1"/>
          </p:cNvGraphicFramePr>
          <p:nvPr/>
        </p:nvGraphicFramePr>
        <p:xfrm>
          <a:off x="5631759" y="1906407"/>
          <a:ext cx="5181211" cy="2821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15906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855960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609345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7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0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82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 - </a:t>
                      </a: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64" name="TextBox 63">
            <a:extLst>
              <a:ext uri="{FF2B5EF4-FFF2-40B4-BE49-F238E27FC236}">
                <a16:creationId xmlns:a16="http://schemas.microsoft.com/office/drawing/2014/main" id="{F29041E5-4ADC-4121-94E9-408EC2D02D86}"/>
              </a:ext>
            </a:extLst>
          </p:cNvPr>
          <p:cNvSpPr txBox="1"/>
          <p:nvPr/>
        </p:nvSpPr>
        <p:spPr>
          <a:xfrm>
            <a:off x="5186115" y="1412092"/>
            <a:ext cx="66630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treated with DNase I of total template amount 75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 </a:t>
            </a:r>
          </a:p>
          <a:p>
            <a:pPr lvl="0">
              <a:defRPr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2238351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41364"/>
    </mc:Choice>
    <mc:Fallback xmlns="">
      <p:transition spd="slow" advTm="41364"/>
    </mc:Fallback>
  </mc:AlternateContent>
  <p:extLst>
    <p:ext uri="{3A86A75C-4F4B-4683-9AE1-C65F6400EC91}">
      <p14:laserTraceLst xmlns:p14="http://schemas.microsoft.com/office/powerpoint/2010/main">
        <p14:tracePtLst>
          <p14:tracePt t="1607" x="12004675" y="4146550"/>
          <p14:tracePt t="1616" x="11890375" y="4186238"/>
          <p14:tracePt t="1623" x="11858625" y="4195763"/>
          <p14:tracePt t="1631" x="11804650" y="4205288"/>
          <p14:tracePt t="1643" x="11771313" y="4205288"/>
          <p14:tracePt t="1646" x="11763375" y="4205288"/>
          <p14:tracePt t="1656" x="11749088" y="4205288"/>
          <p14:tracePt t="1713" x="11739563" y="4205288"/>
          <p14:tracePt t="1721" x="11703050" y="4200525"/>
          <p14:tracePt t="1729" x="11693525" y="4200525"/>
          <p14:tracePt t="1737" x="11634788" y="4200525"/>
          <p14:tracePt t="1743" x="11625263" y="4200525"/>
          <p14:tracePt t="1751" x="11566525" y="4200525"/>
          <p14:tracePt t="1763" x="11420475" y="4200525"/>
          <p14:tracePt t="1767" x="11393488" y="4200525"/>
          <p14:tracePt t="1779" x="11218863" y="4200525"/>
          <p14:tracePt t="1781" x="11177588" y="4200525"/>
          <p14:tracePt t="1792" x="11064875" y="4200525"/>
          <p14:tracePt t="1802" x="10790238" y="4200525"/>
          <p14:tracePt t="1809" x="10712450" y="4200525"/>
          <p14:tracePt t="1818" x="10466388" y="4200525"/>
          <p14:tracePt t="1823" x="10410825" y="4200525"/>
          <p14:tracePt t="1833" x="10301288" y="4200525"/>
          <p14:tracePt t="1845" x="10150475" y="4173538"/>
          <p14:tracePt t="1847" x="10123488" y="4173538"/>
          <p14:tracePt t="1858" x="10036175" y="4173538"/>
          <p14:tracePt t="1864" x="10028238" y="4173538"/>
          <p14:tracePt t="1874" x="10013950" y="4173538"/>
          <p14:tracePt t="1883" x="10004425" y="4173538"/>
          <p14:tracePt t="2005" x="9994900" y="4173538"/>
          <p14:tracePt t="2014" x="9991725" y="4178300"/>
          <p14:tracePt t="2024" x="9982200" y="4183063"/>
          <p14:tracePt t="2047" x="9982200" y="4191000"/>
          <p14:tracePt t="11816" x="9955213" y="4200525"/>
          <p14:tracePt t="11829" x="4803775" y="3594100"/>
          <p14:tracePt t="11841" x="4657725" y="3594100"/>
          <p14:tracePt t="11850" x="4584700" y="3594100"/>
          <p14:tracePt t="11857" x="4511675" y="3594100"/>
          <p14:tracePt t="11866" x="4465638" y="3606800"/>
          <p14:tracePt t="11873" x="4448175" y="3606800"/>
          <p14:tracePt t="11879" x="4402138" y="3643313"/>
          <p14:tracePt t="11895" x="4314825" y="3684588"/>
          <p14:tracePt t="11906" x="4246563" y="3752850"/>
          <p14:tracePt t="11910" x="4229100" y="3762375"/>
          <p14:tracePt t="11922" x="4137025" y="3840163"/>
          <p14:tracePt t="11929" x="4054475" y="3908425"/>
          <p14:tracePt t="11936" x="3990975" y="3949700"/>
          <p14:tracePt t="11945" x="3927475" y="4000500"/>
          <p14:tracePt t="11952" x="3881438" y="4013200"/>
          <p14:tracePt t="11962" x="3817938" y="4076700"/>
          <p14:tracePt t="11973" x="3767138" y="4127500"/>
          <p14:tracePt t="11977" x="3735388" y="4137025"/>
          <p14:tracePt t="11986" x="3694113" y="4149725"/>
          <p14:tracePt t="12016" x="3684588" y="4149725"/>
          <p14:tracePt t="12027" x="3648075" y="4149725"/>
          <p14:tracePt t="12031" x="3643313" y="4146550"/>
          <p14:tracePt t="12042" x="3602038" y="4117975"/>
          <p14:tracePt t="12053" x="3594100" y="4110038"/>
          <p14:tracePt t="12058" x="3565525" y="4100513"/>
          <p14:tracePt t="12068" x="3562350" y="4090988"/>
          <p14:tracePt t="12087" x="3543300" y="4081463"/>
          <p14:tracePt t="12097" x="3525838" y="4064000"/>
          <p14:tracePt t="12108" x="3516313" y="4054475"/>
          <p14:tracePt t="12117" x="3497263" y="4027488"/>
          <p14:tracePt t="12122" x="3489325" y="4027488"/>
          <p14:tracePt t="12132" x="3475038" y="4022725"/>
          <p14:tracePt t="12138" x="3443288" y="4022725"/>
          <p14:tracePt t="12147" x="3402013" y="4022725"/>
          <p14:tracePt t="12152" x="3382963" y="4022725"/>
          <p14:tracePt t="12162" x="3287713" y="4022725"/>
          <p14:tracePt t="12172" x="3255963" y="4022725"/>
          <p14:tracePt t="12179" x="3214688" y="4022725"/>
          <p14:tracePt t="12189" x="3173413" y="4022725"/>
          <p14:tracePt t="12194" x="3155950" y="4022725"/>
          <p14:tracePt t="12205" x="3119438" y="4022725"/>
          <p14:tracePt t="12213" x="3086100" y="4022725"/>
          <p14:tracePt t="12217" x="3059113" y="4022725"/>
          <p14:tracePt t="12227" x="3027363" y="4022725"/>
          <p14:tracePt t="12233" x="3022600" y="4022725"/>
          <p14:tracePt t="12243" x="2922588" y="4022725"/>
          <p14:tracePt t="12253" x="2813050" y="4022725"/>
          <p14:tracePt t="12258" x="2781300" y="4022725"/>
          <p14:tracePt t="12267" x="2740025" y="4022725"/>
          <p14:tracePt t="12273" x="2725738" y="4022725"/>
          <p14:tracePt t="12283" x="2679700" y="4037013"/>
          <p14:tracePt t="12293" x="2640013" y="4049713"/>
          <p14:tracePt t="12299" x="2620963" y="4049713"/>
          <p14:tracePt t="12310" x="2579688" y="4059238"/>
          <p14:tracePt t="12313" x="2562225" y="4068763"/>
          <p14:tracePt t="12323" x="2489200" y="4090988"/>
          <p14:tracePt t="12334" x="2374900" y="4117975"/>
          <p14:tracePt t="12341" x="2301875" y="4117975"/>
          <p14:tracePt t="12349" x="2187575" y="4164013"/>
          <p14:tracePt t="12356" x="2155825" y="4164013"/>
          <p14:tracePt t="12363" x="1995488" y="4178300"/>
          <p14:tracePt t="12374" x="1866900" y="4178300"/>
          <p14:tracePt t="12380" x="1757363" y="4178300"/>
          <p14:tracePt t="12390" x="1684338" y="4178300"/>
          <p14:tracePt t="12394" x="1644650" y="4178300"/>
          <p14:tracePt t="12406" x="1516063" y="4154488"/>
          <p14:tracePt t="12416" x="1470025" y="4146550"/>
          <p14:tracePt t="12423" x="1443038" y="4146550"/>
          <p14:tracePt t="12429" x="1433513" y="4146550"/>
          <p14:tracePt t="12436" x="1423988" y="4137025"/>
          <p14:tracePt t="12445" x="1411288" y="4137025"/>
          <p14:tracePt t="12557" x="1379538" y="4127500"/>
          <p14:tracePt t="12566" x="1374775" y="4117975"/>
          <p14:tracePt t="12577" x="1365250" y="4110038"/>
          <p14:tracePt t="12583" x="1365250" y="4105275"/>
          <p14:tracePt t="12603" x="1355725" y="4076700"/>
          <p14:tracePt t="12613" x="1355725" y="4068763"/>
          <p14:tracePt t="12627" x="1347788" y="4064000"/>
          <p14:tracePt t="12634" x="1338263" y="4054475"/>
          <p14:tracePt t="12648" x="1338263" y="4044950"/>
          <p14:tracePt t="12667" x="1338263" y="4037013"/>
          <p14:tracePt t="12681" x="1333500" y="4032250"/>
          <p14:tracePt t="13798" x="1360488" y="3976688"/>
          <p14:tracePt t="13802" x="1493838" y="3903663"/>
          <p14:tracePt t="13809" x="1543050" y="3852863"/>
          <p14:tracePt t="13819" x="1749425" y="3716338"/>
          <p14:tracePt t="13825" x="1885950" y="3594100"/>
          <p14:tracePt t="13832" x="1985963" y="3552825"/>
          <p14:tracePt t="13841" x="2036763" y="3502025"/>
          <p14:tracePt t="13848" x="2319338" y="3333750"/>
          <p14:tracePt t="13858" x="2530475" y="3227388"/>
          <p14:tracePt t="13862" x="2725738" y="3159125"/>
          <p14:tracePt t="13873" x="2908300" y="3114675"/>
          <p14:tracePt t="13879" x="3005138" y="3100388"/>
          <p14:tracePt t="13890" x="3479800" y="3059113"/>
          <p14:tracePt t="13898" x="3679825" y="3044825"/>
          <p14:tracePt t="13902" x="3862388" y="3013075"/>
          <p14:tracePt t="13914" x="3990975" y="3000375"/>
          <p14:tracePt t="13918" x="4032250" y="3000375"/>
          <p14:tracePt t="13929" x="4146550" y="3000375"/>
          <p14:tracePt t="13941" x="4178300" y="2981325"/>
          <p14:tracePt t="13944" x="4232275" y="2968625"/>
          <p14:tracePt t="13957" x="4292600" y="2954338"/>
          <p14:tracePt t="13958" x="4310063" y="2944813"/>
          <p14:tracePt t="13967" x="4341813" y="2935288"/>
          <p14:tracePt t="13978" x="4360863" y="2917825"/>
          <p14:tracePt t="13983" x="4392613" y="2894013"/>
          <p14:tracePt t="13994" x="4411663" y="2894013"/>
          <p14:tracePt t="13997" x="4414838" y="2890838"/>
          <p14:tracePt t="14008" x="4433888" y="2881313"/>
          <p14:tracePt t="14020" x="4465638" y="2871788"/>
          <p14:tracePt t="14023" x="4492625" y="2849563"/>
          <p14:tracePt t="14034" x="4525963" y="2830513"/>
          <p14:tracePt t="14040" x="4533900" y="2830513"/>
          <p14:tracePt t="14049" x="4611688" y="2784475"/>
          <p14:tracePt t="14061" x="4672013" y="2762250"/>
          <p14:tracePt t="14063" x="4740275" y="2708275"/>
          <p14:tracePt t="14074" x="4767263" y="2689225"/>
          <p14:tracePt t="14080" x="4784725" y="2679700"/>
          <p14:tracePt t="14091" x="4891088" y="2638425"/>
          <p14:tracePt t="14099" x="4935538" y="2601913"/>
          <p14:tracePt t="14106" x="5000625" y="2579688"/>
          <p14:tracePt t="14114" x="5045075" y="2543175"/>
          <p14:tracePt t="14122" x="5054600" y="2516188"/>
          <p14:tracePt t="14130" x="5105400" y="2424113"/>
          <p14:tracePt t="14140" x="5132388" y="2365375"/>
          <p14:tracePt t="14146" x="5187950" y="2282825"/>
          <p14:tracePt t="14156" x="5224463" y="2219325"/>
          <p14:tracePt t="14160" x="5224463" y="2200275"/>
          <p14:tracePt t="14172" x="5237163" y="2141538"/>
          <p14:tracePt t="14180" x="5273675" y="2095500"/>
          <p14:tracePt t="14188" x="5283200" y="2063750"/>
          <p14:tracePt t="14196" x="5292725" y="2036763"/>
          <p14:tracePt t="14206" x="5310188" y="2005013"/>
          <p14:tracePt t="14222" x="5324475" y="1985963"/>
          <p14:tracePt t="14240" x="5329238" y="1973263"/>
          <p14:tracePt t="14252" x="5338763" y="1954213"/>
          <p14:tracePt t="14261" x="5356225" y="1935163"/>
          <p14:tracePt t="14265" x="5378450" y="1903413"/>
          <p14:tracePt t="14276" x="5411788" y="1871663"/>
          <p14:tracePt t="14281" x="5438775" y="1849438"/>
          <p14:tracePt t="14292" x="5475288" y="1808163"/>
          <p14:tracePt t="14301" x="5507038" y="1776413"/>
          <p14:tracePt t="14308" x="5516563" y="1766888"/>
          <p14:tracePt t="14316" x="5529263" y="1749425"/>
          <p14:tracePt t="14323" x="5543550" y="1716088"/>
          <p14:tracePt t="14331" x="5561013" y="1698625"/>
          <p14:tracePt t="14457" x="5561013" y="1689100"/>
          <p14:tracePt t="14497" x="5557838" y="1689100"/>
          <p14:tracePt t="14601" x="5548313" y="1693863"/>
          <p14:tracePt t="14631" x="5548313" y="1712913"/>
          <p14:tracePt t="14641" x="5548313" y="1720850"/>
          <p14:tracePt t="14644" x="5548313" y="1725613"/>
          <p14:tracePt t="14654" x="5538788" y="1752600"/>
          <p14:tracePt t="14663" x="5538788" y="1771650"/>
          <p14:tracePt t="14669" x="5538788" y="1798638"/>
          <p14:tracePt t="14679" x="5538788" y="1830388"/>
          <p14:tracePt t="14683" x="5538788" y="1835150"/>
          <p14:tracePt t="14693" x="5538788" y="1898650"/>
          <p14:tracePt t="14711" x="5538788" y="1912938"/>
          <p14:tracePt t="14725" x="5538788" y="1922463"/>
          <p14:tracePt t="14903" x="5538788" y="1931988"/>
          <p14:tracePt t="14912" x="5553075" y="1931988"/>
          <p14:tracePt t="14927" x="5580063" y="1931988"/>
          <p14:tracePt t="14936" x="5626100" y="1931988"/>
          <p14:tracePt t="14947" x="5667375" y="1931988"/>
          <p14:tracePt t="14951" x="5711825" y="1912938"/>
          <p14:tracePt t="14961" x="5803900" y="1898650"/>
          <p14:tracePt t="14967" x="5826125" y="1866900"/>
          <p14:tracePt t="14977" x="5927725" y="1854200"/>
          <p14:tracePt t="14987" x="6018213" y="1839913"/>
          <p14:tracePt t="14992" x="6076950" y="1830388"/>
          <p14:tracePt t="15001" x="6173788" y="1817688"/>
          <p14:tracePt t="15007" x="6183313" y="1817688"/>
          <p14:tracePt t="15018" x="6242050" y="1808163"/>
          <p14:tracePt t="15028" x="6288088" y="1793875"/>
          <p14:tracePt t="15032" x="6292850" y="1793875"/>
          <p14:tracePt t="15042" x="6319838" y="1793875"/>
          <p14:tracePt t="15051" x="6329363" y="1793875"/>
          <p14:tracePt t="15098" x="6334125" y="1793875"/>
          <p14:tracePt t="15108" x="6342063" y="1793875"/>
          <p14:tracePt t="15117" x="6351588" y="1793875"/>
          <p14:tracePt t="15128" x="6378575" y="1793875"/>
          <p14:tracePt t="15147" x="6407150" y="1793875"/>
          <p14:tracePt t="15156" x="6415088" y="1793875"/>
          <p14:tracePt t="15163" x="6429375" y="1793875"/>
          <p14:tracePt t="15175" x="6461125" y="1798638"/>
          <p14:tracePt t="15184" x="6470650" y="1798638"/>
          <p14:tracePt t="15191" x="6483350" y="1798638"/>
          <p14:tracePt t="15194" x="6502400" y="1798638"/>
          <p14:tracePt t="15205" x="6543675" y="1798638"/>
          <p14:tracePt t="15210" x="6553200" y="1808163"/>
          <p14:tracePt t="15222" x="6580188" y="1808163"/>
          <p14:tracePt t="15230" x="6607175" y="1808163"/>
          <p14:tracePt t="15234" x="6638925" y="1817688"/>
          <p14:tracePt t="15244" x="6694488" y="1830388"/>
          <p14:tracePt t="15256" x="6740525" y="1854200"/>
          <p14:tracePt t="15260" x="6757988" y="1854200"/>
          <p14:tracePt t="15273" x="6840538" y="1862138"/>
          <p14:tracePt t="15289" x="6959600" y="1885950"/>
          <p14:tracePt t="15299" x="7027863" y="1885950"/>
          <p14:tracePt t="15310" x="7081838" y="1885950"/>
          <p14:tracePt t="15315" x="7123113" y="1885950"/>
          <p14:tracePt t="15326" x="7154863" y="1885950"/>
          <p14:tracePt t="15330" x="7159625" y="1885950"/>
          <p14:tracePt t="15340" x="7186613" y="1885950"/>
          <p14:tracePt t="15909" x="7196138" y="1885950"/>
          <p14:tracePt t="15950" x="7205663" y="1885950"/>
          <p14:tracePt t="15980" x="7210425" y="1885950"/>
          <p14:tracePt t="15992" x="7227888" y="1885950"/>
          <p14:tracePt t="16002" x="7237413" y="1885950"/>
          <p14:tracePt t="16076" x="7251700" y="1881188"/>
          <p14:tracePt t="17736" x="7269163" y="1881188"/>
          <p14:tracePt t="17745" x="7300913" y="1881188"/>
          <p14:tracePt t="17752" x="7305675" y="1881188"/>
          <p14:tracePt t="17756" x="7324725" y="1881188"/>
          <p14:tracePt t="17765" x="7392988" y="1881188"/>
          <p14:tracePt t="17776" x="7419975" y="1881188"/>
          <p14:tracePt t="17782" x="7429500" y="1881188"/>
          <p14:tracePt t="17792" x="7488238" y="1881188"/>
          <p14:tracePt t="17796" x="7507288" y="1881188"/>
          <p14:tracePt t="17806" x="7575550" y="1881188"/>
          <p14:tracePt t="17816" x="7607300" y="1881188"/>
          <p14:tracePt t="17823" x="7626350" y="1881188"/>
          <p14:tracePt t="17832" x="7740650" y="1881188"/>
          <p14:tracePt t="17839" x="7767638" y="1881188"/>
          <p14:tracePt t="17848" x="7881938" y="1881188"/>
          <p14:tracePt t="17859" x="7935913" y="1881188"/>
          <p14:tracePt t="17861" x="7996238" y="1881188"/>
          <p14:tracePt t="17873" x="8123238" y="1881188"/>
          <p14:tracePt t="17878" x="8150225" y="1881188"/>
          <p14:tracePt t="17894" x="8264525" y="1881188"/>
          <p14:tracePt t="17897" x="8337550" y="1881188"/>
          <p14:tracePt t="17901" x="8356600" y="1881188"/>
          <p14:tracePt t="17912" x="8424863" y="1881188"/>
          <p14:tracePt t="17918" x="8434388" y="1881188"/>
          <p14:tracePt t="17928" x="8451850" y="1862138"/>
          <p14:tracePt t="17939" x="8461375" y="1862138"/>
          <p14:tracePt t="18028" x="8475663" y="1862138"/>
          <p14:tracePt t="18064" x="8483600" y="1862138"/>
          <p14:tracePt t="18093" x="8497888" y="1862138"/>
          <p14:tracePt t="18103" x="8507413" y="1862138"/>
          <p14:tracePt t="18113" x="8534400" y="1862138"/>
          <p14:tracePt t="18124" x="8543925" y="1862138"/>
          <p14:tracePt t="18133" x="8566150" y="1862138"/>
          <p14:tracePt t="18151" x="8585200" y="1862138"/>
          <p14:tracePt t="18161" x="8602663" y="1862138"/>
          <p14:tracePt t="18172" x="8629650" y="1862138"/>
          <p14:tracePt t="18180" x="8648700" y="1862138"/>
          <p14:tracePt t="18189" x="8658225" y="1862138"/>
          <p14:tracePt t="18196" x="8685213" y="1862138"/>
          <p14:tracePt t="18200" x="8694738" y="1862138"/>
          <p14:tracePt t="18210" x="8707438" y="1862138"/>
          <p14:tracePt t="18222" x="8739188" y="1862138"/>
          <p14:tracePt t="18230" x="8743950" y="1862138"/>
          <p14:tracePt t="18238" x="8753475" y="1862138"/>
          <p14:tracePt t="18246" x="8763000" y="1862138"/>
          <p14:tracePt t="18256" x="8767763" y="1862138"/>
          <p14:tracePt t="18266" x="8775700" y="1862138"/>
          <p14:tracePt t="18279" x="8785225" y="1862138"/>
          <p14:tracePt t="18292" x="8789988" y="1862138"/>
          <p14:tracePt t="18311" x="8809038" y="1862138"/>
          <p14:tracePt t="18508" x="8826500" y="1862138"/>
          <p14:tracePt t="18513" x="8836025" y="1862138"/>
          <p14:tracePt t="18518" x="8840788" y="1862138"/>
          <p14:tracePt t="18525" x="8848725" y="1862138"/>
          <p14:tracePt t="18534" x="8867775" y="1862138"/>
          <p14:tracePt t="18544" x="8885238" y="1862138"/>
          <p14:tracePt t="18548" x="8890000" y="1862138"/>
          <p14:tracePt t="18559" x="8926513" y="1862138"/>
          <p14:tracePt t="18564" x="8945563" y="1862138"/>
          <p14:tracePt t="18575" x="8999538" y="1862138"/>
          <p14:tracePt t="18584" x="9028113" y="1862138"/>
          <p14:tracePt t="18590" x="9036050" y="1862138"/>
          <p14:tracePt t="18598" x="9072563" y="1862138"/>
          <p14:tracePt t="18606" x="9091613" y="1862138"/>
          <p14:tracePt t="18614" x="9109075" y="1862138"/>
          <p14:tracePt t="18624" x="9137650" y="1862138"/>
          <p14:tracePt t="18634" x="9155113" y="1862138"/>
          <p14:tracePt t="18640" x="9164638" y="1862138"/>
          <p14:tracePt t="18655" x="9178925" y="1862138"/>
          <p14:tracePt t="18680" x="9186863" y="1862138"/>
          <p14:tracePt t="18694" x="9196388" y="1862138"/>
          <p14:tracePt t="18705" x="9201150" y="1862138"/>
          <p14:tracePt t="18710" x="9210675" y="1862138"/>
          <p14:tracePt t="18776" x="9218613" y="1862138"/>
          <p14:tracePt t="18786" x="9223375" y="1866900"/>
          <p14:tracePt t="18796" x="9232900" y="1866900"/>
          <p14:tracePt t="18811" x="9242425" y="1876425"/>
          <p14:tracePt t="18820" x="9251950" y="1876425"/>
          <p14:tracePt t="18826" x="9255125" y="1876425"/>
          <p14:tracePt t="18829" x="9274175" y="1885950"/>
          <p14:tracePt t="18846" x="9283700" y="1885950"/>
          <p14:tracePt t="18857" x="9296400" y="1885950"/>
          <p14:tracePt t="18871" x="9315450" y="1885950"/>
          <p14:tracePt t="18877" x="9347200" y="1895475"/>
          <p14:tracePt t="18888" x="9356725" y="1895475"/>
          <p14:tracePt t="18896" x="9378950" y="1903413"/>
          <p14:tracePt t="18906" x="9398000" y="1903413"/>
          <p14:tracePt t="18911" x="9405938" y="1903413"/>
          <p14:tracePt t="18921" x="9442450" y="1912938"/>
          <p14:tracePt t="18926" x="9451975" y="1912938"/>
          <p14:tracePt t="18939" x="9475788" y="1912938"/>
          <p14:tracePt t="18946" x="9493250" y="1912938"/>
          <p14:tracePt t="18952" x="9502775" y="1912938"/>
          <p14:tracePt t="18963" x="9539288" y="1912938"/>
          <p14:tracePt t="18965" x="9548813" y="1912938"/>
          <p14:tracePt t="18976" x="9607550" y="1912938"/>
          <p14:tracePt t="18989" x="9648825" y="1912938"/>
          <p14:tracePt t="18992" x="9666288" y="1912938"/>
          <p14:tracePt t="19002" x="9734550" y="1912938"/>
          <p14:tracePt t="19008" x="9753600" y="1912938"/>
          <p14:tracePt t="19018" x="9836150" y="1912938"/>
          <p14:tracePt t="19028" x="9877425" y="1912938"/>
          <p14:tracePt t="19031" x="9894888" y="1912938"/>
          <p14:tracePt t="19042" x="9950450" y="1903413"/>
          <p14:tracePt t="19048" x="9982200" y="1895475"/>
          <p14:tracePt t="19059" x="10009188" y="1895475"/>
          <p14:tracePt t="19067" x="10028238" y="1895475"/>
          <p14:tracePt t="19072" x="10036175" y="1895475"/>
          <p14:tracePt t="19081" x="10045700" y="1895475"/>
          <p14:tracePt t="19406" x="10050463" y="1895475"/>
          <p14:tracePt t="19412" x="10059988" y="1895475"/>
          <p14:tracePt t="19420" x="10077450" y="1876425"/>
          <p14:tracePt t="19429" x="10118725" y="1858963"/>
          <p14:tracePt t="19439" x="10128250" y="1858963"/>
          <p14:tracePt t="19453" x="10145713" y="1858963"/>
          <p14:tracePt t="19461" x="10164763" y="1844675"/>
          <p14:tracePt t="19473" x="10169525" y="1844675"/>
          <p14:tracePt t="19495" x="10179050" y="1839913"/>
          <p14:tracePt t="19502" x="10186988" y="1839913"/>
          <p14:tracePt t="19512" x="10206038" y="1830388"/>
          <p14:tracePt t="19523" x="10218738" y="1830388"/>
          <p14:tracePt t="19526" x="10228263" y="1822450"/>
          <p14:tracePt t="19531" x="10247313" y="1812925"/>
          <p14:tracePt t="19542" x="10279063" y="1803400"/>
          <p14:tracePt t="19558" x="10283825" y="1803400"/>
          <p14:tracePt t="19568" x="10291763" y="1793875"/>
          <p14:tracePt t="19573" x="10301288" y="1781175"/>
          <p14:tracePt t="19581" x="10310813" y="1781175"/>
          <p14:tracePt t="19778" x="10315575" y="1781175"/>
          <p14:tracePt t="19784" x="10325100" y="1781175"/>
          <p14:tracePt t="19794" x="10325100" y="1789113"/>
          <p14:tracePt t="19800" x="10325100" y="1808163"/>
          <p14:tracePt t="19825" x="10325100" y="1812925"/>
          <p14:tracePt t="19835" x="10325100" y="1822450"/>
          <p14:tracePt t="19844" x="10325100" y="1830388"/>
          <p14:tracePt t="21494" x="10342563" y="1849438"/>
          <p14:tracePt t="21498" x="10410825" y="1849438"/>
          <p14:tracePt t="21504" x="10452100" y="1849438"/>
          <p14:tracePt t="21514" x="10520363" y="1849438"/>
          <p14:tracePt t="21523" x="10612438" y="1849438"/>
          <p14:tracePt t="21530" x="10690225" y="1849438"/>
          <p14:tracePt t="21544" x="10799763" y="1849438"/>
          <p14:tracePt t="21557" x="10841038" y="1849438"/>
          <p14:tracePt t="21561" x="10844213" y="1849438"/>
          <p14:tracePt t="21575" x="10853738" y="1849438"/>
          <p14:tracePt t="22326" x="10863263" y="1849438"/>
          <p14:tracePt t="23961" x="10868025" y="1849438"/>
          <p14:tracePt t="24030" x="10877550" y="1854200"/>
          <p14:tracePt t="25679" x="10877550" y="1871663"/>
          <p14:tracePt t="25690" x="10780713" y="1898650"/>
          <p14:tracePt t="25695" x="10739438" y="1908175"/>
          <p14:tracePt t="25705" x="10515600" y="2012950"/>
          <p14:tracePt t="25709" x="10437813" y="2022475"/>
          <p14:tracePt t="25722" x="10218738" y="2109788"/>
          <p14:tracePt t="25730" x="10086975" y="2136775"/>
          <p14:tracePt t="25740" x="10067925" y="2159000"/>
          <p14:tracePt t="25746" x="9936163" y="2182813"/>
          <p14:tracePt t="25750" x="9918700" y="2192338"/>
          <p14:tracePt t="25760" x="9858375" y="2214563"/>
          <p14:tracePt t="25772" x="9817100" y="2214563"/>
          <p14:tracePt t="25822" x="9790113" y="2214563"/>
          <p14:tracePt t="25831" x="9780588" y="2224088"/>
          <p14:tracePt t="25842" x="9731375" y="2241550"/>
          <p14:tracePt t="25852" x="9702800" y="2255838"/>
          <p14:tracePt t="25859" x="9685338" y="2265363"/>
          <p14:tracePt t="25865" x="9612313" y="2273300"/>
          <p14:tracePt t="25872" x="9580563" y="2305050"/>
          <p14:tracePt t="25881" x="9502775" y="2319338"/>
          <p14:tracePt t="25892" x="9461500" y="2328863"/>
          <p14:tracePt t="25895" x="9429750" y="2351088"/>
          <p14:tracePt t="25908" x="9402763" y="2360613"/>
          <p14:tracePt t="25912" x="9393238" y="2360613"/>
          <p14:tracePt t="25922" x="9374188" y="2370138"/>
          <p14:tracePt t="25932" x="9356725" y="2378075"/>
          <p14:tracePt t="26028" x="9347200" y="2397125"/>
          <p14:tracePt t="26320" x="9369425" y="2397125"/>
          <p14:tracePt t="26326" x="9456738" y="2397125"/>
          <p14:tracePt t="26329" x="9498013" y="2397125"/>
          <p14:tracePt t="26340" x="9653588" y="2397125"/>
          <p14:tracePt t="26349" x="9780588" y="2397125"/>
          <p14:tracePt t="26355" x="9821863" y="2397125"/>
          <p14:tracePt t="26367" x="10040938" y="2397125"/>
          <p14:tracePt t="26372" x="10067925" y="2397125"/>
          <p14:tracePt t="26382" x="10215563" y="2397125"/>
          <p14:tracePt t="26393" x="10288588" y="2397125"/>
          <p14:tracePt t="26395" x="10296525" y="2397125"/>
          <p14:tracePt t="26406" x="10320338" y="2397125"/>
          <p14:tracePt t="26461" x="10337800" y="2392363"/>
          <p14:tracePt t="26472" x="10361613" y="2382838"/>
          <p14:tracePt t="26477" x="10364788" y="2374900"/>
          <p14:tracePt t="26488" x="10374313" y="2346325"/>
          <p14:tracePt t="26493" x="10383838" y="2341563"/>
          <p14:tracePt t="26502" x="10415588" y="2265363"/>
          <p14:tracePt t="26511" x="10425113" y="2224088"/>
          <p14:tracePt t="26518" x="10425113" y="2214563"/>
          <p14:tracePt t="26527" x="10447338" y="2163763"/>
          <p14:tracePt t="26532" x="10447338" y="2155825"/>
          <p14:tracePt t="26543" x="10447338" y="2109788"/>
          <p14:tracePt t="26552" x="10447338" y="2078038"/>
          <p14:tracePt t="26558" x="10447338" y="2073275"/>
          <p14:tracePt t="26568" x="10456863" y="2036763"/>
          <p14:tracePt t="26574" x="10456863" y="2017713"/>
          <p14:tracePt t="26581" x="10456863" y="2009775"/>
          <p14:tracePt t="26594" x="10456863" y="2000250"/>
          <p14:tracePt t="26597" x="10456863" y="1995488"/>
          <p14:tracePt t="26610" x="10456863" y="1968500"/>
          <p14:tracePt t="26617" x="10456863" y="1958975"/>
          <p14:tracePt t="26643" x="10456863" y="1931988"/>
          <p14:tracePt t="26664" x="10425113" y="1890713"/>
          <p14:tracePt t="26674" x="10420350" y="1881188"/>
          <p14:tracePt t="26684" x="10401300" y="1871663"/>
          <p14:tracePt t="26689" x="10393363" y="1862138"/>
          <p14:tracePt t="26697" x="10383838" y="1858963"/>
          <p14:tracePt t="26705" x="10369550" y="1858963"/>
          <p14:tracePt t="26714" x="10337800" y="1844675"/>
          <p14:tracePt t="26721" x="10320338" y="1844675"/>
          <p14:tracePt t="26729" x="10301288" y="1835150"/>
          <p14:tracePt t="26733" x="10296525" y="1835150"/>
          <p14:tracePt t="26744" x="10279063" y="1835150"/>
          <p14:tracePt t="26757" x="10269538" y="1830388"/>
          <p14:tracePt t="26760" x="10264775" y="1830388"/>
          <p14:tracePt t="26771" x="10247313" y="1830388"/>
          <p14:tracePt t="26774" x="10228263" y="1830388"/>
          <p14:tracePt t="26784" x="10218738" y="1830388"/>
          <p14:tracePt t="26794" x="10196513" y="1830388"/>
          <p14:tracePt t="26806" x="10164763" y="1830388"/>
          <p14:tracePt t="26810" x="10160000" y="1830388"/>
          <p14:tracePt t="26813" x="10150475" y="1830388"/>
          <p14:tracePt t="26827" x="10113963" y="1830388"/>
          <p14:tracePt t="26838" x="10082213" y="1835150"/>
          <p14:tracePt t="26841" x="10077450" y="1844675"/>
          <p14:tracePt t="26849" x="10013950" y="1862138"/>
          <p14:tracePt t="26857" x="10004425" y="1871663"/>
          <p14:tracePt t="26866" x="9972675" y="1922463"/>
          <p14:tracePt t="26887" x="9936163" y="1963738"/>
          <p14:tracePt t="26893" x="9894888" y="2012950"/>
          <p14:tracePt t="26895" x="9863138" y="2022475"/>
          <p14:tracePt t="26906" x="9826625" y="2082800"/>
          <p14:tracePt t="26916" x="9809163" y="2105025"/>
          <p14:tracePt t="26922" x="9799638" y="2109788"/>
          <p14:tracePt t="26929" x="9780588" y="2136775"/>
          <p14:tracePt t="26939" x="9775825" y="2146300"/>
          <p14:tracePt t="26945" x="9775825" y="2173288"/>
          <p14:tracePt t="26957" x="9767888" y="2178050"/>
          <p14:tracePt t="26966" x="9758363" y="2187575"/>
          <p14:tracePt t="26971" x="9758363" y="2195513"/>
          <p14:tracePt t="26988" x="9748838" y="2205038"/>
          <p14:tracePt t="26996" x="9748838" y="2219325"/>
          <p14:tracePt t="27004" x="9739313" y="2251075"/>
          <p14:tracePt t="27012" x="9731375" y="2268538"/>
          <p14:tracePt t="27016" x="9712325" y="2278063"/>
          <p14:tracePt t="27027" x="9702800" y="2297113"/>
          <p14:tracePt t="27036" x="9702800" y="2351088"/>
          <p14:tracePt t="27042" x="9694863" y="2360613"/>
          <p14:tracePt t="27052" x="9685338" y="2387600"/>
          <p14:tracePt t="27059" x="9675813" y="2414588"/>
          <p14:tracePt t="27067" x="9658350" y="2447925"/>
          <p14:tracePt t="27078" x="9658350" y="2474913"/>
          <p14:tracePt t="27081" x="9648825" y="2484438"/>
          <p14:tracePt t="27093" x="9625013" y="2547938"/>
          <p14:tracePt t="27097" x="9625013" y="2565400"/>
          <p14:tracePt t="27108" x="9588500" y="2638425"/>
          <p14:tracePt t="27118" x="9588500" y="2679700"/>
          <p14:tracePt t="27123" x="9571038" y="2708275"/>
          <p14:tracePt t="27132" x="9556750" y="2767013"/>
          <p14:tracePt t="27139" x="9556750" y="2771775"/>
          <p14:tracePt t="27147" x="9507538" y="2840038"/>
          <p14:tracePt t="27158" x="9507538" y="2894013"/>
          <p14:tracePt t="27161" x="9507538" y="2913063"/>
          <p14:tracePt t="27174" x="9478963" y="3000375"/>
          <p14:tracePt t="27177" x="9478963" y="3008313"/>
          <p14:tracePt t="27188" x="9478963" y="3068638"/>
          <p14:tracePt t="27197" x="9471025" y="3127375"/>
          <p14:tracePt t="27205" x="9471025" y="3154363"/>
          <p14:tracePt t="27213" x="9442450" y="3227388"/>
          <p14:tracePt t="27217" x="9442450" y="3236913"/>
          <p14:tracePt t="27227" x="9434513" y="3309938"/>
          <p14:tracePt t="27238" x="9434513" y="3351213"/>
          <p14:tracePt t="27244" x="9434513" y="3378200"/>
          <p14:tracePt t="27255" x="9410700" y="3438525"/>
          <p14:tracePt t="27258" x="9410700" y="3448050"/>
          <p14:tracePt t="27268" x="9410700" y="3521075"/>
          <p14:tracePt t="27277" x="9410700" y="3575050"/>
          <p14:tracePt t="27283" x="9410700" y="3584575"/>
          <p14:tracePt t="27293" x="9410700" y="3684588"/>
          <p14:tracePt t="27299" x="9410700" y="3689350"/>
          <p14:tracePt t="27310" x="9410700" y="3776663"/>
          <p14:tracePt t="27321" x="9410700" y="3835400"/>
          <p14:tracePt t="27324" x="9410700" y="3876675"/>
          <p14:tracePt t="27334" x="9398000" y="3944938"/>
          <p14:tracePt t="27340" x="9398000" y="3963988"/>
          <p14:tracePt t="27349" x="9388475" y="4049713"/>
          <p14:tracePt t="27360" x="9388475" y="4090988"/>
          <p14:tracePt t="27363" x="9388475" y="4105275"/>
          <p14:tracePt t="27375" x="9388475" y="4178300"/>
          <p14:tracePt t="27379" x="9388475" y="4191000"/>
          <p14:tracePt t="27390" x="9393238" y="4264025"/>
          <p14:tracePt t="27399" x="9402763" y="4305300"/>
          <p14:tracePt t="27406" x="9424988" y="4324350"/>
          <p14:tracePt t="27416" x="9447213" y="4397375"/>
          <p14:tracePt t="27421" x="9456738" y="4405313"/>
          <p14:tracePt t="27429" x="9466263" y="4424363"/>
          <p14:tracePt t="27439" x="9498013" y="4483100"/>
          <p14:tracePt t="27445" x="9515475" y="4492625"/>
          <p14:tracePt t="27456" x="9548813" y="4524375"/>
          <p14:tracePt t="27460" x="9556750" y="4529138"/>
          <p14:tracePt t="27472" x="9588500" y="4570413"/>
          <p14:tracePt t="27480" x="9593263" y="4579938"/>
          <p14:tracePt t="27487" x="9602788" y="4584700"/>
          <p14:tracePt t="27495" x="9621838" y="4602163"/>
          <p14:tracePt t="27506" x="9639300" y="4633913"/>
          <p14:tracePt t="27511" x="9639300" y="4643438"/>
          <p14:tracePt t="27522" x="9658350" y="4657725"/>
          <p14:tracePt t="27526" x="9675813" y="4670425"/>
          <p14:tracePt t="27538" x="9707563" y="4699000"/>
          <p14:tracePt t="27542" x="9717088" y="4699000"/>
          <p14:tracePt t="27556" x="9753600" y="4730750"/>
          <p14:tracePt t="27561" x="9775825" y="4738688"/>
          <p14:tracePt t="27565" x="9794875" y="4748213"/>
          <p14:tracePt t="27576" x="9882188" y="4772025"/>
          <p14:tracePt t="27581" x="9894888" y="4772025"/>
          <p14:tracePt t="27592" x="9940925" y="4784725"/>
          <p14:tracePt t="27606" x="9999663" y="4811713"/>
          <p14:tracePt t="27616" x="10055225" y="4811713"/>
          <p14:tracePt t="27622" x="10064750" y="4811713"/>
          <p14:tracePt t="27631" x="10091738" y="4811713"/>
          <p14:tracePt t="27642" x="10118725" y="4821238"/>
          <p14:tracePt t="27647" x="10128250" y="4821238"/>
          <p14:tracePt t="27658" x="10145713" y="4821238"/>
          <p14:tracePt t="27661" x="10150475" y="4821238"/>
          <p14:tracePt t="27672" x="10160000" y="4821238"/>
          <p14:tracePt t="27681" x="10169525" y="4821238"/>
          <p14:tracePt t="27688" x="10182225" y="4821238"/>
          <p14:tracePt t="27698" x="10191750" y="4811713"/>
          <p14:tracePt t="27704" x="10201275" y="4811713"/>
          <p14:tracePt t="27712" x="10218738" y="4794250"/>
          <p14:tracePt t="27723" x="10237788" y="4775200"/>
          <p14:tracePt t="27727" x="10247313" y="4767263"/>
          <p14:tracePt t="27739" x="10274300" y="4716463"/>
          <p14:tracePt t="27742" x="10296525" y="4699000"/>
          <p14:tracePt t="27755" x="10333038" y="4625975"/>
          <p14:tracePt t="27763" x="10383838" y="4556125"/>
          <p14:tracePt t="27767" x="10383838" y="4548188"/>
          <p14:tracePt t="27777" x="10415588" y="4497388"/>
          <p14:tracePt t="27783" x="10425113" y="4479925"/>
          <p14:tracePt t="27794" x="10447338" y="4433888"/>
          <p14:tracePt t="27805" x="10483850" y="4387850"/>
          <p14:tracePt t="27808" x="10483850" y="4368800"/>
          <p14:tracePt t="27818" x="10493375" y="4314825"/>
          <p14:tracePt t="27824" x="10502900" y="4305300"/>
          <p14:tracePt t="27833" x="10510838" y="4268788"/>
          <p14:tracePt t="27843" x="10510838" y="4241800"/>
          <p14:tracePt t="27847" x="10520363" y="4222750"/>
          <p14:tracePt t="27858" x="10520363" y="4183063"/>
          <p14:tracePt t="27863" x="10539413" y="4149725"/>
          <p14:tracePt t="27887" x="10552113" y="4068763"/>
          <p14:tracePt t="27892" x="10561638" y="4049713"/>
          <p14:tracePt t="27899" x="10561638" y="4017963"/>
          <p14:tracePt t="27904" x="10561638" y="4000500"/>
          <p14:tracePt t="27913" x="10571163" y="3944938"/>
          <p14:tracePt t="27924" x="10580688" y="3913188"/>
          <p14:tracePt t="27934" x="10580688" y="3886200"/>
          <p14:tracePt t="27950" x="10593388" y="3852863"/>
          <p14:tracePt t="27969" x="10598150" y="3849688"/>
          <p14:tracePt t="27996" x="10607675" y="3840163"/>
          <p14:tracePt t="28092" x="10617200" y="3830638"/>
          <p14:tracePt t="28102" x="10634663" y="3803650"/>
          <p14:tracePt t="28115" x="10634663" y="3798888"/>
          <p14:tracePt t="28126" x="10639425" y="3789363"/>
          <p14:tracePt t="28131" x="10639425" y="3779838"/>
          <p14:tracePt t="28142" x="10648950" y="3752850"/>
          <p14:tracePt t="28176" x="10648950" y="3748088"/>
          <p14:tracePt t="28192" x="10658475" y="3730625"/>
          <p14:tracePt t="28196" x="10658475" y="3721100"/>
          <p14:tracePt t="28206" x="10658475" y="3716338"/>
          <p14:tracePt t="28218" x="10658475" y="3698875"/>
          <p14:tracePt t="28227" x="10675938" y="3679825"/>
          <p14:tracePt t="28252" x="10675938" y="3670300"/>
          <p14:tracePt t="28262" x="10694988" y="3643313"/>
          <p14:tracePt t="28273" x="10694988" y="3633788"/>
          <p14:tracePt t="28281" x="10694988" y="3630613"/>
          <p14:tracePt t="28308" x="10694988" y="3621088"/>
          <p14:tracePt t="28318" x="10694988" y="3602038"/>
          <p14:tracePt t="28338" x="10694988" y="3575050"/>
          <p14:tracePt t="28343" x="10694988" y="3565525"/>
          <p14:tracePt t="28358" x="10694988" y="3552825"/>
          <p14:tracePt t="28368" x="10694988" y="3543300"/>
          <p14:tracePt t="28439" x="10694988" y="3533775"/>
          <p14:tracePt t="28504" x="10694988" y="3524250"/>
          <p14:tracePt t="28521" x="10694988" y="3521075"/>
          <p14:tracePt t="28534" x="10694988" y="3502025"/>
          <p14:tracePt t="28544" x="10694988" y="3492500"/>
          <p14:tracePt t="28549" x="10694988" y="3487738"/>
          <p14:tracePt t="28560" x="10694988" y="3479800"/>
          <p14:tracePt t="28573" x="10694988" y="3470275"/>
          <p14:tracePt t="28576" x="10694988" y="3465513"/>
          <p14:tracePt t="28589" x="10690225" y="3392488"/>
          <p14:tracePt t="28600" x="10671175" y="3333750"/>
          <p14:tracePt t="28610" x="10658475" y="3287713"/>
          <p14:tracePt t="28615" x="10658475" y="3260725"/>
          <p14:tracePt t="28626" x="10634663" y="3159125"/>
          <p14:tracePt t="28629" x="10634663" y="3127375"/>
          <p14:tracePt t="28640" x="10607675" y="3059113"/>
          <p14:tracePt t="28649" x="10607675" y="3000375"/>
          <p14:tracePt t="28656" x="10598150" y="2971800"/>
          <p14:tracePt t="28665" x="10598150" y="2898775"/>
          <p14:tracePt t="28675" x="10598150" y="2871788"/>
          <p14:tracePt t="28681" x="10575925" y="2798763"/>
          <p14:tracePt t="28693" x="10566400" y="2757488"/>
          <p14:tracePt t="28695" x="10566400" y="2747963"/>
          <p14:tracePt t="28709" x="10552113" y="2689225"/>
          <p14:tracePt t="28711" x="10552113" y="2679700"/>
          <p14:tracePt t="28721" x="10534650" y="2616200"/>
          <p14:tracePt t="28731" x="10534650" y="2589213"/>
          <p14:tracePt t="28742" x="10510838" y="2543175"/>
          <p14:tracePt t="28746" x="10502900" y="2538413"/>
          <p14:tracePt t="28755" x="10493375" y="2520950"/>
          <p14:tracePt t="28761" x="10474325" y="2474913"/>
          <p14:tracePt t="28772" x="10452100" y="2428875"/>
          <p14:tracePt t="28776" x="10452100" y="2424113"/>
          <p14:tracePt t="28789" x="10425113" y="2397125"/>
          <p14:tracePt t="28793" x="10410825" y="2365375"/>
          <p14:tracePt t="28804" x="10379075" y="2319338"/>
          <p14:tracePt t="28811" x="10369550" y="2309813"/>
          <p14:tracePt t="28818" x="10342563" y="2292350"/>
          <p14:tracePt t="28827" x="10310813" y="2251075"/>
          <p14:tracePt t="28831" x="10301288" y="2241550"/>
          <p14:tracePt t="28842" x="10237788" y="2209800"/>
          <p14:tracePt t="28855" x="10218738" y="2200275"/>
          <p14:tracePt t="28861" x="10160000" y="2163763"/>
          <p14:tracePt t="28868" x="10140950" y="2155825"/>
          <p14:tracePt t="28878" x="10113963" y="2146300"/>
          <p14:tracePt t="28881" x="10067925" y="2136775"/>
          <p14:tracePt t="28893" x="10040938" y="2122488"/>
          <p14:tracePt t="28897" x="10031413" y="2122488"/>
          <p14:tracePt t="28908" x="9982200" y="2114550"/>
          <p14:tracePt t="28913" x="9963150" y="2105025"/>
          <p14:tracePt t="28924" x="9936163" y="2085975"/>
          <p14:tracePt t="28933" x="9926638" y="2085975"/>
          <p14:tracePt t="28938" x="9918700" y="2085975"/>
          <p14:tracePt t="28947" x="9890125" y="2085975"/>
          <p14:tracePt t="28955" x="9877425" y="2085975"/>
          <p14:tracePt t="28965" x="9853613" y="2078038"/>
          <p14:tracePt t="28974" x="9840913" y="2078038"/>
          <p14:tracePt t="28983" x="9821863" y="2078038"/>
          <p14:tracePt t="28994" x="9812338" y="2078038"/>
          <p14:tracePt t="29004" x="9804400" y="2078038"/>
          <p14:tracePt t="29014" x="9790113" y="2078038"/>
          <p14:tracePt t="29024" x="9780588" y="2078038"/>
          <p14:tracePt t="29040" x="9772650" y="2078038"/>
          <p14:tracePt t="29050" x="9772650" y="2105025"/>
          <p14:tracePt t="29054" x="9767888" y="2105025"/>
          <p14:tracePt t="29061" x="9758363" y="2114550"/>
          <p14:tracePt t="29069" x="9739313" y="2132013"/>
          <p14:tracePt t="29076" x="9731375" y="2136775"/>
          <p14:tracePt t="29084" x="9690100" y="2178050"/>
          <p14:tracePt t="29094" x="9671050" y="2224088"/>
          <p14:tracePt t="29100" x="9661525" y="2232025"/>
          <p14:tracePt t="29110" x="9629775" y="2297113"/>
          <p14:tracePt t="29114" x="9621838" y="2324100"/>
          <p14:tracePt t="29125" x="9593263" y="2411413"/>
          <p14:tracePt t="29136" x="9551988" y="2492375"/>
          <p14:tracePt t="29142" x="9551988" y="2501900"/>
          <p14:tracePt t="29149" x="9520238" y="2589213"/>
          <p14:tracePt t="29157" x="9502775" y="2620963"/>
          <p14:tracePt t="29165" x="9475788" y="2735263"/>
          <p14:tracePt t="29176" x="9461500" y="2794000"/>
          <p14:tracePt t="29180" x="9451975" y="2813050"/>
          <p14:tracePt t="29190" x="9442450" y="2898775"/>
          <p14:tracePt t="29196" x="9420225" y="2944813"/>
          <p14:tracePt t="29206" x="9420225" y="3054350"/>
          <p14:tracePt t="29215" x="9420225" y="3146425"/>
          <p14:tracePt t="29221" x="9420225" y="3163888"/>
          <p14:tracePt t="29229" x="9420225" y="3278188"/>
          <p14:tracePt t="29239" x="9410700" y="3305175"/>
          <p14:tracePt t="29246" x="9410700" y="3406775"/>
          <p14:tracePt t="29255" x="9410700" y="3497263"/>
          <p14:tracePt t="29261" x="9410700" y="3529013"/>
          <p14:tracePt t="29272" x="9410700" y="3643313"/>
          <p14:tracePt t="29276" x="9410700" y="3684588"/>
          <p14:tracePt t="29288" x="9429750" y="3813175"/>
          <p14:tracePt t="29295" x="9429750" y="3922713"/>
          <p14:tracePt t="29305" x="9439275" y="3954463"/>
          <p14:tracePt t="29311" x="9466263" y="4095750"/>
          <p14:tracePt t="29315" x="9466263" y="4137025"/>
          <p14:tracePt t="29326" x="9520238" y="4283075"/>
          <p14:tracePt t="29339" x="9561513" y="4365625"/>
          <p14:tracePt t="29342" x="9561513" y="4397375"/>
          <p14:tracePt t="29356" x="9598025" y="4538663"/>
          <p14:tracePt t="29358" x="9621838" y="4584700"/>
          <p14:tracePt t="29368" x="9685338" y="4735513"/>
          <p14:tracePt t="29378" x="9739313" y="4835525"/>
          <p14:tracePt t="29382" x="9748838" y="4852988"/>
          <p14:tracePt t="29393" x="9812338" y="4959350"/>
          <p14:tracePt t="29397" x="9821863" y="4967288"/>
          <p14:tracePt t="29409" x="9877425" y="5045075"/>
          <p14:tracePt t="29417" x="9899650" y="5072063"/>
          <p14:tracePt t="29423" x="9926638" y="5095875"/>
          <p14:tracePt t="29517" x="10233025" y="5122863"/>
          <p14:tracePt t="29527" x="10291763" y="5076825"/>
          <p14:tracePt t="29538" x="10347325" y="5008563"/>
          <p14:tracePt t="29543" x="10352088" y="5003800"/>
          <p14:tracePt t="29555" x="10398125" y="4940300"/>
          <p14:tracePt t="29558" x="10406063" y="4918075"/>
          <p14:tracePt t="29568" x="10429875" y="4876800"/>
          <p14:tracePt t="29577" x="10437813" y="4816475"/>
          <p14:tracePt t="29584" x="10437813" y="4799013"/>
          <p14:tracePt t="29593" x="10488613" y="4711700"/>
          <p14:tracePt t="29599" x="10488613" y="4702175"/>
          <p14:tracePt t="29610" x="10502900" y="4616450"/>
          <p14:tracePt t="29622" x="10510838" y="4575175"/>
          <p14:tracePt t="29624" x="10520363" y="4543425"/>
          <p14:tracePt t="29633" x="10520363" y="4460875"/>
          <p14:tracePt t="29641" x="10520363" y="4419600"/>
          <p14:tracePt t="29649" x="10534650" y="4360863"/>
          <p14:tracePt t="29660" x="10544175" y="4319588"/>
          <p14:tracePt t="29663" x="10544175" y="4310063"/>
          <p14:tracePt t="29674" x="10544175" y="4237038"/>
          <p14:tracePt t="29679" x="10544175" y="4232275"/>
          <p14:tracePt t="29691" x="10544175" y="4183063"/>
          <p14:tracePt t="29699" x="10544175" y="4154488"/>
          <p14:tracePt t="29707" x="10544175" y="4137025"/>
          <p14:tracePt t="29715" x="10544175" y="4105275"/>
          <p14:tracePt t="29722" x="10544175" y="4076700"/>
          <p14:tracePt t="29729" x="10544175" y="4037013"/>
          <p14:tracePt t="29740" x="10544175" y="4017963"/>
          <p14:tracePt t="29745" x="10544175" y="3990975"/>
          <p14:tracePt t="29756" x="10544175" y="3959225"/>
          <p14:tracePt t="29760" x="10544175" y="3954463"/>
          <p14:tracePt t="29771" x="10544175" y="3944938"/>
          <p14:tracePt t="29780" x="10544175" y="3935413"/>
          <p14:tracePt t="29789" x="10539413" y="3908425"/>
          <p14:tracePt t="29905" x="10539413" y="3894138"/>
          <p14:tracePt t="30065" x="10539413" y="3886200"/>
          <p14:tracePt t="30075" x="10539413" y="3876675"/>
          <p14:tracePt t="30085" x="10539413" y="3867150"/>
          <p14:tracePt t="30096" x="10510838" y="3830638"/>
          <p14:tracePt t="30114" x="10510838" y="3821113"/>
          <p14:tracePt t="30120" x="10502900" y="3813175"/>
          <p14:tracePt t="30139" x="10483850" y="3808413"/>
          <p14:tracePt t="30145" x="10479088" y="3798888"/>
          <p14:tracePt t="30155" x="10471150" y="3798888"/>
          <p14:tracePt t="30159" x="10461625" y="3798888"/>
          <p14:tracePt t="30173" x="10452100" y="3789363"/>
          <p14:tracePt t="30185" x="10447338" y="3789363"/>
          <p14:tracePt t="30193" x="10437813" y="3789363"/>
          <p14:tracePt t="30219" x="10429875" y="3779838"/>
          <p14:tracePt t="30224" x="10425113" y="3779838"/>
          <p14:tracePt t="30230" x="10415588" y="3779838"/>
          <p14:tracePt t="30242" x="10398125" y="3779838"/>
          <p14:tracePt t="30245" x="10393363" y="3776663"/>
          <p14:tracePt t="30257" x="10342563" y="3776663"/>
          <p14:tracePt t="30265" x="10325100" y="3776663"/>
          <p14:tracePt t="30272" x="10320338" y="3776663"/>
          <p14:tracePt t="30281" x="10264775" y="3752850"/>
          <p14:tracePt t="30292" x="10247313" y="3743325"/>
          <p14:tracePt t="30297" x="10164763" y="3735388"/>
          <p14:tracePt t="30309" x="10091738" y="3721100"/>
          <p14:tracePt t="30321" x="9945688" y="3698875"/>
          <p14:tracePt t="30326" x="9904413" y="3698875"/>
          <p14:tracePt t="30338" x="9717088" y="3638550"/>
          <p14:tracePt t="30345" x="9602788" y="3611563"/>
          <p14:tracePt t="30349" x="9548813" y="3611563"/>
          <p14:tracePt t="30359" x="9315450" y="3575050"/>
          <p14:tracePt t="30366" x="9237663" y="3565525"/>
          <p14:tracePt t="30377" x="9032875" y="3533775"/>
          <p14:tracePt t="30392" x="8894763" y="3492500"/>
          <p14:tracePt t="30408" x="8712200" y="3470275"/>
          <p14:tracePt t="30415" x="8597900" y="3455988"/>
          <p14:tracePt t="30425" x="8520113" y="3443288"/>
          <p14:tracePt t="30431" x="8502650" y="3433763"/>
          <p14:tracePt t="30442" x="8402638" y="3424238"/>
          <p14:tracePt t="30445" x="8383588" y="3424238"/>
          <p14:tracePt t="30455" x="8269288" y="3397250"/>
          <p14:tracePt t="30466" x="8205788" y="3373438"/>
          <p14:tracePt t="30475" x="8196263" y="3373438"/>
          <p14:tracePt t="30483" x="8096250" y="3351213"/>
          <p14:tracePt t="30487" x="8077200" y="3341688"/>
          <p14:tracePt t="30497" x="7977188" y="3328988"/>
          <p14:tracePt t="30509" x="7923213" y="3328988"/>
          <p14:tracePt t="30513" x="7904163" y="3319463"/>
          <p14:tracePt t="30524" x="7816850" y="3292475"/>
          <p14:tracePt t="30531" x="7799388" y="3292475"/>
          <p14:tracePt t="30540" x="7699375" y="3282950"/>
          <p14:tracePt t="30547" x="7643813" y="3282950"/>
          <p14:tracePt t="30554" x="7612063" y="3260725"/>
          <p14:tracePt t="30561" x="7529513" y="3260725"/>
          <p14:tracePt t="30567" x="7519988" y="3260725"/>
          <p14:tracePt t="30577" x="7456488" y="3241675"/>
          <p14:tracePt t="30589" x="7429500" y="3227388"/>
          <p14:tracePt t="30597" x="7397750" y="3227388"/>
          <p14:tracePt t="30606" x="7392988" y="3224213"/>
          <p14:tracePt t="30608" x="7366000" y="3205163"/>
          <p14:tracePt t="30618" x="7319963" y="3182938"/>
          <p14:tracePt t="30627" x="7300913" y="3173413"/>
          <p14:tracePt t="30636" x="7283450" y="3163888"/>
          <p14:tracePt t="30644" x="7251700" y="3154363"/>
          <p14:tracePt t="30649" x="7246938" y="3154363"/>
          <p14:tracePt t="30661" x="7169150" y="3132138"/>
          <p14:tracePt t="30670" x="7150100" y="3132138"/>
          <p14:tracePt t="30679" x="7118350" y="3109913"/>
          <p14:tracePt t="30685" x="7077075" y="3090863"/>
          <p14:tracePt t="30688" x="7069138" y="3090863"/>
          <p14:tracePt t="30698" x="7018338" y="3081338"/>
          <p14:tracePt t="30709" x="6977063" y="3068638"/>
          <p14:tracePt t="30713" x="6959600" y="3059113"/>
          <p14:tracePt t="30724" x="6918325" y="3049588"/>
          <p14:tracePt t="30727" x="6908800" y="3049588"/>
          <p14:tracePt t="30738" x="6881813" y="3041650"/>
          <p14:tracePt t="30749" x="6853238" y="3041650"/>
          <p14:tracePt t="30754" x="6845300" y="3022600"/>
          <p14:tracePt t="30765" x="6835775" y="3022600"/>
          <p14:tracePt t="30775" x="6826250" y="3022600"/>
          <p14:tracePt t="30824" x="6813550" y="3022600"/>
          <p14:tracePt t="30840" x="6794500" y="3022600"/>
          <p14:tracePt t="30843" x="6784975" y="3022600"/>
          <p14:tracePt t="30849" x="6780213" y="3022600"/>
          <p14:tracePt t="30859" x="6753225" y="3022600"/>
          <p14:tracePt t="30875" x="6711950" y="3027363"/>
          <p14:tracePt t="30881" x="6689725" y="3036888"/>
          <p14:tracePt t="30901" x="6657975" y="3054350"/>
          <p14:tracePt t="30918" x="6643688" y="3054350"/>
          <p14:tracePt t="30927" x="6626225" y="3063875"/>
          <p14:tracePt t="30935" x="6616700" y="3063875"/>
          <p14:tracePt t="30946" x="6611938" y="3063875"/>
          <p14:tracePt t="30997" x="6594475" y="3063875"/>
          <p14:tracePt t="31202" x="6584950" y="3063875"/>
          <p14:tracePt t="31208" x="6561138" y="3073400"/>
          <p14:tracePt t="31218" x="6529388" y="3073400"/>
          <p14:tracePt t="31225" x="6502400" y="3081338"/>
          <p14:tracePt t="31234" x="6446838" y="3081338"/>
          <p14:tracePt t="31241" x="6415088" y="3100388"/>
          <p14:tracePt t="31248" x="6242050" y="3114675"/>
          <p14:tracePt t="31256" x="6200775" y="3114675"/>
          <p14:tracePt t="31264" x="5886450" y="3114675"/>
          <p14:tracePt t="31275" x="5511800" y="3114675"/>
          <p14:tracePt t="31278" x="5370513" y="3114675"/>
          <p14:tracePt t="31290" x="4630738" y="3114675"/>
          <p14:tracePt t="31295" x="4484688" y="3114675"/>
          <p14:tracePt t="31307" x="3716338" y="3114675"/>
          <p14:tracePt t="31314" x="3182938" y="3163888"/>
          <p14:tracePt t="31318" x="3054350" y="3163888"/>
          <p14:tracePt t="31330" x="2497138" y="3227388"/>
          <p14:tracePt t="31333" x="2387600" y="3227388"/>
          <p14:tracePt t="31343" x="2017713" y="3263900"/>
          <p14:tracePt t="31355" x="1927225" y="3278188"/>
          <p14:tracePt t="31359" x="1885950" y="3278188"/>
          <p14:tracePt t="31370" x="1854200" y="3287713"/>
          <p14:tracePt t="31394" x="1849438" y="3297238"/>
          <p14:tracePt t="31431" x="1839913" y="3305175"/>
          <p14:tracePt t="31436" x="1830388" y="3305175"/>
          <p14:tracePt t="31446" x="1803400" y="3314700"/>
          <p14:tracePt t="31449" x="1798638" y="3324225"/>
          <p14:tracePt t="31460" x="1781175" y="3336925"/>
          <p14:tracePt t="31465" x="1739900" y="3336925"/>
          <p14:tracePt t="31476" x="1693863" y="3373438"/>
          <p14:tracePt t="31479" x="1676400" y="3373438"/>
          <p14:tracePt t="31489" x="1589088" y="3409950"/>
          <p14:tracePt t="31495" x="1538288" y="3448050"/>
          <p14:tracePt t="31506" x="1423988" y="3506788"/>
          <p14:tracePt t="31516" x="1360488" y="3543300"/>
          <p14:tracePt t="31521" x="1292225" y="3597275"/>
          <p14:tracePt t="31529" x="1177925" y="3670300"/>
          <p14:tracePt t="31539" x="1127125" y="3703638"/>
          <p14:tracePt t="31545" x="995363" y="3779838"/>
          <p14:tracePt t="31556" x="944563" y="3830638"/>
          <p14:tracePt t="31562" x="912813" y="3849688"/>
          <p14:tracePt t="31572" x="827088" y="3898900"/>
          <p14:tracePt t="31576" x="793750" y="3922713"/>
          <p14:tracePt t="31586" x="744538" y="3995738"/>
          <p14:tracePt t="31595" x="725488" y="4027488"/>
          <p14:tracePt t="31605" x="717550" y="4032250"/>
          <p14:tracePt t="31611" x="698500" y="4073525"/>
          <p14:tracePt t="31622" x="688975" y="4076700"/>
          <p14:tracePt t="31626" x="671513" y="4086225"/>
          <p14:tracePt t="31638" x="661988" y="4105275"/>
          <p14:tracePt t="31642" x="657225" y="4113213"/>
          <p14:tracePt t="31656" x="639763" y="4122738"/>
          <p14:tracePt t="31668" x="639763" y="4132263"/>
          <p14:tracePt t="31677" x="635000" y="4137025"/>
          <p14:tracePt t="31789" x="635000" y="4146550"/>
          <p14:tracePt t="31809" x="676275" y="4132263"/>
          <p14:tracePt t="31816" x="681038" y="4122738"/>
          <p14:tracePt t="31819" x="688975" y="4122738"/>
          <p14:tracePt t="31829" x="730250" y="4081463"/>
          <p14:tracePt t="31841" x="739775" y="4076700"/>
          <p14:tracePt t="31845" x="762000" y="4068763"/>
          <p14:tracePt t="31855" x="793750" y="4068763"/>
          <p14:tracePt t="31858" x="812800" y="4068763"/>
          <p14:tracePt t="31869" x="844550" y="4037013"/>
          <p14:tracePt t="31879" x="863600" y="4003675"/>
          <p14:tracePt t="31897" x="871538" y="4003675"/>
          <p14:tracePt t="31899" x="876300" y="3995738"/>
          <p14:tracePt t="31909" x="885825" y="3990975"/>
          <p14:tracePt t="31931" x="895350" y="3981450"/>
          <p14:tracePt t="31942" x="904875" y="3971925"/>
          <p14:tracePt t="31965" x="927100" y="3963988"/>
          <p14:tracePt t="32011" x="936625" y="3954463"/>
          <p14:tracePt t="32097" x="944563" y="3940175"/>
          <p14:tracePt t="32107" x="954088" y="3930650"/>
          <p14:tracePt t="32232" x="958850" y="3922713"/>
          <p14:tracePt t="32254" x="977900" y="3913188"/>
          <p14:tracePt t="32264" x="985838" y="3908425"/>
          <p14:tracePt t="32279" x="995363" y="3898900"/>
          <p14:tracePt t="32297" x="1009650" y="3886200"/>
          <p14:tracePt t="32317" x="1017588" y="3867150"/>
          <p14:tracePt t="32347" x="1017588" y="3857625"/>
          <p14:tracePt t="32473" x="1017588" y="3849688"/>
          <p14:tracePt t="32483" x="1014413" y="3835400"/>
          <p14:tracePt t="32493" x="1004888" y="3825875"/>
          <p14:tracePt t="32500" x="1000125" y="3825875"/>
          <p14:tracePt t="32506" x="981075" y="3825875"/>
          <p14:tracePt t="32514" x="941388" y="3816350"/>
          <p14:tracePt t="32525" x="908050" y="3803650"/>
          <p14:tracePt t="32529" x="876300" y="3784600"/>
          <p14:tracePt t="32540" x="827088" y="3784600"/>
          <p14:tracePt t="32543" x="793750" y="3784600"/>
          <p14:tracePt t="32555" x="725488" y="3771900"/>
          <p14:tracePt t="32564" x="681038" y="3762375"/>
          <p14:tracePt t="32571" x="676275" y="3762375"/>
          <p14:tracePt t="32580" x="625475" y="3752850"/>
          <p14:tracePt t="32589" x="615950" y="3752850"/>
          <p14:tracePt t="32596" x="608013" y="3752850"/>
          <p14:tracePt t="32606" x="603250" y="3743325"/>
          <p14:tracePt t="32609" x="593725" y="3743325"/>
          <p14:tracePt t="32626" x="584200" y="3743325"/>
          <p14:tracePt t="32638" x="579438" y="3740150"/>
          <p14:tracePt t="32645" x="571500" y="3740150"/>
          <p14:tracePt t="32659" x="561975" y="3740150"/>
          <p14:tracePt t="32661" x="557213" y="3740150"/>
          <p14:tracePt t="32676" x="547688" y="3740150"/>
          <p14:tracePt t="32696" x="530225" y="3740150"/>
          <p14:tracePt t="32712" x="520700" y="3740150"/>
          <p14:tracePt t="32722" x="515938" y="3740150"/>
          <p14:tracePt t="32725" x="506413" y="3740150"/>
          <p14:tracePt t="32738" x="488950" y="3740150"/>
          <p14:tracePt t="32756" x="484188" y="3740150"/>
          <p14:tracePt t="32765" x="474663" y="3740150"/>
          <p14:tracePt t="32796" x="465138" y="3740150"/>
          <p14:tracePt t="32932" x="461963" y="3740150"/>
          <p14:tracePt t="32959" x="452438" y="3740150"/>
          <p14:tracePt t="32968" x="442913" y="3740150"/>
          <p14:tracePt t="32984" x="433388" y="3740150"/>
          <p14:tracePt t="33010" x="428625" y="3740150"/>
          <p14:tracePt t="33018" x="420688" y="3740150"/>
          <p14:tracePt t="33200" x="411163" y="3740150"/>
          <p14:tracePt t="33226" x="425450" y="3740150"/>
          <p14:tracePt t="33231" x="433388" y="3748088"/>
          <p14:tracePt t="33241" x="461963" y="3776663"/>
          <p14:tracePt t="33250" x="479425" y="3776663"/>
          <p14:tracePt t="33256" x="506413" y="3776663"/>
          <p14:tracePt t="33266" x="538163" y="3784600"/>
          <p14:tracePt t="33272" x="552450" y="3784600"/>
          <p14:tracePt t="33282" x="598488" y="3794125"/>
          <p14:tracePt t="33293" x="625475" y="3794125"/>
          <p14:tracePt t="33296" x="644525" y="3794125"/>
          <p14:tracePt t="33307" x="712788" y="3794125"/>
          <p14:tracePt t="33312" x="730250" y="3794125"/>
          <p14:tracePt t="33322" x="785813" y="3794125"/>
          <p14:tracePt t="33331" x="812800" y="3794125"/>
          <p14:tracePt t="33337" x="822325" y="3794125"/>
          <p14:tracePt t="33347" x="868363" y="3794125"/>
          <p14:tracePt t="33354" x="876300" y="3794125"/>
          <p14:tracePt t="33362" x="885825" y="3794125"/>
          <p14:tracePt t="33373" x="912813" y="3794125"/>
          <p14:tracePt t="33381" x="927100" y="3794125"/>
          <p14:tracePt t="33388" x="936625" y="3794125"/>
          <p14:tracePt t="33392" x="944563" y="3784600"/>
          <p14:tracePt t="33405" x="954088" y="3784600"/>
          <p14:tracePt t="33412" x="968375" y="3784600"/>
          <p14:tracePt t="33422" x="985838" y="3784600"/>
          <p14:tracePt t="33427" x="995363" y="3784600"/>
          <p14:tracePt t="33441" x="1004888" y="3784600"/>
          <p14:tracePt t="33443" x="1009650" y="3784600"/>
          <p14:tracePt t="33455" x="1017588" y="3784600"/>
          <p14:tracePt t="33461" x="1027113" y="3776663"/>
          <p14:tracePt t="33564" x="1022350" y="3776663"/>
          <p14:tracePt t="33574" x="1004888" y="3776663"/>
          <p14:tracePt t="33578" x="977900" y="3776663"/>
          <p14:tracePt t="33589" x="895350" y="3776663"/>
          <p14:tracePt t="33594" x="863600" y="3776663"/>
          <p14:tracePt t="33606" x="720725" y="3776663"/>
          <p14:tracePt t="33614" x="630238" y="3776663"/>
          <p14:tracePt t="33618" x="598488" y="3776663"/>
          <p14:tracePt t="33630" x="442913" y="3776663"/>
          <p14:tracePt t="33634" x="411163" y="3776663"/>
          <p14:tracePt t="33645" x="269875" y="3762375"/>
          <p14:tracePt t="33656" x="209550" y="3752850"/>
          <p14:tracePt t="33660" x="192088" y="3752850"/>
          <p14:tracePt t="33670" x="182563" y="3752850"/>
          <p14:tracePt t="33786" x="196850" y="3752850"/>
          <p14:tracePt t="33790" x="201613" y="3752850"/>
          <p14:tracePt t="33799" x="209550" y="3752850"/>
          <p14:tracePt t="33806" x="238125" y="3752850"/>
          <p14:tracePt t="33816" x="277813" y="3752850"/>
          <p14:tracePt t="33822" x="287338" y="3752850"/>
          <p14:tracePt t="33829" x="374650" y="3757613"/>
          <p14:tracePt t="33836" x="387350" y="3757613"/>
          <p14:tracePt t="33845" x="488950" y="3757613"/>
          <p14:tracePt t="33855" x="547688" y="3757613"/>
          <p14:tracePt t="33862" x="561975" y="3757613"/>
          <p14:tracePt t="33874" x="647700" y="3757613"/>
          <p14:tracePt t="33876" x="666750" y="3757613"/>
          <p14:tracePt t="33889" x="708025" y="3757613"/>
          <p14:tracePt t="33895" x="720725" y="3757613"/>
          <p14:tracePt t="33906" x="730250" y="3757613"/>
          <p14:tracePt t="33916" x="739775" y="3757613"/>
          <p14:tracePt t="33971" x="749300" y="3757613"/>
          <p14:tracePt t="34002" x="754063" y="3757613"/>
          <p14:tracePt t="34127" x="762000" y="3757613"/>
          <p14:tracePt t="34157" x="771525" y="3757613"/>
          <p14:tracePt t="34168" x="776288" y="3757613"/>
          <p14:tracePt t="34177" x="793750" y="3776663"/>
          <p14:tracePt t="34189" x="803275" y="3794125"/>
          <p14:tracePt t="34197" x="827088" y="3825875"/>
          <p14:tracePt t="34210" x="849313" y="3881438"/>
          <p14:tracePt t="34222" x="871538" y="3927475"/>
          <p14:tracePt t="34224" x="871538" y="3935413"/>
          <p14:tracePt t="34234" x="904875" y="4013200"/>
          <p14:tracePt t="34244" x="912813" y="4032250"/>
          <p14:tracePt t="34250" x="977900" y="4105275"/>
          <p14:tracePt t="34260" x="985838" y="4137025"/>
          <p14:tracePt t="34263" x="1009650" y="4191000"/>
          <p14:tracePt t="34274" x="1068388" y="4310063"/>
          <p14:tracePt t="34280" x="1068388" y="4337050"/>
          <p14:tracePt t="34290" x="1090613" y="4456113"/>
          <p14:tracePt t="34299" x="1104900" y="4529138"/>
          <p14:tracePt t="34305" x="1104900" y="4560888"/>
          <p14:tracePt t="34313" x="1119188" y="4689475"/>
          <p14:tracePt t="34323" x="1119188" y="4706938"/>
          <p14:tracePt t="34329" x="1119188" y="4867275"/>
          <p14:tracePt t="34341" x="1119188" y="4940300"/>
          <p14:tracePt t="34345" x="1119188" y="4967288"/>
          <p14:tracePt t="34356" x="1119188" y="5068888"/>
          <p14:tracePt t="34359" x="1119188" y="5086350"/>
          <p14:tracePt t="34371" x="1119188" y="5127625"/>
          <p14:tracePt t="34379" x="1127125" y="5168900"/>
          <p14:tracePt t="34388" x="1127125" y="5178425"/>
          <p14:tracePt t="34396" x="1136650" y="5200650"/>
          <p14:tracePt t="34399" x="1136650" y="5210175"/>
          <p14:tracePt t="34410" x="1136650" y="5218113"/>
          <p14:tracePt t="34422" x="1136650" y="5232400"/>
          <p14:tracePt t="34429" x="1146175" y="5254625"/>
          <p14:tracePt t="34452" x="1146175" y="5259388"/>
          <p14:tracePt t="34462" x="1163638" y="5278438"/>
          <p14:tracePt t="34492" x="1163638" y="5287963"/>
          <p14:tracePt t="34568" x="1173163" y="5295900"/>
          <p14:tracePt t="34581" x="1173163" y="5310188"/>
          <p14:tracePt t="34588" x="1173163" y="5319713"/>
          <p14:tracePt t="34597" x="1173163" y="5327650"/>
          <p14:tracePt t="34605" x="1177925" y="5332413"/>
          <p14:tracePt t="34611" x="1177925" y="5351463"/>
          <p14:tracePt t="34627" x="1177925" y="5360988"/>
          <p14:tracePt t="34638" x="1177925" y="5397500"/>
          <p14:tracePt t="34642" x="1177925" y="5402263"/>
          <p14:tracePt t="34655" x="1177925" y="5410200"/>
          <p14:tracePt t="34661" x="1177925" y="5429250"/>
          <p14:tracePt t="34667" x="1177925" y="5434013"/>
          <p14:tracePt t="34677" x="1177925" y="5441950"/>
          <p14:tracePt t="34684" x="1177925" y="5461000"/>
          <p14:tracePt t="34693" x="1177925" y="5465763"/>
          <p14:tracePt t="34706" x="1177925" y="5492750"/>
          <p14:tracePt t="34713" x="1177925" y="5502275"/>
          <p14:tracePt t="34725" x="1177925" y="5511800"/>
          <p14:tracePt t="34734" x="1177925" y="5514975"/>
          <p14:tracePt t="34747" x="1177925" y="5534025"/>
          <p14:tracePt t="35329" x="1177925" y="5519738"/>
          <p14:tracePt t="35356" x="1177925" y="5511800"/>
          <p14:tracePt t="35370" x="1168400" y="5507038"/>
          <p14:tracePt t="35381" x="1160463" y="5487988"/>
          <p14:tracePt t="35399" x="1150938" y="5478463"/>
          <p14:tracePt t="35409" x="1150938" y="5465763"/>
          <p14:tracePt t="35433" x="1146175" y="5456238"/>
          <p14:tracePt t="35463" x="1136650" y="5446713"/>
          <p14:tracePt t="35475" x="1127125" y="5429250"/>
          <p14:tracePt t="35490" x="1127125" y="5424488"/>
          <p14:tracePt t="35499" x="1127125" y="5405438"/>
          <p14:tracePt t="35516" x="1127125" y="5378450"/>
          <p14:tracePt t="35529" x="1127125" y="5368925"/>
          <p14:tracePt t="35540" x="1109663" y="5341938"/>
          <p14:tracePt t="35551" x="1109663" y="5332413"/>
          <p14:tracePt t="35556" x="1109663" y="5327650"/>
          <p14:tracePt t="35566" x="1109663" y="5310188"/>
          <p14:tracePt t="35572" x="1109663" y="5300663"/>
          <p14:tracePt t="35579" x="1109663" y="5295900"/>
          <p14:tracePt t="35606" x="1109663" y="5287963"/>
          <p14:tracePt t="35631" x="1109663" y="5278438"/>
          <p14:tracePt t="35636" x="1100138" y="5273675"/>
          <p14:tracePt t="35656" x="1100138" y="5254625"/>
          <p14:tracePt t="35661" x="1100138" y="5237163"/>
          <p14:tracePt t="35671" x="1100138" y="5227638"/>
          <p14:tracePt t="35675" x="1100138" y="5214938"/>
          <p14:tracePt t="35689" x="1100138" y="5205413"/>
          <p14:tracePt t="35692" x="1100138" y="5186363"/>
          <p14:tracePt t="35705" x="1100138" y="5159375"/>
          <p14:tracePt t="35709" x="1100138" y="5149850"/>
          <p14:tracePt t="35718" x="1087438" y="5132388"/>
          <p14:tracePt t="35740" x="1087438" y="5127625"/>
          <p14:tracePt t="35812" x="1087438" y="5108575"/>
          <p14:tracePt t="35824" x="1087438" y="5100638"/>
          <p14:tracePt t="35834" x="1087438" y="5086350"/>
          <p14:tracePt t="35839" x="1087438" y="5076825"/>
          <p14:tracePt t="35847" x="1087438" y="5068888"/>
          <p14:tracePt t="35855" x="1087438" y="5064125"/>
          <p14:tracePt t="35865" x="1087438" y="5045075"/>
          <p14:tracePt t="35874" x="1087438" y="5027613"/>
          <p14:tracePt t="35877" x="1087438" y="5008563"/>
          <p14:tracePt t="35890" x="1087438" y="5003800"/>
          <p14:tracePt t="35904" x="1087438" y="4976813"/>
          <p14:tracePt t="35907" x="1087438" y="4972050"/>
          <p14:tracePt t="35919" x="1087438" y="4935538"/>
          <p14:tracePt t="35927" x="1087438" y="4918075"/>
          <p14:tracePt t="35933" x="1090613" y="4899025"/>
          <p14:tracePt t="35944" x="1090613" y="4845050"/>
          <p14:tracePt t="35955" x="1090613" y="4826000"/>
          <p14:tracePt t="35960" x="1090613" y="4799013"/>
          <p14:tracePt t="35971" x="1090613" y="4757738"/>
          <p14:tracePt t="35980" x="1090613" y="4725988"/>
          <p14:tracePt t="35983" x="1090613" y="4716463"/>
          <p14:tracePt t="35991" x="1090613" y="4702175"/>
          <p14:tracePt t="35999" x="1090613" y="4662488"/>
          <p14:tracePt t="36010" x="1090613" y="4629150"/>
          <p14:tracePt t="36013" x="1090613" y="4625975"/>
          <p14:tracePt t="36024" x="1090613" y="4560888"/>
          <p14:tracePt t="36029" x="1090613" y="4556125"/>
          <p14:tracePt t="36040" x="1090613" y="4529138"/>
          <p14:tracePt t="36050" x="1090613" y="4487863"/>
          <p14:tracePt t="36056" x="1090613" y="4470400"/>
          <p14:tracePt t="36066" x="1090613" y="4429125"/>
          <p14:tracePt t="36070" x="1090613" y="4410075"/>
          <p14:tracePt t="36079" x="1090613" y="4368800"/>
          <p14:tracePt t="36090" x="1090613" y="4341813"/>
          <p14:tracePt t="36100" x="1090613" y="4300538"/>
          <p14:tracePt t="36110" x="1090613" y="4283075"/>
          <p14:tracePt t="36123" x="1090613" y="4256088"/>
          <p14:tracePt t="36130" x="1090613" y="4237038"/>
          <p14:tracePt t="36139" x="1090613" y="4219575"/>
          <p14:tracePt t="36145" x="1090613" y="4200525"/>
          <p14:tracePt t="36150" x="1090613" y="4183063"/>
          <p14:tracePt t="36160" x="1100138" y="4154488"/>
          <p14:tracePt t="36171" x="1100138" y="4146550"/>
          <p14:tracePt t="36176" x="1100138" y="4137025"/>
          <p14:tracePt t="36189" x="1109663" y="4100513"/>
          <p14:tracePt t="36192" x="1109663" y="4095750"/>
          <p14:tracePt t="36206" x="1119188" y="4068763"/>
          <p14:tracePt t="36211" x="1119188" y="4059238"/>
          <p14:tracePt t="36215" x="1119188" y="4049713"/>
          <p14:tracePt t="36226" x="1127125" y="4027488"/>
          <p14:tracePt t="36232" x="1136650" y="3995738"/>
          <p14:tracePt t="36242" x="1136650" y="3976688"/>
          <p14:tracePt t="36256" x="1136650" y="3963988"/>
          <p14:tracePt t="36265" x="1136650" y="3954463"/>
          <p14:tracePt t="36272" x="1146175" y="3935413"/>
          <p14:tracePt t="36281" x="1146175" y="3917950"/>
          <p14:tracePt t="36291" x="1146175" y="3913188"/>
          <p14:tracePt t="36304" x="1146175" y="3903663"/>
          <p14:tracePt t="36307" x="1146175" y="3894138"/>
          <p14:tracePt t="36322" x="1146175" y="3889375"/>
          <p14:tracePt t="36388" x="1146175" y="3871913"/>
          <p14:tracePt t="36391" x="1146175" y="3862388"/>
          <p14:tracePt t="36620" x="1146175" y="3867150"/>
          <p14:tracePt t="36624" x="1146175" y="3886200"/>
          <p14:tracePt t="36630" x="1146175" y="3889375"/>
          <p14:tracePt t="36640" x="1146175" y="3917950"/>
          <p14:tracePt t="36646" x="1146175" y="3944938"/>
          <p14:tracePt t="36656" x="1146175" y="3954463"/>
          <p14:tracePt t="36660" x="1146175" y="3971925"/>
          <p14:tracePt t="36674" x="1146175" y="4013200"/>
          <p14:tracePt t="36680" x="1146175" y="4032250"/>
          <p14:tracePt t="36690" x="1146175" y="4037013"/>
          <p14:tracePt t="36696" x="1146175" y="4064000"/>
          <p14:tracePt t="36706" x="1146175" y="4105275"/>
          <p14:tracePt t="36716" x="1146175" y="4113213"/>
          <p14:tracePt t="36726" x="1155700" y="4127500"/>
          <p14:tracePt t="36736" x="1155700" y="4146550"/>
          <p14:tracePt t="36746" x="1155700" y="4164013"/>
          <p14:tracePt t="36755" x="1155700" y="4173538"/>
          <p14:tracePt t="36779" x="1155700" y="4183063"/>
          <p14:tracePt t="36857" x="1155700" y="4186238"/>
          <p14:tracePt t="36871" x="1155700" y="4195763"/>
          <p14:tracePt t="36881" x="1163638" y="4214813"/>
          <p14:tracePt t="36899" x="1163638" y="4219575"/>
          <p14:tracePt t="36916" x="1168400" y="4256088"/>
          <p14:tracePt t="36926" x="1168400" y="4273550"/>
          <p14:tracePt t="36930" x="1168400" y="4278313"/>
          <p14:tracePt t="36942" x="1168400" y="4295775"/>
          <p14:tracePt t="36953" x="1168400" y="4310063"/>
          <p14:tracePt t="36958" x="1168400" y="4329113"/>
          <p14:tracePt t="36967" x="1168400" y="4337050"/>
          <p14:tracePt t="36977" x="1168400" y="4351338"/>
          <p14:tracePt t="36987" x="1168400" y="4368800"/>
          <p14:tracePt t="36993" x="1168400" y="4387850"/>
          <p14:tracePt t="37008" x="1168400" y="4419600"/>
          <p14:tracePt t="37029" x="1168400" y="4424363"/>
          <p14:tracePt t="37120" x="1177925" y="4424363"/>
          <p14:tracePt t="37129" x="1187450" y="4424363"/>
          <p14:tracePt t="37140" x="1192213" y="4424363"/>
          <p14:tracePt t="37154" x="1200150" y="4424363"/>
          <p14:tracePt t="37170" x="1209675" y="4414838"/>
          <p14:tracePt t="37179" x="1223963" y="4414838"/>
          <p14:tracePt t="37184" x="1233488" y="4414838"/>
          <p14:tracePt t="37194" x="1241425" y="4414838"/>
          <p14:tracePt t="37199" x="1250950" y="4414838"/>
          <p14:tracePt t="37210" x="1265238" y="4414838"/>
          <p14:tracePt t="37222" x="1274763" y="4414838"/>
          <p14:tracePt t="39062" x="1287463" y="4414838"/>
          <p14:tracePt t="39073" x="1296988" y="4414838"/>
          <p14:tracePt t="39079" x="1306513" y="4419600"/>
          <p14:tracePt t="39742" x="1323975" y="4424363"/>
          <p14:tracePt t="39748" x="1343025" y="4456113"/>
          <p14:tracePt t="39753" x="1387475" y="4502150"/>
          <p14:tracePt t="39762" x="1497013" y="4657725"/>
          <p14:tracePt t="39772" x="1611313" y="4835525"/>
          <p14:tracePt t="39778" x="1698625" y="4954588"/>
          <p14:tracePt t="39788" x="1903413" y="5195888"/>
          <p14:tracePt t="39791" x="2009775" y="5300663"/>
          <p14:tracePt t="39804" x="2525713" y="5794375"/>
          <p14:tracePt t="39811" x="3119438" y="6173788"/>
          <p14:tracePt t="39822" x="3803650" y="6502400"/>
          <p14:tracePt t="39828" x="4552950" y="6780213"/>
        </p14:tracePtLst>
      </p14:laserTraceLst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EB879CD-8891-48AB-922C-653A2655BEB8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Per Locus LR of EFM and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endParaRPr lang="en-US" sz="280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8A71A94-2488-45E2-9FB0-C06E89AD545E}"/>
              </a:ext>
            </a:extLst>
          </p:cNvPr>
          <p:cNvGraphicFramePr>
            <a:graphicFrameLocks noGrp="1"/>
          </p:cNvGraphicFramePr>
          <p:nvPr/>
        </p:nvGraphicFramePr>
        <p:xfrm>
          <a:off x="2921098" y="835187"/>
          <a:ext cx="5916085" cy="55138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79021">
                  <a:extLst>
                    <a:ext uri="{9D8B030D-6E8A-4147-A177-3AD203B41FA5}">
                      <a16:colId xmlns:a16="http://schemas.microsoft.com/office/drawing/2014/main" val="3028104731"/>
                    </a:ext>
                  </a:extLst>
                </a:gridCol>
                <a:gridCol w="1272755">
                  <a:extLst>
                    <a:ext uri="{9D8B030D-6E8A-4147-A177-3AD203B41FA5}">
                      <a16:colId xmlns:a16="http://schemas.microsoft.com/office/drawing/2014/main" val="255243766"/>
                    </a:ext>
                  </a:extLst>
                </a:gridCol>
                <a:gridCol w="1389451">
                  <a:extLst>
                    <a:ext uri="{9D8B030D-6E8A-4147-A177-3AD203B41FA5}">
                      <a16:colId xmlns:a16="http://schemas.microsoft.com/office/drawing/2014/main" val="3943563408"/>
                    </a:ext>
                  </a:extLst>
                </a:gridCol>
                <a:gridCol w="1774858">
                  <a:extLst>
                    <a:ext uri="{9D8B030D-6E8A-4147-A177-3AD203B41FA5}">
                      <a16:colId xmlns:a16="http://schemas.microsoft.com/office/drawing/2014/main" val="2384991088"/>
                    </a:ext>
                  </a:extLst>
                </a:gridCol>
              </a:tblGrid>
              <a:tr h="4295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/</a:t>
                      </a:r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801505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36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3445203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36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10116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6179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5836654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365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593364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7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25996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238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1176533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7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64431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03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1751867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62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552500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6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815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201171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22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4254654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8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31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2705928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8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789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6052702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0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909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802016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975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23239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5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51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6945769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6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49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1835045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8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825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9699610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1.82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2314530"/>
                  </a:ext>
                </a:extLst>
              </a:tr>
              <a:tr h="241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7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6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15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0321142"/>
                  </a:ext>
                </a:extLst>
              </a:tr>
              <a:tr h="24899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88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17" marR="9517" marT="9517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5581378"/>
                  </a:ext>
                </a:extLst>
              </a:tr>
            </a:tbl>
          </a:graphicData>
        </a:graphic>
      </p:graphicFrame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CFA3106C-ABC5-4A7F-9654-D287262B90D9}"/>
              </a:ext>
            </a:extLst>
          </p:cNvPr>
          <p:cNvSpPr/>
          <p:nvPr/>
        </p:nvSpPr>
        <p:spPr>
          <a:xfrm>
            <a:off x="2902626" y="5595765"/>
            <a:ext cx="5924963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E24625EB-E75F-4FDE-BF9F-1CB71EAF0362}"/>
              </a:ext>
            </a:extLst>
          </p:cNvPr>
          <p:cNvSpPr/>
          <p:nvPr/>
        </p:nvSpPr>
        <p:spPr>
          <a:xfrm rot="2759521">
            <a:off x="4744164" y="510746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BAE4B052-0298-4A51-BE51-4D8C4498B61F}"/>
              </a:ext>
            </a:extLst>
          </p:cNvPr>
          <p:cNvSpPr/>
          <p:nvPr/>
        </p:nvSpPr>
        <p:spPr>
          <a:xfrm rot="8070277">
            <a:off x="6441585" y="511521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01D9140-D5FB-4896-964E-99DB11DC4FF3}"/>
              </a:ext>
            </a:extLst>
          </p:cNvPr>
          <p:cNvSpPr/>
          <p:nvPr/>
        </p:nvSpPr>
        <p:spPr>
          <a:xfrm>
            <a:off x="4083328" y="4686549"/>
            <a:ext cx="104387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5B38F52-36AB-4A07-8A68-A9D0EC88EE66}"/>
              </a:ext>
            </a:extLst>
          </p:cNvPr>
          <p:cNvSpPr/>
          <p:nvPr/>
        </p:nvSpPr>
        <p:spPr>
          <a:xfrm>
            <a:off x="6630360" y="4686549"/>
            <a:ext cx="110799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7287275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4878"/>
    </mc:Choice>
    <mc:Fallback xmlns="">
      <p:transition spd="slow" advTm="24878"/>
    </mc:Fallback>
  </mc:AlternateContent>
  <p:extLst>
    <p:ext uri="{3A86A75C-4F4B-4683-9AE1-C65F6400EC91}">
      <p14:laserTraceLst xmlns:p14="http://schemas.microsoft.com/office/powerpoint/2010/main">
        <p14:tracePtLst>
          <p14:tracePt t="3475" x="11593513" y="3667125"/>
          <p14:tracePt t="3480" x="11393488" y="3667125"/>
          <p14:tracePt t="3490" x="10598150" y="3667125"/>
          <p14:tracePt t="3494" x="10420350" y="3667125"/>
          <p14:tracePt t="3509" x="9544050" y="3667125"/>
          <p14:tracePt t="3514" x="8986838" y="3667125"/>
          <p14:tracePt t="3524" x="8804275" y="3667125"/>
          <p14:tracePt t="3528" x="8147050" y="3667125"/>
          <p14:tracePt t="3540" x="8018463" y="3667125"/>
          <p14:tracePt t="3545" x="7548563" y="3667125"/>
          <p14:tracePt t="3555" x="7388225" y="3667125"/>
          <p14:tracePt t="3558" x="7346950" y="3667125"/>
          <p14:tracePt t="3570" x="7256463" y="3711575"/>
          <p14:tracePt t="3575" x="7227888" y="3711575"/>
          <p14:tracePt t="3588" x="7183438" y="3743325"/>
          <p14:tracePt t="3594" x="7173913" y="3752850"/>
          <p14:tracePt t="3604" x="7164388" y="3771900"/>
          <p14:tracePt t="3610" x="7154863" y="3789363"/>
          <p14:tracePt t="3620" x="7154863" y="3794125"/>
          <p14:tracePt t="3624" x="7150100" y="3803650"/>
          <p14:tracePt t="3635" x="7150100" y="3813175"/>
          <p14:tracePt t="3640" x="7150100" y="3816350"/>
          <p14:tracePt t="3653" x="7142163" y="3825875"/>
          <p14:tracePt t="3660" x="7132638" y="3835400"/>
          <p14:tracePt t="3740" x="7127875" y="3835400"/>
          <p14:tracePt t="3748" x="7110413" y="3821113"/>
          <p14:tracePt t="3757" x="7073900" y="3762375"/>
          <p14:tracePt t="3761" x="7064375" y="3743325"/>
          <p14:tracePt t="3771" x="7000875" y="3652838"/>
          <p14:tracePt t="3777" x="6977063" y="3625850"/>
          <p14:tracePt t="3788" x="6899275" y="3506788"/>
          <p14:tracePt t="3796" x="6794500" y="3370263"/>
          <p14:tracePt t="3802" x="6784975" y="3360738"/>
          <p14:tracePt t="3812" x="6589713" y="3146425"/>
          <p14:tracePt t="3816" x="6565900" y="3117850"/>
          <p14:tracePt t="3826" x="6429375" y="2930525"/>
          <p14:tracePt t="3836" x="6310313" y="2813050"/>
          <p14:tracePt t="3842" x="6256338" y="2747963"/>
          <p14:tracePt t="3853" x="6146800" y="2593975"/>
          <p14:tracePt t="3857" x="6118225" y="2562225"/>
          <p14:tracePt t="3867" x="6013450" y="2443163"/>
          <p14:tracePt t="3877" x="5940425" y="2341563"/>
          <p14:tracePt t="3890" x="5930900" y="2333625"/>
          <p14:tracePt t="3893" x="5854700" y="2255838"/>
          <p14:tracePt t="3896" x="5845175" y="2224088"/>
          <p14:tracePt t="3906" x="5781675" y="2119313"/>
          <p14:tracePt t="3921" x="5757863" y="2100263"/>
          <p14:tracePt t="3923" x="5753100" y="2090738"/>
          <p14:tracePt t="3933" x="5699125" y="2027238"/>
          <p14:tracePt t="3939" x="5689600" y="2017713"/>
          <p14:tracePt t="3948" x="5657850" y="1981200"/>
          <p14:tracePt t="3958" x="5638800" y="1958975"/>
          <p14:tracePt t="3962" x="5630863" y="1939925"/>
          <p14:tracePt t="3973" x="5594350" y="1881188"/>
          <p14:tracePt t="3978" x="5584825" y="1862138"/>
          <p14:tracePt t="3988" x="5553075" y="1803400"/>
          <p14:tracePt t="3999" x="5521325" y="1771650"/>
          <p14:tracePt t="4002" x="5497513" y="1752600"/>
          <p14:tracePt t="4012" x="5487988" y="1712913"/>
          <p14:tracePt t="4019" x="5480050" y="1679575"/>
          <p14:tracePt t="4028" x="5443538" y="1639888"/>
          <p14:tracePt t="4038" x="5424488" y="1616075"/>
          <p14:tracePt t="4045" x="5424488" y="1598613"/>
          <p14:tracePt t="4055" x="5392738" y="1570038"/>
          <p14:tracePt t="4058" x="5392738" y="1562100"/>
          <p14:tracePt t="4071" x="5383213" y="1543050"/>
          <p14:tracePt t="4078" x="5378450" y="1533525"/>
          <p14:tracePt t="4089" x="5378450" y="1520825"/>
          <p14:tracePt t="4094" x="5370513" y="1501775"/>
          <p14:tracePt t="4109" x="5346700" y="1479550"/>
          <p14:tracePt t="4125" x="5346700" y="1474788"/>
          <p14:tracePt t="4128" x="5341938" y="1465263"/>
          <p14:tracePt t="4144" x="5334000" y="1455738"/>
          <p14:tracePt t="4311" x="5334000" y="1443038"/>
          <p14:tracePt t="4321" x="5324475" y="1433513"/>
          <p14:tracePt t="4328" x="5319713" y="1423988"/>
          <p14:tracePt t="4466" x="5310188" y="1416050"/>
          <p14:tracePt t="4513" x="5302250" y="1411288"/>
          <p14:tracePt t="4522" x="5292725" y="1411288"/>
          <p14:tracePt t="4536" x="5287963" y="1401763"/>
          <p14:tracePt t="4554" x="5278438" y="1382713"/>
          <p14:tracePt t="4583" x="5268913" y="1365250"/>
          <p14:tracePt t="4593" x="5260975" y="1346200"/>
          <p14:tracePt t="4972" x="5260975" y="1338263"/>
          <p14:tracePt t="4992" x="5260975" y="1333500"/>
          <p14:tracePt t="5068" x="5260975" y="1314450"/>
          <p14:tracePt t="5288" x="5264150" y="1328738"/>
          <p14:tracePt t="5294" x="5264150" y="1338263"/>
          <p14:tracePt t="5300" x="5264150" y="1365250"/>
          <p14:tracePt t="5310" x="5264150" y="1433513"/>
          <p14:tracePt t="5321" x="5264150" y="1474788"/>
          <p14:tracePt t="5324" x="5264150" y="1501775"/>
          <p14:tracePt t="5335" x="5264150" y="1603375"/>
          <p14:tracePt t="5340" x="5264150" y="1643063"/>
          <p14:tracePt t="5355" x="5278438" y="1803400"/>
          <p14:tracePt t="5360" x="5278438" y="1931988"/>
          <p14:tracePt t="5364" x="5278438" y="1973263"/>
          <p14:tracePt t="5374" x="5319713" y="2178050"/>
          <p14:tracePt t="5380" x="5319713" y="2219325"/>
          <p14:tracePt t="5391" x="5319713" y="2455863"/>
          <p14:tracePt t="5401" x="5319713" y="2533650"/>
          <p14:tracePt t="5407" x="5319713" y="2589213"/>
          <p14:tracePt t="5416" x="5351463" y="2752725"/>
          <p14:tracePt t="5424" x="5365750" y="2830513"/>
          <p14:tracePt t="5430" x="5365750" y="3054350"/>
          <p14:tracePt t="5440" x="5392738" y="3182938"/>
          <p14:tracePt t="5446" x="5392738" y="3214688"/>
          <p14:tracePt t="5456" x="5392738" y="3355975"/>
          <p14:tracePt t="5460" x="5392738" y="3414713"/>
          <p14:tracePt t="5470" x="5407025" y="3597275"/>
          <p14:tracePt t="5480" x="5407025" y="3689350"/>
          <p14:tracePt t="5487" x="5419725" y="3767138"/>
          <p14:tracePt t="5496" x="5419725" y="3927475"/>
          <p14:tracePt t="5502" x="5419725" y="3959225"/>
          <p14:tracePt t="5510" x="5419725" y="4132263"/>
          <p14:tracePt t="5521" x="5419725" y="4205288"/>
          <p14:tracePt t="5526" x="5419725" y="4246563"/>
          <p14:tracePt t="5538" x="5419725" y="4373563"/>
          <p14:tracePt t="5542" x="5429250" y="4405313"/>
          <p14:tracePt t="5556" x="5443538" y="4533900"/>
          <p14:tracePt t="5562" x="5443538" y="4589463"/>
          <p14:tracePt t="5566" x="5443538" y="4606925"/>
          <p14:tracePt t="5576" x="5443538" y="4694238"/>
          <p14:tracePt t="5582" x="5443538" y="4706938"/>
          <p14:tracePt t="5593" x="5443538" y="4762500"/>
          <p14:tracePt t="5607" x="5443538" y="4821238"/>
          <p14:tracePt t="5616" x="5443538" y="4876800"/>
          <p14:tracePt t="5622" x="5443538" y="4894263"/>
          <p14:tracePt t="5632" x="5443538" y="4949825"/>
          <p14:tracePt t="5642" x="5443538" y="4967288"/>
          <p14:tracePt t="5653" x="5443538" y="4972050"/>
          <p14:tracePt t="5662" x="5443538" y="4981575"/>
          <p14:tracePt t="5673" x="5443538" y="4991100"/>
          <p14:tracePt t="5809" x="5461000" y="4999038"/>
          <p14:tracePt t="5821" x="5461000" y="4995863"/>
          <p14:tracePt t="5829" x="5470525" y="4976813"/>
          <p14:tracePt t="5842" x="5492750" y="4876800"/>
          <p14:tracePt t="5846" x="5538788" y="4762500"/>
          <p14:tracePt t="5851" x="5548313" y="4730750"/>
          <p14:tracePt t="5864" x="5594350" y="4451350"/>
          <p14:tracePt t="5879" x="5684838" y="4154488"/>
          <p14:tracePt t="5884" x="5699125" y="3990975"/>
          <p14:tracePt t="5891" x="5699125" y="3930650"/>
          <p14:tracePt t="5904" x="5767388" y="3602038"/>
          <p14:tracePt t="5913" x="5826125" y="3178175"/>
          <p14:tracePt t="5924" x="5854700" y="3013075"/>
          <p14:tracePt t="5930" x="5881688" y="2949575"/>
          <p14:tracePt t="5941" x="5935663" y="2662238"/>
          <p14:tracePt t="5944" x="5935663" y="2643188"/>
          <p14:tracePt t="5959" x="6000750" y="2497138"/>
          <p14:tracePt t="5966" x="6013450" y="2438400"/>
          <p14:tracePt t="5975" x="6013450" y="2419350"/>
          <p14:tracePt t="5982" x="6049963" y="2333625"/>
          <p14:tracePt t="5993" x="6049963" y="2324100"/>
          <p14:tracePt t="5998" x="6059488" y="2260600"/>
          <p14:tracePt t="6010" x="6091238" y="2228850"/>
          <p14:tracePt t="6011" x="6091238" y="2200275"/>
          <p14:tracePt t="6021" x="6105525" y="2146300"/>
          <p14:tracePt t="6026" x="6115050" y="2136775"/>
          <p14:tracePt t="6036" x="6127750" y="2119313"/>
          <p14:tracePt t="6046" x="6127750" y="2109788"/>
          <p14:tracePt t="6052" x="6127750" y="2095500"/>
          <p14:tracePt t="6059" x="6151563" y="2063750"/>
          <p14:tracePt t="6074" x="6151563" y="2054225"/>
          <p14:tracePt t="6078" x="6151563" y="2032000"/>
          <p14:tracePt t="6093" x="6159500" y="1954213"/>
          <p14:tracePt t="6110" x="6173788" y="1854200"/>
          <p14:tracePt t="6119" x="6188075" y="1752600"/>
          <p14:tracePt t="6128" x="6188075" y="1720850"/>
          <p14:tracePt t="6132" x="6188075" y="1679575"/>
          <p14:tracePt t="6143" x="6196013" y="1598613"/>
          <p14:tracePt t="6145" x="6196013" y="1589088"/>
          <p14:tracePt t="6157" x="6205538" y="1552575"/>
          <p14:tracePt t="6166" x="6205538" y="1479550"/>
          <p14:tracePt t="6177" x="6227763" y="1455738"/>
          <p14:tracePt t="6184" x="6227763" y="1443038"/>
          <p14:tracePt t="6186" x="6227763" y="1433513"/>
          <p14:tracePt t="6196" x="6227763" y="1382713"/>
          <p14:tracePt t="6211" x="6237288" y="1365250"/>
          <p14:tracePt t="6222" x="6237288" y="1350963"/>
          <p14:tracePt t="6225" x="6256338" y="1328738"/>
          <p14:tracePt t="6239" x="6256338" y="1309688"/>
          <p14:tracePt t="6254" x="6256338" y="1296988"/>
          <p14:tracePt t="6262" x="6256338" y="1277938"/>
          <p14:tracePt t="6269" x="6256338" y="1270000"/>
          <p14:tracePt t="6279" x="6256338" y="1241425"/>
          <p14:tracePt t="6294" x="6256338" y="1228725"/>
          <p14:tracePt t="6307" x="6256338" y="1209675"/>
          <p14:tracePt t="6322" x="6256338" y="1204913"/>
          <p14:tracePt t="6328" x="6256338" y="1196975"/>
          <p14:tracePt t="6336" x="6256338" y="1177925"/>
          <p14:tracePt t="6491" x="6256338" y="1182688"/>
          <p14:tracePt t="6500" x="6256338" y="1192213"/>
          <p14:tracePt t="6511" x="6256338" y="1233488"/>
          <p14:tracePt t="6526" x="6256338" y="1282700"/>
          <p14:tracePt t="6530" x="6256338" y="1323975"/>
          <p14:tracePt t="6537" x="6256338" y="1350963"/>
          <p14:tracePt t="6544" x="6256338" y="1419225"/>
          <p14:tracePt t="6550" x="6251575" y="1465263"/>
          <p14:tracePt t="6560" x="6251575" y="1574800"/>
          <p14:tracePt t="6571" x="6237288" y="1684338"/>
          <p14:tracePt t="6576" x="6237288" y="1725613"/>
          <p14:tracePt t="6588" x="6237288" y="1885950"/>
          <p14:tracePt t="6591" x="6237288" y="1927225"/>
          <p14:tracePt t="6605" x="6237288" y="2119313"/>
          <p14:tracePt t="6610" x="6224588" y="2228850"/>
          <p14:tracePt t="6616" x="6224588" y="2268538"/>
          <p14:tracePt t="6626" x="6224588" y="2460625"/>
          <p14:tracePt t="6630" x="6224588" y="2520950"/>
          <p14:tracePt t="6641" x="6205538" y="2716213"/>
          <p14:tracePt t="6656" x="6205538" y="2886075"/>
          <p14:tracePt t="6671" x="6205538" y="3059113"/>
          <p14:tracePt t="6683" x="6205538" y="3187700"/>
          <p14:tracePt t="6692" x="6205538" y="3263900"/>
          <p14:tracePt t="6696" x="6205538" y="3292475"/>
          <p14:tracePt t="6706" x="6205538" y="3373438"/>
          <p14:tracePt t="6712" x="6205538" y="3406775"/>
          <p14:tracePt t="6723" x="6205538" y="3506788"/>
          <p14:tracePt t="6732" x="6205538" y="3579813"/>
          <p14:tracePt t="6739" x="6205538" y="3584575"/>
          <p14:tracePt t="6746" x="6205538" y="3662363"/>
          <p14:tracePt t="6754" x="6205538" y="3675063"/>
          <p14:tracePt t="6762" x="6205538" y="3776663"/>
          <p14:tracePt t="6773" x="6205538" y="3849688"/>
          <p14:tracePt t="6775" x="6205538" y="3881438"/>
          <p14:tracePt t="6786" x="6205538" y="4008438"/>
          <p14:tracePt t="6791" x="6205538" y="4037013"/>
          <p14:tracePt t="6804" x="6205538" y="4183063"/>
          <p14:tracePt t="6812" x="6205538" y="4256088"/>
          <p14:tracePt t="6821" x="6205538" y="4310063"/>
          <p14:tracePt t="6829" x="6205538" y="4475163"/>
          <p14:tracePt t="6832" x="6205538" y="4548188"/>
          <p14:tracePt t="6842" x="6205538" y="4730750"/>
          <p14:tracePt t="6854" x="6205538" y="4857750"/>
          <p14:tracePt t="6859" x="6205538" y="4913313"/>
          <p14:tracePt t="6871" x="6205538" y="5113338"/>
          <p14:tracePt t="6873" x="6205538" y="5141913"/>
          <p14:tracePt t="6882" x="6205538" y="5314950"/>
          <p14:tracePt t="6895" x="6205538" y="5461000"/>
          <p14:tracePt t="6898" x="6205538" y="5534025"/>
          <p14:tracePt t="6908" x="6205538" y="5757863"/>
          <p14:tracePt t="6914" x="6205538" y="5811838"/>
          <p14:tracePt t="6925" x="6205538" y="6064250"/>
          <p14:tracePt t="6940" x="6205538" y="6227763"/>
          <p14:tracePt t="6949" x="6205538" y="6373813"/>
          <p14:tracePt t="6959" x="6205538" y="6392863"/>
          <p14:tracePt t="6964" x="6205538" y="6519863"/>
          <p14:tracePt t="6975" x="6205538" y="6592888"/>
          <p14:tracePt t="6978" x="6205538" y="6602413"/>
          <p14:tracePt t="6989" x="6215063" y="6675438"/>
          <p14:tracePt t="6994" x="6215063" y="6692900"/>
          <p14:tracePt t="7004" x="6215063" y="6721475"/>
          <p14:tracePt t="7014" x="6224588" y="6753225"/>
          <p14:tracePt t="7402" x="6242050" y="6753225"/>
          <p14:tracePt t="7409" x="6256338" y="6753225"/>
          <p14:tracePt t="7419" x="6264275" y="6753225"/>
          <p14:tracePt t="7426" x="6300788" y="6753225"/>
          <p14:tracePt t="7433" x="6356350" y="6748463"/>
          <p14:tracePt t="7440" x="6373813" y="6738938"/>
          <p14:tracePt t="7449" x="6507163" y="6738938"/>
          <p14:tracePt t="7458" x="6534150" y="6738938"/>
          <p14:tracePt t="7462" x="6777038" y="6738938"/>
          <p14:tracePt t="7474" x="6959600" y="6748463"/>
          <p14:tracePt t="7478" x="7032625" y="6762750"/>
          <p14:tracePt t="7489" x="7232650" y="6762750"/>
          <p14:tracePt t="7494" x="7310438" y="6770688"/>
          <p14:tracePt t="7504" x="7519988" y="6821488"/>
          <p14:tracePt t="7514" x="7670800" y="6853238"/>
          <p14:tracePt t="7594" x="8178800" y="6680200"/>
          <p14:tracePt t="7600" x="8228013" y="6616700"/>
          <p14:tracePt t="7610" x="8274050" y="6465888"/>
          <p14:tracePt t="7615" x="8288338" y="6405563"/>
          <p14:tracePt t="7625" x="8383588" y="6054725"/>
          <p14:tracePt t="7638" x="8420100" y="5811838"/>
          <p14:tracePt t="7641" x="8447088" y="5711825"/>
          <p14:tracePt t="7656" x="8585200" y="5186363"/>
          <p14:tracePt t="7665" x="8643938" y="4789488"/>
          <p14:tracePt t="7675" x="8689975" y="4606925"/>
          <p14:tracePt t="7680" x="8702675" y="4511675"/>
          <p14:tracePt t="7691" x="8804275" y="4137025"/>
          <p14:tracePt t="7694" x="8831263" y="4040188"/>
          <p14:tracePt t="7705" x="8926513" y="3689350"/>
          <p14:tracePt t="7722" x="8999538" y="3406775"/>
          <p14:tracePt t="7730" x="9055100" y="3090863"/>
          <p14:tracePt t="7738" x="9082088" y="3013075"/>
          <p14:tracePt t="7746" x="9142413" y="2671763"/>
          <p14:tracePt t="7758" x="9142413" y="2506663"/>
          <p14:tracePt t="7760" x="9150350" y="2447925"/>
          <p14:tracePt t="7772" x="9150350" y="2265363"/>
          <p14:tracePt t="7776" x="9150350" y="2224088"/>
          <p14:tracePt t="7787" x="9142413" y="2063750"/>
          <p14:tracePt t="7796" x="9128125" y="1973263"/>
          <p14:tracePt t="7804" x="9128125" y="1954213"/>
          <p14:tracePt t="7810" x="9091613" y="1835150"/>
          <p14:tracePt t="7816" x="9091613" y="1822450"/>
          <p14:tracePt t="7827" x="9050338" y="1689100"/>
          <p14:tracePt t="7838" x="9028113" y="1611313"/>
          <p14:tracePt t="7843" x="9028113" y="1579563"/>
          <p14:tracePt t="7857" x="8977313" y="1419225"/>
          <p14:tracePt t="7866" x="8918575" y="1306513"/>
          <p14:tracePt t="7877" x="8882063" y="1241425"/>
          <p14:tracePt t="7882" x="8858250" y="1223963"/>
          <p14:tracePt t="7892" x="8821738" y="1119188"/>
          <p14:tracePt t="7907" x="8763000" y="1009650"/>
          <p14:tracePt t="7923" x="8707438" y="944563"/>
          <p14:tracePt t="7932" x="8621713" y="844550"/>
          <p14:tracePt t="7938" x="8616950" y="835025"/>
          <p14:tracePt t="7946" x="8548688" y="771525"/>
          <p14:tracePt t="7958" x="8502650" y="749300"/>
          <p14:tracePt t="7963" x="8483600" y="739775"/>
          <p14:tracePt t="7973" x="8410575" y="703263"/>
          <p14:tracePt t="7982" x="8393113" y="693738"/>
          <p14:tracePt t="7989" x="8347075" y="657225"/>
          <p14:tracePt t="7998" x="8288338" y="635000"/>
          <p14:tracePt t="8006" x="8269288" y="635000"/>
          <p14:tracePt t="8012" x="8196263" y="598488"/>
          <p14:tracePt t="8022" x="8178800" y="598488"/>
          <p14:tracePt t="8028" x="8091488" y="584200"/>
          <p14:tracePt t="8039" x="8035925" y="584200"/>
          <p14:tracePt t="8043" x="8018463" y="584200"/>
          <p14:tracePt t="8051" x="7935913" y="584200"/>
          <p14:tracePt t="8058" x="7918450" y="584200"/>
          <p14:tracePt t="8068" x="7845425" y="584200"/>
          <p14:tracePt t="8078" x="7804150" y="584200"/>
          <p14:tracePt t="8088" x="7789863" y="584200"/>
          <p14:tracePt t="8094" x="7731125" y="603250"/>
          <p14:tracePt t="8098" x="7712075" y="611188"/>
          <p14:tracePt t="8109" x="7634288" y="676275"/>
          <p14:tracePt t="8121" x="7593013" y="698500"/>
          <p14:tracePt t="8125" x="7561263" y="717550"/>
          <p14:tracePt t="8139" x="7475538" y="827088"/>
          <p14:tracePt t="8148" x="7410450" y="931863"/>
          <p14:tracePt t="8159" x="7346950" y="968375"/>
          <p14:tracePt t="8164" x="7337425" y="1000125"/>
          <p14:tracePt t="8174" x="7264400" y="1168400"/>
          <p14:tracePt t="8180" x="7264400" y="1177925"/>
          <p14:tracePt t="8192" x="7210425" y="1382713"/>
          <p14:tracePt t="8205" x="7154863" y="1543050"/>
          <p14:tracePt t="8215" x="7113588" y="1730375"/>
          <p14:tracePt t="8221" x="7100888" y="1789113"/>
          <p14:tracePt t="8230" x="7023100" y="2136775"/>
          <p14:tracePt t="8241" x="7008813" y="2314575"/>
          <p14:tracePt t="8244" x="6996113" y="2411413"/>
          <p14:tracePt t="8256" x="6959600" y="2803525"/>
          <p14:tracePt t="8260" x="6959600" y="2876550"/>
          <p14:tracePt t="8271" x="6959600" y="3319463"/>
          <p14:tracePt t="8280" x="6959600" y="3543300"/>
          <p14:tracePt t="8286" x="6959600" y="3633788"/>
          <p14:tracePt t="8296" x="6959600" y="4049713"/>
          <p14:tracePt t="8302" x="6959600" y="4122738"/>
          <p14:tracePt t="8310" x="6972300" y="4456113"/>
          <p14:tracePt t="8322" x="7000875" y="4643438"/>
          <p14:tracePt t="8326" x="7013575" y="4702175"/>
          <p14:tracePt t="8338" x="7086600" y="4995863"/>
          <p14:tracePt t="8341" x="7113588" y="5072063"/>
          <p14:tracePt t="8354" x="7227888" y="5373688"/>
          <p14:tracePt t="8360" x="7300913" y="5511800"/>
          <p14:tracePt t="8372" x="7324725" y="5556250"/>
          <p14:tracePt t="8377" x="7429500" y="5711825"/>
          <p14:tracePt t="8380" x="7443788" y="5738813"/>
          <p14:tracePt t="8391" x="7488238" y="5799138"/>
          <p14:tracePt t="8405" x="7507288" y="5821363"/>
          <p14:tracePt t="8408" x="7516813" y="5826125"/>
          <p14:tracePt t="8766" x="7534275" y="5835650"/>
          <p14:tracePt t="8775" x="7575550" y="5835650"/>
          <p14:tracePt t="8781" x="7629525" y="5835650"/>
          <p14:tracePt t="8785" x="7648575" y="5835650"/>
          <p14:tracePt t="8795" x="7762875" y="5826125"/>
          <p14:tracePt t="8801" x="7789863" y="5826125"/>
          <p14:tracePt t="8810" x="7967663" y="5799138"/>
          <p14:tracePt t="8821" x="8101013" y="5784850"/>
          <p14:tracePt t="8824" x="8142288" y="5784850"/>
          <p14:tracePt t="8837" x="8483600" y="5753100"/>
          <p14:tracePt t="8840" x="8612188" y="5734050"/>
          <p14:tracePt t="8852" x="9201150" y="5670550"/>
          <p14:tracePt t="8860" x="9731375" y="5624513"/>
          <p14:tracePt t="8863" x="9882188" y="5592763"/>
          <p14:tracePt t="8901" x="11880850" y="5068888"/>
          <p14:tracePt t="8907" x="12014200" y="5022850"/>
          <p14:tracePt t="11433" x="9794875" y="6373813"/>
          <p14:tracePt t="11440" x="9775825" y="6383338"/>
          <p14:tracePt t="11448" x="9671050" y="6437313"/>
          <p14:tracePt t="11454" x="9653588" y="6437313"/>
          <p14:tracePt t="11461" x="9556750" y="6446838"/>
          <p14:tracePt t="11473" x="9498013" y="6446838"/>
          <p14:tracePt t="11478" x="9471025" y="6461125"/>
          <p14:tracePt t="11490" x="9369425" y="6470650"/>
          <p14:tracePt t="11492" x="9351963" y="6470650"/>
          <p14:tracePt t="11504" x="9251950" y="6470650"/>
          <p14:tracePt t="11512" x="9178925" y="6470650"/>
          <p14:tracePt t="11520" x="9145588" y="6483350"/>
          <p14:tracePt t="11528" x="9064625" y="6483350"/>
          <p14:tracePt t="11539" x="9023350" y="6483350"/>
          <p14:tracePt t="11546" x="8921750" y="6483350"/>
          <p14:tracePt t="11554" x="8894763" y="6483350"/>
          <p14:tracePt t="11558" x="8863013" y="6483350"/>
          <p14:tracePt t="11571" x="8780463" y="6483350"/>
          <p14:tracePt t="11574" x="8763000" y="6483350"/>
          <p14:tracePt t="11589" x="8680450" y="6483350"/>
          <p14:tracePt t="11594" x="8639175" y="6483350"/>
          <p14:tracePt t="11598" x="8607425" y="6483350"/>
          <p14:tracePt t="11609" x="8580438" y="6473825"/>
          <p14:tracePt t="11614" x="8561388" y="6465888"/>
          <p14:tracePt t="11625" x="8529638" y="6456363"/>
          <p14:tracePt t="11638" x="8512175" y="6456363"/>
          <p14:tracePt t="11640" x="8470900" y="6434138"/>
          <p14:tracePt t="11652" x="8461375" y="6429375"/>
          <p14:tracePt t="11654" x="8451850" y="6419850"/>
          <p14:tracePt t="11665" x="8424863" y="6419850"/>
          <p14:tracePt t="11675" x="8420100" y="6410325"/>
          <p14:tracePt t="11680" x="8410575" y="6410325"/>
          <p14:tracePt t="11691" x="8374063" y="6392863"/>
          <p14:tracePt t="11695" x="8366125" y="6392863"/>
          <p14:tracePt t="11704" x="8347075" y="6383338"/>
          <p14:tracePt t="11714" x="8274050" y="6319838"/>
          <p14:tracePt t="11721" x="8264525" y="6319838"/>
          <p14:tracePt t="11730" x="8247063" y="6315075"/>
          <p14:tracePt t="11734" x="8242300" y="6315075"/>
          <p14:tracePt t="11744" x="8223250" y="6315075"/>
          <p14:tracePt t="11757" x="8215313" y="6315075"/>
          <p14:tracePt t="11772" x="8210550" y="6315075"/>
          <p14:tracePt t="11788" x="8191500" y="6315075"/>
          <p14:tracePt t="11796" x="8183563" y="6315075"/>
          <p14:tracePt t="11800" x="8154988" y="6315075"/>
          <p14:tracePt t="11810" x="8142288" y="6315075"/>
          <p14:tracePt t="11820" x="8132763" y="6315075"/>
          <p14:tracePt t="11826" x="8081963" y="6315075"/>
          <p14:tracePt t="11838" x="8054975" y="6315075"/>
          <p14:tracePt t="11841" x="8045450" y="6315075"/>
          <p14:tracePt t="11853" x="7959725" y="6315075"/>
          <p14:tracePt t="11856" x="7945438" y="6315075"/>
          <p14:tracePt t="11870" x="7845425" y="6315075"/>
          <p14:tracePt t="11891" x="7743825" y="6315075"/>
          <p14:tracePt t="11892" x="7634288" y="6315075"/>
          <p14:tracePt t="11896" x="7593013" y="6315075"/>
          <p14:tracePt t="11908" x="7466013" y="6315075"/>
          <p14:tracePt t="11920" x="7370763" y="6315075"/>
          <p14:tracePt t="11923" x="7342188" y="6315075"/>
          <p14:tracePt t="11932" x="7215188" y="6315075"/>
          <p14:tracePt t="11941" x="7142163" y="6315075"/>
          <p14:tracePt t="11947" x="6977063" y="6315075"/>
          <p14:tracePt t="11957" x="6831013" y="6315075"/>
          <p14:tracePt t="11962" x="6789738" y="6315075"/>
          <p14:tracePt t="11973" x="6548438" y="6315075"/>
          <p14:tracePt t="11978" x="6507163" y="6315075"/>
          <p14:tracePt t="11990" x="6315075" y="6315075"/>
          <p14:tracePt t="11998" x="6169025" y="6315075"/>
          <p14:tracePt t="12004" x="6127750" y="6315075"/>
          <p14:tracePt t="12012" x="5935663" y="6315075"/>
          <p14:tracePt t="12021" x="5894388" y="6315075"/>
          <p14:tracePt t="12029" x="5670550" y="6283325"/>
          <p14:tracePt t="12039" x="5561013" y="6283325"/>
          <p14:tracePt t="12043" x="5487988" y="6283325"/>
          <p14:tracePt t="12054" x="5151438" y="6264275"/>
          <p14:tracePt t="12059" x="5059363" y="6264275"/>
          <p14:tracePt t="12071" x="4699000" y="6246813"/>
          <p14:tracePt t="12079" x="4548188" y="6213475"/>
          <p14:tracePt t="12082" x="4470400" y="6200775"/>
          <p14:tracePt t="12093" x="4260850" y="6154738"/>
          <p14:tracePt t="12098" x="4200525" y="6140450"/>
          <p14:tracePt t="12109" x="4090988" y="6127750"/>
          <p14:tracePt t="12122" x="4041775" y="6091238"/>
          <p14:tracePt t="12125" x="4022725" y="6081713"/>
          <p14:tracePt t="12139" x="3971925" y="6054725"/>
          <p14:tracePt t="12148" x="3963988" y="6054725"/>
          <p14:tracePt t="12158" x="3954463" y="6045200"/>
          <p14:tracePt t="12163" x="3949700" y="6035675"/>
          <p14:tracePt t="12205" x="3940175" y="6022975"/>
          <p14:tracePt t="12214" x="3922713" y="6022975"/>
          <p14:tracePt t="12224" x="3903663" y="6013450"/>
          <p14:tracePt t="12230" x="3895725" y="6003925"/>
          <p14:tracePt t="12244" x="3867150" y="5994400"/>
          <p14:tracePt t="12256" x="3825875" y="5972175"/>
          <p14:tracePt t="12260" x="3817938" y="5954713"/>
          <p14:tracePt t="12272" x="3786188" y="5921375"/>
          <p14:tracePt t="12280" x="3752850" y="5913438"/>
          <p14:tracePt t="12287" x="3749675" y="5903913"/>
          <p14:tracePt t="12294" x="3713163" y="5894388"/>
          <p14:tracePt t="12304" x="3679825" y="5884863"/>
          <p14:tracePt t="12310" x="3606800" y="5862638"/>
          <p14:tracePt t="12320" x="3575050" y="5830888"/>
          <p14:tracePt t="12324" x="3548063" y="5821363"/>
          <p14:tracePt t="12338" x="3460750" y="5807075"/>
          <p14:tracePt t="12341" x="3429000" y="5807075"/>
          <p14:tracePt t="12353" x="3360738" y="5807075"/>
          <p14:tracePt t="12360" x="3333750" y="5807075"/>
          <p14:tracePt t="12371" x="3324225" y="5807075"/>
          <p14:tracePt t="12376" x="3287713" y="5807075"/>
          <p14:tracePt t="12380" x="3282950" y="5807075"/>
          <p14:tracePt t="12391" x="3273425" y="5807075"/>
          <p14:tracePt t="12401" x="3265488" y="5811838"/>
          <p14:tracePt t="12496" x="3255963" y="5826125"/>
          <p14:tracePt t="12517" x="3255963" y="5835650"/>
          <p14:tracePt t="12523" x="3255963" y="5853113"/>
          <p14:tracePt t="12532" x="3255963" y="5872163"/>
          <p14:tracePt t="12541" x="3255963" y="5876925"/>
          <p14:tracePt t="12546" x="3255963" y="5884863"/>
          <p14:tracePt t="12554" x="3255963" y="5913438"/>
          <p14:tracePt t="12571" x="3255963" y="5930900"/>
          <p14:tracePt t="12578" x="3255963" y="5945188"/>
          <p14:tracePt t="12591" x="3255963" y="5954713"/>
          <p14:tracePt t="12593" x="3260725" y="5981700"/>
          <p14:tracePt t="12609" x="3270250" y="5991225"/>
          <p14:tracePt t="12714" x="3270250" y="5994400"/>
          <p14:tracePt t="13510" x="3270250" y="6003925"/>
          <p14:tracePt t="13669" x="3287713" y="6003925"/>
          <p14:tracePt t="13734" x="3302000" y="6003925"/>
          <p14:tracePt t="13742" x="3319463" y="6003925"/>
          <p14:tracePt t="13752" x="3328988" y="6003925"/>
          <p14:tracePt t="13762" x="3346450" y="6003925"/>
          <p14:tracePt t="13773" x="3351213" y="6003925"/>
          <p14:tracePt t="13778" x="3370263" y="6003925"/>
          <p14:tracePt t="13799" x="3387725" y="6003925"/>
          <p14:tracePt t="13805" x="3392488" y="6003925"/>
          <p14:tracePt t="13812" x="3402013" y="6003925"/>
          <p14:tracePt t="13823" x="3411538" y="6003925"/>
          <p14:tracePt t="13828" x="3419475" y="6003925"/>
          <p14:tracePt t="14132" x="3424238" y="6003925"/>
          <p14:tracePt t="14140" x="3460750" y="6003925"/>
          <p14:tracePt t="14152" x="3475038" y="6003925"/>
          <p14:tracePt t="14158" x="3484563" y="6003925"/>
          <p14:tracePt t="14171" x="3543300" y="6013450"/>
          <p14:tracePt t="14184" x="3602038" y="6013450"/>
          <p14:tracePt t="14195" x="3643313" y="6027738"/>
          <p14:tracePt t="14205" x="3662363" y="6027738"/>
          <p14:tracePt t="14208" x="3730625" y="6035675"/>
          <p14:tracePt t="14214" x="3762375" y="6035675"/>
          <p14:tracePt t="14223" x="3862388" y="6049963"/>
          <p14:tracePt t="14232" x="3922713" y="6072188"/>
          <p14:tracePt t="14240" x="3954463" y="6072188"/>
          <p14:tracePt t="14246" x="4083050" y="6100763"/>
          <p14:tracePt t="14254" x="4114800" y="6100763"/>
          <p14:tracePt t="14261" x="4241800" y="6127750"/>
          <p14:tracePt t="14272" x="4338638" y="6140450"/>
          <p14:tracePt t="14275" x="4365625" y="6149975"/>
          <p14:tracePt t="14286" x="4497388" y="6164263"/>
          <p14:tracePt t="14292" x="4525963" y="6164263"/>
          <p14:tracePt t="14303" x="4708525" y="6205538"/>
          <p14:tracePt t="14312" x="4784725" y="6218238"/>
          <p14:tracePt t="14319" x="4857750" y="6218238"/>
          <p14:tracePt t="14328" x="5045075" y="6264275"/>
          <p14:tracePt t="14333" x="5100638" y="6264275"/>
          <p14:tracePt t="14342" x="5334000" y="6296025"/>
          <p14:tracePt t="14355" x="5502275" y="6359525"/>
          <p14:tracePt t="14359" x="5557838" y="6359525"/>
          <p14:tracePt t="14373" x="5835650" y="6388100"/>
          <p14:tracePt t="14382" x="6200775" y="6424613"/>
          <p14:tracePt t="14392" x="6446838" y="6461125"/>
          <p14:tracePt t="14398" x="6524625" y="6473825"/>
          <p14:tracePt t="14409" x="6881813" y="6473825"/>
          <p14:tracePt t="14414" x="6959600" y="6483350"/>
          <p14:tracePt t="14424" x="7154863" y="6483350"/>
          <p14:tracePt t="14436" x="7264400" y="6483350"/>
          <p14:tracePt t="14439" x="7283450" y="6483350"/>
          <p14:tracePt t="14448" x="7356475" y="6483350"/>
          <p14:tracePt t="14455" x="7370763" y="6483350"/>
          <p14:tracePt t="14464" x="7424738" y="6483350"/>
          <p14:tracePt t="14474" x="7443788" y="6483350"/>
          <p14:tracePt t="14478" x="7451725" y="6483350"/>
          <p14:tracePt t="14490" x="7466013" y="6483350"/>
          <p14:tracePt t="14494" x="7475538" y="6483350"/>
          <p14:tracePt t="14505" x="7493000" y="6483350"/>
          <p14:tracePt t="14514" x="7512050" y="6483350"/>
          <p14:tracePt t="14522" x="7516813" y="6483350"/>
          <p14:tracePt t="14530" x="7543800" y="6483350"/>
          <p14:tracePt t="14540" x="7553325" y="6483350"/>
          <p14:tracePt t="14544" x="7589838" y="6483350"/>
          <p14:tracePt t="14558" x="7607300" y="6483350"/>
          <p14:tracePt t="14560" x="7612063" y="6483350"/>
          <p14:tracePt t="14570" x="7648575" y="6483350"/>
          <p14:tracePt t="14574" x="7658100" y="6483350"/>
          <p14:tracePt t="14587" x="7702550" y="6483350"/>
          <p14:tracePt t="14594" x="7743825" y="6483350"/>
          <p14:tracePt t="14604" x="7753350" y="6470650"/>
          <p14:tracePt t="14610" x="7808913" y="6470650"/>
          <p14:tracePt t="14614" x="7826375" y="6470650"/>
          <p14:tracePt t="14625" x="7913688" y="6470650"/>
          <p14:tracePt t="14637" x="7986713" y="6470650"/>
          <p14:tracePt t="14640" x="8004175" y="6470650"/>
          <p14:tracePt t="14655" x="8118475" y="6470650"/>
          <p14:tracePt t="14657" x="8132763" y="6470650"/>
          <p14:tracePt t="14670" x="8237538" y="6446838"/>
          <p14:tracePt t="14676" x="8256588" y="6415088"/>
          <p14:tracePt t="14680" x="8283575" y="6415088"/>
          <p14:tracePt t="14690" x="8369300" y="6400800"/>
          <p14:tracePt t="14696" x="8388350" y="6392863"/>
          <p14:tracePt t="14707" x="8475663" y="6369050"/>
          <p14:tracePt t="14721" x="8556625" y="6346825"/>
          <p14:tracePt t="14730" x="8626475" y="6319838"/>
          <p14:tracePt t="14736" x="8648700" y="6300788"/>
          <p14:tracePt t="14746" x="8736013" y="6249988"/>
          <p14:tracePt t="14756" x="8753475" y="6242050"/>
          <p14:tracePt t="14762" x="8785225" y="6218238"/>
          <p14:tracePt t="14772" x="8831263" y="6186488"/>
          <p14:tracePt t="14776" x="8840788" y="6169025"/>
          <p14:tracePt t="14786" x="8858250" y="6149975"/>
          <p14:tracePt t="14797" x="8890000" y="6127750"/>
          <p14:tracePt t="14804" x="8899525" y="6118225"/>
          <p14:tracePt t="14812" x="8899525" y="6103938"/>
          <p14:tracePt t="14820" x="8909050" y="6072188"/>
          <p14:tracePt t="14826" x="8909050" y="6064250"/>
          <p14:tracePt t="14837" x="8918575" y="6040438"/>
          <p14:tracePt t="14847" x="8918575" y="5999163"/>
          <p14:tracePt t="14857" x="8918575" y="5967413"/>
          <p14:tracePt t="14872" x="8918575" y="5962650"/>
          <p14:tracePt t="14878" x="8918575" y="5954713"/>
          <p14:tracePt t="14939" x="8918575" y="5945188"/>
          <p14:tracePt t="14968" x="8918575" y="5935663"/>
          <p14:tracePt t="14973" x="8918575" y="5921375"/>
          <p14:tracePt t="14982" x="8918575" y="5913438"/>
          <p14:tracePt t="14995" x="8918575" y="5903913"/>
          <p14:tracePt t="15006" x="8918575" y="5899150"/>
          <p14:tracePt t="15014" x="8918575" y="5889625"/>
          <p14:tracePt t="15019" x="8913813" y="5881688"/>
          <p14:tracePt t="15028" x="8913813" y="5867400"/>
          <p14:tracePt t="15039" x="8894763" y="5843588"/>
          <p14:tracePt t="15045" x="8885238" y="5840413"/>
          <p14:tracePt t="15055" x="8877300" y="5821363"/>
          <p14:tracePt t="15072" x="8858250" y="5803900"/>
          <p14:tracePt t="15078" x="8848725" y="5794375"/>
          <p14:tracePt t="15089" x="8831263" y="5767388"/>
          <p14:tracePt t="15106" x="8821738" y="5757863"/>
          <p14:tracePt t="15111" x="8816975" y="5753100"/>
          <p14:tracePt t="15121" x="8809038" y="5743575"/>
          <p14:tracePt t="15124" x="8799513" y="5734050"/>
          <p14:tracePt t="15137" x="8772525" y="5716588"/>
          <p14:tracePt t="15144" x="8743950" y="5707063"/>
          <p14:tracePt t="15155" x="8707438" y="5661025"/>
          <p14:tracePt t="15160" x="8702675" y="5653088"/>
          <p14:tracePt t="15164" x="8694738" y="5648325"/>
          <p14:tracePt t="15175" x="8643938" y="5616575"/>
          <p14:tracePt t="15180" x="8634413" y="5597525"/>
          <p14:tracePt t="15190" x="8589963" y="5561013"/>
          <p14:tracePt t="15205" x="8539163" y="5551488"/>
          <p14:tracePt t="15221" x="8478838" y="5534025"/>
          <p14:tracePt t="15230" x="8442325" y="5524500"/>
          <p14:tracePt t="15241" x="8397875" y="5502275"/>
          <p14:tracePt t="15246" x="8378825" y="5492750"/>
          <p14:tracePt t="15257" x="8337550" y="5492750"/>
          <p14:tracePt t="15260" x="8329613" y="5492750"/>
          <p14:tracePt t="15271" x="8315325" y="5492750"/>
          <p14:tracePt t="15280" x="8305800" y="5492750"/>
          <p14:tracePt t="15289" x="8288338" y="5483225"/>
          <p14:tracePt t="15296" x="8283575" y="5483225"/>
          <p14:tracePt t="15311" x="8274050" y="5483225"/>
          <p14:tracePt t="15322" x="8247063" y="5483225"/>
          <p14:tracePt t="15332" x="8228013" y="5483225"/>
          <p14:tracePt t="15337" x="8223250" y="5483225"/>
          <p14:tracePt t="15342" x="8215313" y="5483225"/>
          <p14:tracePt t="15354" x="8178800" y="5483225"/>
          <p14:tracePt t="15363" x="8137525" y="5483225"/>
          <p14:tracePt t="15370" x="8108950" y="5483225"/>
          <p14:tracePt t="15376" x="8023225" y="5483225"/>
          <p14:tracePt t="15383" x="8013700" y="5483225"/>
          <p14:tracePt t="15392" x="7931150" y="5483225"/>
          <p14:tracePt t="15405" x="7889875" y="5483225"/>
          <p14:tracePt t="15407" x="7872413" y="5483225"/>
          <p14:tracePt t="15421" x="7826375" y="5511800"/>
          <p14:tracePt t="15424" x="7794625" y="5519738"/>
          <p14:tracePt t="15433" x="7767638" y="5519738"/>
          <p14:tracePt t="15442" x="7748588" y="5529263"/>
          <p14:tracePt t="15448" x="7716838" y="5543550"/>
          <p14:tracePt t="15458" x="7689850" y="5551488"/>
          <p14:tracePt t="15471" x="7680325" y="5551488"/>
          <p14:tracePt t="15473" x="7662863" y="5561013"/>
          <p14:tracePt t="15492" x="7643813" y="5570538"/>
          <p14:tracePt t="15498" x="7626350" y="5570538"/>
          <p14:tracePt t="15505" x="7616825" y="5570538"/>
          <p14:tracePt t="15512" x="7612063" y="5588000"/>
          <p14:tracePt t="15523" x="7593013" y="5597525"/>
          <p14:tracePt t="15533" x="7561263" y="5607050"/>
          <p14:tracePt t="15539" x="7553325" y="5616575"/>
          <p14:tracePt t="15549" x="7539038" y="5616575"/>
          <p14:tracePt t="15555" x="7516813" y="5634038"/>
          <p14:tracePt t="15564" x="7512050" y="5638800"/>
          <p14:tracePt t="15575" x="7493000" y="5665788"/>
          <p14:tracePt t="15579" x="7483475" y="5675313"/>
          <p14:tracePt t="15589" x="7475538" y="5684838"/>
          <p14:tracePt t="15594" x="7470775" y="5684838"/>
          <p14:tracePt t="15606" x="7461250" y="5694363"/>
          <p14:tracePt t="15608" x="7451725" y="5694363"/>
          <p14:tracePt t="15621" x="7443788" y="5697538"/>
          <p14:tracePt t="15628" x="7443788" y="5707063"/>
          <p14:tracePt t="15636" x="7443788" y="5716588"/>
          <p14:tracePt t="15644" x="7443788" y="5721350"/>
          <p14:tracePt t="15647" x="7443788" y="5738813"/>
          <p14:tracePt t="15658" x="7443788" y="5757863"/>
          <p14:tracePt t="15664" x="7443788" y="5767388"/>
          <p14:tracePt t="15674" x="7443788" y="5799138"/>
          <p14:tracePt t="15686" x="7443788" y="5816600"/>
          <p14:tracePt t="15690" x="7443788" y="5826125"/>
          <p14:tracePt t="15704" x="7443788" y="5853113"/>
          <p14:tracePt t="15710" x="7443788" y="5857875"/>
          <p14:tracePt t="15713" x="7443788" y="5876925"/>
          <p14:tracePt t="15724" x="7443788" y="5894388"/>
          <p14:tracePt t="15737" x="7446963" y="5913438"/>
          <p14:tracePt t="15745" x="7456488" y="5921375"/>
          <p14:tracePt t="15756" x="7456488" y="5935663"/>
          <p14:tracePt t="15764" x="7475538" y="5957888"/>
          <p14:tracePt t="15774" x="7483475" y="5976938"/>
          <p14:tracePt t="15784" x="7493000" y="5981700"/>
          <p14:tracePt t="15797" x="7512050" y="5999163"/>
          <p14:tracePt t="15808" x="7529513" y="6022975"/>
          <p14:tracePt t="15821" x="7548563" y="6035675"/>
          <p14:tracePt t="15827" x="7556500" y="6054725"/>
          <p14:tracePt t="15838" x="7597775" y="6064250"/>
          <p14:tracePt t="15846" x="7602538" y="6072188"/>
          <p14:tracePt t="15857" x="7621588" y="6081713"/>
          <p14:tracePt t="15877" x="7639050" y="6081713"/>
          <p14:tracePt t="15879" x="7658100" y="6091238"/>
          <p14:tracePt t="15891" x="7675563" y="6091238"/>
          <p14:tracePt t="15904" x="7707313" y="6100763"/>
          <p14:tracePt t="15920" x="7712075" y="6100763"/>
          <p14:tracePt t="15926" x="7740650" y="6100763"/>
          <p14:tracePt t="15936" x="7758113" y="6100763"/>
          <p14:tracePt t="15942" x="7767638" y="6108700"/>
          <p14:tracePt t="15952" x="7772400" y="6108700"/>
          <p14:tracePt t="15957" x="7789863" y="6108700"/>
          <p14:tracePt t="15973" x="7799388" y="6108700"/>
          <p14:tracePt t="15985" x="7804150" y="6113463"/>
          <p14:tracePt t="15993" x="7813675" y="6113463"/>
          <p14:tracePt t="16009" x="7821613" y="6132513"/>
          <p14:tracePt t="16012" x="7831138" y="6132513"/>
          <p14:tracePt t="16023" x="7835900" y="6132513"/>
          <p14:tracePt t="16040" x="7845425" y="6140450"/>
          <p14:tracePt t="16054" x="7853363" y="6140450"/>
          <p14:tracePt t="16062" x="7867650" y="6140450"/>
          <p14:tracePt t="16089" x="7877175" y="6140450"/>
          <p14:tracePt t="16103" x="7894638" y="6140450"/>
          <p14:tracePt t="16132" x="7913688" y="6140450"/>
          <p14:tracePt t="16144" x="7918450" y="6145213"/>
          <p14:tracePt t="16149" x="7926388" y="6145213"/>
          <p14:tracePt t="16159" x="7945438" y="6145213"/>
          <p14:tracePt t="16171" x="7959725" y="6145213"/>
          <p14:tracePt t="16174" x="7967663" y="6145213"/>
          <p14:tracePt t="16189" x="7996238" y="6145213"/>
          <p14:tracePt t="16198" x="8027988" y="6145213"/>
          <p14:tracePt t="16208" x="8086725" y="6169025"/>
          <p14:tracePt t="16214" x="8096250" y="6169025"/>
          <p14:tracePt t="16224" x="8123238" y="6169025"/>
          <p14:tracePt t="16228" x="8128000" y="6169025"/>
          <p14:tracePt t="16239" x="8178800" y="6169025"/>
          <p14:tracePt t="16248" x="8196263" y="6169025"/>
          <p14:tracePt t="16254" x="8210550" y="6169025"/>
          <p14:tracePt t="16264" x="8242300" y="6169025"/>
          <p14:tracePt t="16274" x="8251825" y="6169025"/>
          <p14:tracePt t="16280" x="8274050" y="6169025"/>
          <p14:tracePt t="16291" x="8305800" y="6164263"/>
          <p14:tracePt t="16294" x="8315325" y="6164263"/>
          <p14:tracePt t="16306" x="8361363" y="6154738"/>
          <p14:tracePt t="16314" x="8378825" y="6154738"/>
          <p14:tracePt t="16322" x="8397875" y="6137275"/>
          <p14:tracePt t="16330" x="8420100" y="6127750"/>
          <p14:tracePt t="16341" x="8439150" y="6118225"/>
          <p14:tracePt t="16344" x="8442325" y="6118225"/>
          <p14:tracePt t="16360" x="8451850" y="6108700"/>
          <p14:tracePt t="16387" x="8461375" y="6100763"/>
          <p14:tracePt t="16693" x="8466138" y="6096000"/>
          <p14:tracePt t="16746" x="8483600" y="6086475"/>
          <p14:tracePt t="16774" x="8483600" y="6076950"/>
          <p14:tracePt t="16804" x="8483600" y="6059488"/>
          <p14:tracePt t="16860" x="8470900" y="6040438"/>
          <p14:tracePt t="16880" x="8461375" y="6030913"/>
          <p14:tracePt t="16887" x="8456613" y="6027738"/>
          <p14:tracePt t="16894" x="8447088" y="6027738"/>
          <p14:tracePt t="16908" x="8429625" y="6018213"/>
          <p14:tracePt t="16910" x="8420100" y="6018213"/>
          <p14:tracePt t="16914" x="8405813" y="6008688"/>
          <p14:tracePt t="16925" x="8388350" y="6008688"/>
          <p14:tracePt t="16938" x="8369300" y="6008688"/>
          <p14:tracePt t="16941" x="8342313" y="6008688"/>
          <p14:tracePt t="16954" x="8301038" y="6008688"/>
          <p14:tracePt t="16956" x="8293100" y="6008688"/>
          <p14:tracePt t="16967" x="8220075" y="6008688"/>
          <p14:tracePt t="16976" x="8159750" y="6008688"/>
          <p14:tracePt t="16980" x="8132763" y="6008688"/>
          <p14:tracePt t="16990" x="8018463" y="6008688"/>
          <p14:tracePt t="16997" x="7999413" y="6008688"/>
          <p14:tracePt t="17008" x="7858125" y="6008688"/>
          <p14:tracePt t="17021" x="7743825" y="6008688"/>
          <p14:tracePt t="17030" x="7670800" y="6018213"/>
          <p14:tracePt t="17037" x="7643813" y="6018213"/>
          <p14:tracePt t="17046" x="7585075" y="6027738"/>
          <p14:tracePt t="17057" x="7543800" y="6027738"/>
          <p14:tracePt t="17062" x="7539038" y="6027738"/>
          <p14:tracePt t="17073" x="7502525" y="6035675"/>
          <p14:tracePt t="17077" x="7493000" y="6035675"/>
          <p14:tracePt t="17086" x="7456488" y="6035675"/>
          <p14:tracePt t="17096" x="7429500" y="6035675"/>
          <p14:tracePt t="17103" x="7410450" y="6045200"/>
          <p14:tracePt t="17112" x="7356475" y="6045200"/>
          <p14:tracePt t="17120" x="7346950" y="6045200"/>
          <p14:tracePt t="17127" x="7296150" y="6045200"/>
          <p14:tracePt t="17137" x="7269163" y="6045200"/>
          <p14:tracePt t="17143" x="7242175" y="6045200"/>
          <p14:tracePt t="17155" x="7186613" y="6045200"/>
          <p14:tracePt t="17157" x="7169150" y="6045200"/>
          <p14:tracePt t="17169" x="7113588" y="6045200"/>
          <p14:tracePt t="17178" x="7054850" y="6045200"/>
          <p14:tracePt t="17182" x="7050088" y="6045200"/>
          <p14:tracePt t="17192" x="7023100" y="6045200"/>
          <p14:tracePt t="17198" x="7013575" y="6045200"/>
          <p14:tracePt t="17208" x="6991350" y="6045200"/>
          <p14:tracePt t="17220" x="6972300" y="6045200"/>
          <p14:tracePt t="17223" x="6964363" y="6045200"/>
          <p14:tracePt t="17232" x="6954838" y="6045200"/>
          <p14:tracePt t="17239" x="6950075" y="6045200"/>
          <p14:tracePt t="17249" x="6931025" y="6045200"/>
          <p14:tracePt t="17262" x="6913563" y="6045200"/>
          <p14:tracePt t="17273" x="6872288" y="6045200"/>
          <p14:tracePt t="17278" x="6862763" y="6045200"/>
          <p14:tracePt t="17289" x="6816725" y="6045200"/>
          <p14:tracePt t="17299" x="6808788" y="6045200"/>
          <p14:tracePt t="17307" x="6784975" y="6045200"/>
          <p14:tracePt t="17314" x="6711950" y="6067425"/>
          <p14:tracePt t="17321" x="6704013" y="6067425"/>
          <p14:tracePt t="17328" x="6657975" y="6067425"/>
          <p14:tracePt t="17338" x="6638925" y="6067425"/>
          <p14:tracePt t="17344" x="6630988" y="6067425"/>
          <p14:tracePt t="17355" x="6584950" y="6067425"/>
          <p14:tracePt t="17358" x="6565900" y="6067425"/>
          <p14:tracePt t="17371" x="6534150" y="6067425"/>
          <p14:tracePt t="17378" x="6507163" y="6067425"/>
          <p14:tracePt t="17387" x="6488113" y="6067425"/>
          <p14:tracePt t="17395" x="6446838" y="6081713"/>
          <p14:tracePt t="17399" x="6438900" y="6081713"/>
          <p14:tracePt t="17410" x="6378575" y="6081713"/>
          <p14:tracePt t="17421" x="6370638" y="6086475"/>
          <p14:tracePt t="17425" x="6356350" y="6086475"/>
          <p14:tracePt t="17434" x="6324600" y="6086475"/>
          <p14:tracePt t="17440" x="6315075" y="6086475"/>
          <p14:tracePt t="17455" x="6278563" y="6096000"/>
          <p14:tracePt t="17460" x="6251575" y="6096000"/>
          <p14:tracePt t="17464" x="6232525" y="6096000"/>
          <p14:tracePt t="17474" x="6191250" y="6096000"/>
          <p14:tracePt t="17480" x="6183313" y="6096000"/>
          <p14:tracePt t="17491" x="6137275" y="6096000"/>
          <p14:tracePt t="17505" x="6076950" y="6096000"/>
          <p14:tracePt t="17514" x="6037263" y="6096000"/>
          <p14:tracePt t="17521" x="6018213" y="6096000"/>
          <p14:tracePt t="17530" x="5976938" y="6096000"/>
          <p14:tracePt t="17541" x="5949950" y="6096000"/>
          <p14:tracePt t="17546" x="5930900" y="6096000"/>
          <p14:tracePt t="17557" x="5876925" y="6096000"/>
          <p14:tracePt t="17560" x="5857875" y="6096000"/>
          <p14:tracePt t="17571" x="5818188" y="6096000"/>
          <p14:tracePt t="17580" x="5789613" y="6096000"/>
          <p14:tracePt t="17587" x="5748338" y="6096000"/>
          <p14:tracePt t="17596" x="5680075" y="6096000"/>
          <p14:tracePt t="17604" x="5648325" y="6096000"/>
          <p14:tracePt t="17610" x="5594350" y="6096000"/>
          <p14:tracePt t="17622" x="5565775" y="6096000"/>
          <p14:tracePt t="17626" x="5548313" y="6096000"/>
          <p14:tracePt t="17638" x="5521325" y="6096000"/>
          <p14:tracePt t="17646" x="5502275" y="6096000"/>
          <p14:tracePt t="17653" x="5484813" y="6096000"/>
          <p14:tracePt t="17662" x="5465763" y="6096000"/>
          <p14:tracePt t="17669" x="5448300" y="6091238"/>
          <p14:tracePt t="17676" x="5407025" y="6072188"/>
          <p14:tracePt t="17682" x="5397500" y="6072188"/>
          <p14:tracePt t="17692" x="5370513" y="6072188"/>
          <p14:tracePt t="17706" x="5341938" y="6072188"/>
          <p14:tracePt t="17707" x="5334000" y="6064250"/>
          <p14:tracePt t="17719" x="5314950" y="6054725"/>
          <p14:tracePt t="17722" x="5297488" y="6045200"/>
          <p14:tracePt t="17733" x="5292725" y="6045200"/>
          <p14:tracePt t="17742" x="5251450" y="6027738"/>
          <p14:tracePt t="17746" x="5241925" y="6018213"/>
          <p14:tracePt t="17758" x="5237163" y="6008688"/>
          <p14:tracePt t="17762" x="5219700" y="5991225"/>
          <p14:tracePt t="17772" x="5210175" y="5986463"/>
          <p14:tracePt t="17782" x="5191125" y="5967413"/>
          <p14:tracePt t="17790" x="5187950" y="5957888"/>
          <p14:tracePt t="17799" x="5178425" y="5957888"/>
          <p14:tracePt t="17806" x="5159375" y="5949950"/>
          <p14:tracePt t="17812" x="5151438" y="5945188"/>
          <p14:tracePt t="17878" x="5146675" y="5945188"/>
          <p14:tracePt t="18582" x="5137150" y="5945188"/>
          <p14:tracePt t="19930" x="5137150" y="5918200"/>
          <p14:tracePt t="19957" x="5137150" y="5908675"/>
          <p14:tracePt t="19973" x="5137150" y="5899150"/>
          <p14:tracePt t="19982" x="5137150" y="5894388"/>
          <p14:tracePt t="20036" x="5137150" y="5884863"/>
          <p14:tracePt t="20137" x="5137150" y="5867400"/>
          <p14:tracePt t="20142" x="5137150" y="5862638"/>
          <p14:tracePt t="20152" x="5137150" y="5843588"/>
          <p14:tracePt t="20158" x="5137150" y="5835650"/>
          <p14:tracePt t="20170" x="5137150" y="5830888"/>
          <p14:tracePt t="20174" x="5137150" y="5811838"/>
          <p14:tracePt t="20189" x="5137150" y="5789613"/>
          <p14:tracePt t="20198" x="5137150" y="5762625"/>
          <p14:tracePt t="20208" x="5137150" y="5753100"/>
          <p14:tracePt t="20214" x="5137150" y="5743575"/>
          <p14:tracePt t="20228" x="5137150" y="5738813"/>
          <p14:tracePt t="20238" x="5137150" y="5730875"/>
          <p14:tracePt t="20248" x="5137150" y="5721350"/>
          <p14:tracePt t="20265" x="5137150" y="5716588"/>
          <p14:tracePt t="20272" x="5137150" y="5697538"/>
          <p14:tracePt t="20278" x="5137150" y="5689600"/>
          <p14:tracePt t="20291" x="5137150" y="5675313"/>
          <p14:tracePt t="20304" x="5137150" y="5648325"/>
          <p14:tracePt t="20314" x="5137150" y="5638800"/>
          <p14:tracePt t="20320" x="5137150" y="5624513"/>
          <p14:tracePt t="20330" x="5137150" y="5607050"/>
          <p14:tracePt t="20336" x="5137150" y="5597525"/>
          <p14:tracePt t="20344" x="5137150" y="5570538"/>
          <p14:tracePt t="20352" x="5137150" y="5565775"/>
          <p14:tracePt t="20360" x="5137150" y="5514975"/>
          <p14:tracePt t="20371" x="5137150" y="5487988"/>
          <p14:tracePt t="20374" x="5137150" y="5478463"/>
          <p14:tracePt t="20387" x="5137150" y="5419725"/>
          <p14:tracePt t="20390" x="5137150" y="5402263"/>
          <p14:tracePt t="20404" x="5137150" y="5346700"/>
          <p14:tracePt t="20409" x="5137150" y="5305425"/>
          <p14:tracePt t="20420" x="5137150" y="5278438"/>
          <p14:tracePt t="20425" x="5137150" y="5205413"/>
          <p14:tracePt t="20429" x="5137150" y="5164138"/>
          <p14:tracePt t="20439" x="5137150" y="5054600"/>
          <p14:tracePt t="20454" x="5137150" y="5013325"/>
          <p14:tracePt t="20456" x="5137150" y="4972050"/>
          <p14:tracePt t="20470" x="5137150" y="4857750"/>
          <p14:tracePt t="20480" x="5137150" y="4816475"/>
          <p14:tracePt t="20490" x="5137150" y="4775200"/>
          <p14:tracePt t="20495" x="5137150" y="4757738"/>
          <p14:tracePt t="20506" x="5137150" y="4730750"/>
          <p14:tracePt t="20509" x="5137150" y="4689475"/>
          <p14:tracePt t="20523" x="5137150" y="4657725"/>
          <p14:tracePt t="20532" x="5137150" y="4589463"/>
          <p14:tracePt t="20536" x="5137150" y="4579938"/>
          <p14:tracePt t="20546" x="5137150" y="4519613"/>
          <p14:tracePt t="20554" x="5137150" y="4492625"/>
          <p14:tracePt t="20562" x="5137150" y="4378325"/>
          <p14:tracePt t="20573" x="5137150" y="4319588"/>
          <p14:tracePt t="20576" x="5137150" y="4314825"/>
          <p14:tracePt t="20591" x="5137150" y="4241800"/>
          <p14:tracePt t="20592" x="5137150" y="4183063"/>
          <p14:tracePt t="20603" x="5137150" y="4141788"/>
          <p14:tracePt t="20612" x="5137150" y="4100513"/>
          <p14:tracePt t="20620" x="5137150" y="4095750"/>
          <p14:tracePt t="20625" x="5137150" y="4068763"/>
          <p14:tracePt t="20641" x="5137150" y="4049713"/>
          <p14:tracePt t="20661" x="5137150" y="4022725"/>
          <p14:tracePt t="20677" x="5137150" y="4013200"/>
          <p14:tracePt t="20794" x="5137150" y="4017963"/>
          <p14:tracePt t="20797" x="5137150" y="4032250"/>
          <p14:tracePt t="20804" x="5137150" y="4073525"/>
          <p14:tracePt t="20813" x="5137150" y="4159250"/>
          <p14:tracePt t="20819" x="5137150" y="4173538"/>
          <p14:tracePt t="20827" x="5137150" y="4332288"/>
          <p14:tracePt t="20835" x="5137150" y="4360863"/>
          <p14:tracePt t="20844" x="5146675" y="4533900"/>
          <p14:tracePt t="20855" x="5173663" y="4665663"/>
          <p14:tracePt t="20858" x="5173663" y="4706938"/>
          <p14:tracePt t="20871" x="5237163" y="4962525"/>
          <p14:tracePt t="20876" x="5264150" y="5027613"/>
          <p14:tracePt t="20887" x="5334000" y="5268913"/>
          <p14:tracePt t="20894" x="5407025" y="5402263"/>
          <p14:tracePt t="20903" x="5419725" y="5446713"/>
          <p14:tracePt t="20911" x="5548313" y="5726113"/>
          <p14:tracePt t="20913" x="5557838" y="5743575"/>
          <p14:tracePt t="20924" x="5684838" y="5967413"/>
          <p14:tracePt t="20935" x="5726113" y="6049963"/>
          <p14:tracePt t="20940" x="5767388" y="6113463"/>
          <p14:tracePt t="20951" x="5854700" y="6249988"/>
          <p14:tracePt t="20955" x="5876925" y="6278563"/>
          <p14:tracePt t="20964" x="5927725" y="6369050"/>
          <p14:tracePt t="20974" x="5981700" y="6451600"/>
          <p14:tracePt t="20980" x="5991225" y="6456363"/>
          <p14:tracePt t="20990" x="6018213" y="6488113"/>
          <p14:tracePt t="20996" x="6027738" y="6507163"/>
          <p14:tracePt t="21007" x="6073775" y="6551613"/>
          <p14:tracePt t="21020" x="6081713" y="6556375"/>
          <p14:tracePt t="21026" x="6086475" y="6565900"/>
          <p14:tracePt t="21037" x="6096000" y="6565900"/>
          <p14:tracePt t="21046" x="6105525" y="6575425"/>
          <p14:tracePt t="21090" x="6115050" y="6575425"/>
          <p14:tracePt t="21096" x="6118225" y="6575425"/>
          <p14:tracePt t="21116" x="6127750" y="6575425"/>
          <p14:tracePt t="21126" x="6137275" y="6575425"/>
          <p14:tracePt t="21137" x="6142038" y="6575425"/>
          <p14:tracePt t="21146" x="6151563" y="6575425"/>
          <p14:tracePt t="21157" x="6159500" y="6575425"/>
          <p14:tracePt t="21166" x="6178550" y="6570663"/>
          <p14:tracePt t="21176" x="6188075" y="6538913"/>
          <p14:tracePt t="21187" x="6196013" y="6519863"/>
          <p14:tracePt t="21192" x="6196013" y="6502400"/>
          <p14:tracePt t="21196" x="6215063" y="6492875"/>
          <p14:tracePt t="21207" x="6237288" y="6437313"/>
          <p14:tracePt t="21221" x="6237288" y="6419850"/>
          <p14:tracePt t="21228" x="6256338" y="6388100"/>
          <p14:tracePt t="21239" x="6264275" y="6378575"/>
          <p14:tracePt t="21249" x="6283325" y="6342063"/>
          <p14:tracePt t="21259" x="6292850" y="6323013"/>
          <p14:tracePt t="21262" x="6292850" y="6296025"/>
          <p14:tracePt t="21273" x="6305550" y="6249988"/>
          <p14:tracePt t="21278" x="6305550" y="6246813"/>
          <p14:tracePt t="21288" x="6305550" y="6181725"/>
          <p14:tracePt t="21299" x="6315075" y="6154738"/>
          <p14:tracePt t="21305" x="6315075" y="6145213"/>
          <p14:tracePt t="21312" x="6324600" y="6118225"/>
          <p14:tracePt t="21318" x="6324600" y="6100763"/>
          <p14:tracePt t="21328" x="6334125" y="6081713"/>
          <p14:tracePt t="21338" x="6334125" y="6064250"/>
          <p14:tracePt t="21344" x="6334125" y="6059488"/>
          <p14:tracePt t="21355" x="6334125" y="6022975"/>
          <p14:tracePt t="21358" x="6334125" y="6013450"/>
          <p14:tracePt t="21371" x="6334125" y="5999163"/>
          <p14:tracePt t="21378" x="6334125" y="5981700"/>
          <p14:tracePt t="21387" x="6334125" y="5972175"/>
          <p14:tracePt t="21394" x="6342063" y="5945188"/>
          <p14:tracePt t="21399" x="6342063" y="5935663"/>
          <p14:tracePt t="21408" x="6342063" y="5921375"/>
          <p14:tracePt t="21428" x="6342063" y="5913438"/>
          <p14:tracePt t="21544" x="6342063" y="5918200"/>
          <p14:tracePt t="21550" x="6342063" y="5926138"/>
          <p14:tracePt t="21556" x="6342063" y="5949950"/>
          <p14:tracePt t="21572" x="6342063" y="5986463"/>
          <p14:tracePt t="21580" x="6342063" y="6027738"/>
          <p14:tracePt t="21588" x="6342063" y="6035675"/>
          <p14:tracePt t="21596" x="6351588" y="6064250"/>
          <p14:tracePt t="21605" x="6351588" y="6067425"/>
          <p14:tracePt t="21610" x="6351588" y="6103938"/>
          <p14:tracePt t="21621" x="6351588" y="6122988"/>
          <p14:tracePt t="21626" x="6361113" y="6140450"/>
          <p14:tracePt t="21638" x="6361113" y="6159500"/>
          <p14:tracePt t="21641" x="6361113" y="6169025"/>
          <p14:tracePt t="21653" x="6361113" y="6191250"/>
          <p14:tracePt t="21753" x="6378575" y="6200775"/>
          <p14:tracePt t="21777" x="6388100" y="6200775"/>
          <p14:tracePt t="21785" x="6392863" y="6200775"/>
          <p14:tracePt t="21798" x="6392863" y="6181725"/>
          <p14:tracePt t="21810" x="6392863" y="6173788"/>
          <p14:tracePt t="21813" x="6392863" y="6169025"/>
          <p14:tracePt t="21826" x="6392863" y="6159500"/>
          <p14:tracePt t="21838" x="6392863" y="6149975"/>
          <p14:tracePt t="21842" x="6392863" y="6145213"/>
          <p14:tracePt t="21916" x="6392863" y="6137275"/>
          <p14:tracePt t="21934" x="6392863" y="6118225"/>
          <p14:tracePt t="21946" x="6392863" y="6113463"/>
          <p14:tracePt t="21957" x="6392863" y="6103938"/>
          <p14:tracePt t="21960" x="6392863" y="6096000"/>
          <p14:tracePt t="21970" x="6392863" y="6086475"/>
          <p14:tracePt t="21982" x="6392863" y="6081713"/>
          <p14:tracePt t="21985" x="6392863" y="6072188"/>
          <p14:tracePt t="21995" x="6392863" y="6064250"/>
          <p14:tracePt t="21999" x="6392863" y="6049963"/>
          <p14:tracePt t="22009" x="6392863" y="6040438"/>
          <p14:tracePt t="22014" x="6383338" y="6030913"/>
          <p14:tracePt t="22025" x="6383338" y="6022975"/>
          <p14:tracePt t="22034" x="6383338" y="6008688"/>
          <p14:tracePt t="22042" x="6373813" y="5999163"/>
          <p14:tracePt t="22057" x="6373813" y="5972175"/>
          <p14:tracePt t="22072" x="6373813" y="5967413"/>
          <p14:tracePt t="22081" x="6373813" y="5949950"/>
          <p14:tracePt t="22095" x="6373813" y="5930900"/>
          <p14:tracePt t="22105" x="6365875" y="5913438"/>
          <p14:tracePt t="22114" x="6365875" y="5884863"/>
          <p14:tracePt t="22129" x="6365875" y="5867400"/>
          <p14:tracePt t="22140" x="6365875" y="5857875"/>
          <p14:tracePt t="22158" x="6365875" y="5848350"/>
          <p14:tracePt t="22161" x="6365875" y="5843588"/>
          <p14:tracePt t="22174" x="6356350" y="5835650"/>
          <p14:tracePt t="22193" x="6356350" y="5816600"/>
          <p14:tracePt t="22205" x="6346825" y="5811838"/>
          <p14:tracePt t="22206" x="6346825" y="5803900"/>
          <p14:tracePt t="22225" x="6346825" y="5794375"/>
          <p14:tracePt t="22236" x="6346825" y="5784850"/>
          <p14:tracePt t="22239" x="6346825" y="5780088"/>
          <p14:tracePt t="22257" x="6346825" y="5770563"/>
          <p14:tracePt t="22273" x="6337300" y="5734050"/>
          <p14:tracePt t="22297" x="6334125" y="5726113"/>
          <p14:tracePt t="22313" x="6324600" y="5721350"/>
          <p14:tracePt t="23043" x="6324600" y="5684838"/>
          <p14:tracePt t="23050" x="6324600" y="5665788"/>
          <p14:tracePt t="23052" x="6324600" y="5634038"/>
          <p14:tracePt t="23065" x="6346825" y="5507038"/>
          <p14:tracePt t="23072" x="6346825" y="5451475"/>
          <p14:tracePt t="23079" x="6407150" y="5283200"/>
          <p14:tracePt t="23088" x="6451600" y="5132388"/>
          <p14:tracePt t="23094" x="6465888" y="5054600"/>
          <p14:tracePt t="23109" x="6616700" y="4524375"/>
          <p14:tracePt t="23122" x="6808788" y="4032250"/>
          <p14:tracePt t="23128" x="7032625" y="3533775"/>
          <p14:tracePt t="23139" x="7110413" y="3378200"/>
          <p14:tracePt t="23144" x="7519988" y="2762250"/>
          <p14:tracePt t="23148" x="7612063" y="2630488"/>
          <p14:tracePt t="23157" x="8123238" y="2251075"/>
          <p14:tracePt t="23169" x="8488363" y="2017713"/>
          <p14:tracePt t="23174" x="8589963" y="1963738"/>
          <p14:tracePt t="23186" x="9191625" y="1716088"/>
          <p14:tracePt t="23190" x="9324975" y="1676400"/>
          <p14:tracePt t="23203" x="9977438" y="1493838"/>
          <p14:tracePt t="23210" x="10420350" y="1379538"/>
          <p14:tracePt t="23214" x="10571163" y="1346200"/>
          <p14:tracePt t="23224" x="11133138" y="1236663"/>
          <p14:tracePt t="23230" x="11260138" y="1223963"/>
          <p14:tracePt t="23240" x="11766550" y="1141413"/>
          <p14:tracePt t="23254" x="12104688" y="1104900"/>
        </p14:tracePtLst>
      </p14:laserTraceLst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6E99F26-5CAE-427D-B05C-B52722F3F36D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D1S1656 weights from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ort</a:t>
            </a:r>
            <a:endParaRPr lang="en-US" sz="28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80157E-FEBF-4A59-B9DE-C9C10A6294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431"/>
          <a:stretch/>
        </p:blipFill>
        <p:spPr>
          <a:xfrm>
            <a:off x="8049379" y="1006331"/>
            <a:ext cx="3460850" cy="40033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1153539-C49A-4623-B40F-B265FD7813C8}"/>
              </a:ext>
            </a:extLst>
          </p:cNvPr>
          <p:cNvSpPr txBox="1"/>
          <p:nvPr/>
        </p:nvSpPr>
        <p:spPr>
          <a:xfrm>
            <a:off x="6647972" y="5764058"/>
            <a:ext cx="4532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,14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epted f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low weight</a:t>
            </a: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F10873C6-AD1D-4A88-9788-17A62AE88E16}"/>
              </a:ext>
            </a:extLst>
          </p:cNvPr>
          <p:cNvSpPr/>
          <p:nvPr/>
        </p:nvSpPr>
        <p:spPr>
          <a:xfrm>
            <a:off x="7513144" y="877455"/>
            <a:ext cx="4439600" cy="4118885"/>
          </a:xfrm>
          <a:prstGeom prst="roundRect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72DCF4-4E68-4CFF-9552-72D36CF7FA59}"/>
              </a:ext>
            </a:extLst>
          </p:cNvPr>
          <p:cNvSpPr txBox="1"/>
          <p:nvPr/>
        </p:nvSpPr>
        <p:spPr>
          <a:xfrm>
            <a:off x="7899224" y="1733225"/>
            <a:ext cx="2030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(major): 12,15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 (minor): </a:t>
            </a:r>
            <a:r>
              <a:rPr lang="en-US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14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E8E51EF-9FB9-42BA-8605-E42CFC6DD8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943" y="792988"/>
            <a:ext cx="6400800" cy="79291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43C438A-785B-4C49-BE3A-D18B90ABCD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9256" y="1585902"/>
            <a:ext cx="6205179" cy="373038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FA2017C-2EC6-4000-B854-287CEF3C110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3883"/>
          <a:stretch/>
        </p:blipFill>
        <p:spPr>
          <a:xfrm>
            <a:off x="293845" y="5316288"/>
            <a:ext cx="6035040" cy="933917"/>
          </a:xfrm>
          <a:prstGeom prst="rect">
            <a:avLst/>
          </a:prstGeom>
        </p:spPr>
      </p:pic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AD175D8D-0372-4E55-BD52-43074B02339B}"/>
              </a:ext>
            </a:extLst>
          </p:cNvPr>
          <p:cNvSpPr/>
          <p:nvPr/>
        </p:nvSpPr>
        <p:spPr>
          <a:xfrm>
            <a:off x="1825666" y="5803566"/>
            <a:ext cx="4480560" cy="274320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633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7242"/>
    </mc:Choice>
    <mc:Fallback xmlns="">
      <p:transition spd="slow" advTm="67242"/>
    </mc:Fallback>
  </mc:AlternateContent>
  <p:extLst>
    <p:ext uri="{3A86A75C-4F4B-4683-9AE1-C65F6400EC91}">
      <p14:laserTraceLst xmlns:p14="http://schemas.microsoft.com/office/powerpoint/2010/main">
        <p14:tracePtLst>
          <p14:tracePt t="2606" x="12123738" y="2520950"/>
          <p14:tracePt t="2617" x="12023725" y="2565400"/>
          <p14:tracePt t="2621" x="11968163" y="2565400"/>
          <p14:tracePt t="2632" x="11707813" y="2598738"/>
          <p14:tracePt t="2642" x="11593513" y="2630488"/>
          <p14:tracePt t="2646" x="11534775" y="2638425"/>
          <p14:tracePt t="2657" x="11260138" y="2747963"/>
          <p14:tracePt t="2662" x="11218863" y="2762250"/>
          <p14:tracePt t="2673" x="11004550" y="2808288"/>
          <p14:tracePt t="2682" x="10941050" y="2849563"/>
          <p14:tracePt t="2687" x="10868025" y="2862263"/>
          <p14:tracePt t="2696" x="10717213" y="2903538"/>
          <p14:tracePt t="2702" x="10707688" y="2903538"/>
          <p14:tracePt t="2712" x="10629900" y="2940050"/>
          <p14:tracePt t="2723" x="10602913" y="2940050"/>
          <p14:tracePt t="2726" x="10593388" y="2959100"/>
          <p14:tracePt t="2738" x="10561638" y="2976563"/>
          <p14:tracePt t="2742" x="10556875" y="2976563"/>
          <p14:tracePt t="2753" x="10502900" y="3017838"/>
          <p14:tracePt t="2762" x="10471150" y="3049588"/>
          <p14:tracePt t="2768" x="10461625" y="3059113"/>
          <p14:tracePt t="2779" x="10434638" y="3086100"/>
          <p14:tracePt t="2782" x="10429875" y="3095625"/>
          <p14:tracePt t="2792" x="10398125" y="3132138"/>
          <p14:tracePt t="2802" x="10379075" y="3154363"/>
          <p14:tracePt t="2809" x="10369550" y="3159125"/>
          <p14:tracePt t="2818" x="10320338" y="3200400"/>
          <p14:tracePt t="2823" x="10310813" y="3200400"/>
          <p14:tracePt t="2832" x="10269538" y="3255963"/>
          <p14:tracePt t="2843" x="10260013" y="3273425"/>
          <p14:tracePt t="2848" x="10242550" y="3292475"/>
          <p14:tracePt t="2859" x="10228263" y="3351213"/>
          <p14:tracePt t="2864" x="10228263" y="3355975"/>
          <p14:tracePt t="2875" x="10210800" y="3406775"/>
          <p14:tracePt t="2885" x="10210800" y="3438525"/>
          <p14:tracePt t="2889" x="10201275" y="3448050"/>
          <p14:tracePt t="2898" x="10179050" y="3506788"/>
          <p14:tracePt t="2905" x="10179050" y="3516313"/>
          <p14:tracePt t="2914" x="10179050" y="3533775"/>
          <p14:tracePt t="2925" x="10169525" y="3560763"/>
          <p14:tracePt t="2928" x="10169525" y="3594100"/>
          <p14:tracePt t="2939" x="10150475" y="3611563"/>
          <p14:tracePt t="2944" x="10150475" y="3630613"/>
          <p14:tracePt t="2956" x="10150475" y="3684588"/>
          <p14:tracePt t="2964" x="10150475" y="3703638"/>
          <p14:tracePt t="2968" x="10150475" y="3706813"/>
          <p14:tracePt t="2981" x="10150475" y="3757613"/>
          <p14:tracePt t="2985" x="10150475" y="3762375"/>
          <p14:tracePt t="2994" x="10150475" y="3789363"/>
          <p14:tracePt t="3005" x="10150475" y="3798888"/>
          <p14:tracePt t="3010" x="10150475" y="3808413"/>
          <p14:tracePt t="3021" x="10140950" y="3813175"/>
          <p14:tracePt t="3024" x="10140950" y="3840163"/>
          <p14:tracePt t="3035" x="10140950" y="3849688"/>
          <p14:tracePt t="3044" x="10133013" y="3852863"/>
          <p14:tracePt t="3051" x="10128250" y="3862388"/>
          <p14:tracePt t="3060" x="10128250" y="3871913"/>
          <p14:tracePt t="3065" x="10118725" y="3881438"/>
          <p14:tracePt t="3080" x="10118725" y="3886200"/>
          <p14:tracePt t="3091" x="10118725" y="3903663"/>
          <p14:tracePt t="3101" x="10109200" y="3913188"/>
          <p14:tracePt t="3110" x="10109200" y="3917950"/>
          <p14:tracePt t="3118" x="10104438" y="3927475"/>
          <p14:tracePt t="3131" x="10096500" y="3935413"/>
          <p14:tracePt t="3141" x="10096500" y="3940175"/>
          <p14:tracePt t="3147" x="10096500" y="3949700"/>
          <p14:tracePt t="3157" x="10086975" y="3959225"/>
          <p14:tracePt t="3168" x="10077450" y="3976688"/>
          <p14:tracePt t="3171" x="10077450" y="3981450"/>
          <p14:tracePt t="3180" x="10072688" y="3990975"/>
          <p14:tracePt t="3191" x="10072688" y="4000500"/>
          <p14:tracePt t="3200" x="10072688" y="4003675"/>
          <p14:tracePt t="3217" x="10064750" y="4013200"/>
          <p14:tracePt t="3227" x="10064750" y="4022725"/>
          <p14:tracePt t="3237" x="10055225" y="4032250"/>
          <p14:tracePt t="3246" x="10045700" y="4044950"/>
          <p14:tracePt t="3257" x="10036175" y="4064000"/>
          <p14:tracePt t="3268" x="10036175" y="4081463"/>
          <p14:tracePt t="3278" x="10009188" y="4105275"/>
          <p14:tracePt t="3288" x="10009188" y="4132263"/>
          <p14:tracePt t="3296" x="10009188" y="4149725"/>
          <p14:tracePt t="3303" x="9999663" y="4159250"/>
          <p14:tracePt t="3312" x="9991725" y="4164013"/>
          <p14:tracePt t="3317" x="9982200" y="4173538"/>
          <p14:tracePt t="3433" x="9977438" y="4183063"/>
          <p14:tracePt t="3456" x="9967913" y="4191000"/>
          <p14:tracePt t="3465" x="9958388" y="4205288"/>
          <p14:tracePt t="3469" x="9950450" y="4214813"/>
          <p14:tracePt t="3479" x="9945688" y="4222750"/>
          <p14:tracePt t="3686" x="9936163" y="4222750"/>
          <p14:tracePt t="3708" x="9918700" y="4222750"/>
          <p14:tracePt t="3721" x="9890125" y="4222750"/>
          <p14:tracePt t="3731" x="9858375" y="4195763"/>
          <p14:tracePt t="3737" x="9848850" y="4195763"/>
          <p14:tracePt t="3747" x="9821863" y="4168775"/>
          <p14:tracePt t="3760" x="9790113" y="4137025"/>
          <p14:tracePt t="3777" x="9772650" y="4117975"/>
          <p14:tracePt t="3787" x="9753600" y="4105275"/>
          <p14:tracePt t="3793" x="9744075" y="4100513"/>
          <p14:tracePt t="3803" x="9739313" y="4090988"/>
          <p14:tracePt t="3823" x="9731375" y="4081463"/>
          <p14:tracePt t="3826" x="9731375" y="4076700"/>
          <p14:tracePt t="3832" x="9731375" y="4059238"/>
          <p14:tracePt t="3842" x="9698038" y="4013200"/>
          <p14:tracePt t="3853" x="9685338" y="3971925"/>
          <p14:tracePt t="3856" x="9685338" y="3940175"/>
          <p14:tracePt t="3866" x="9661525" y="3857625"/>
          <p14:tracePt t="3872" x="9661525" y="3816350"/>
          <p14:tracePt t="3884" x="9648825" y="3698875"/>
          <p14:tracePt t="3894" x="9648825" y="3606800"/>
          <p14:tracePt t="3900" x="9648825" y="3579813"/>
          <p14:tracePt t="3911" x="9648825" y="3479800"/>
          <p14:tracePt t="3914" x="9639300" y="3451225"/>
          <p14:tracePt t="3925" x="9639300" y="3336925"/>
          <p14:tracePt t="3935" x="9639300" y="3227388"/>
          <p14:tracePt t="3939" x="9639300" y="3168650"/>
          <p14:tracePt t="3949" x="9639300" y="2990850"/>
          <p14:tracePt t="3953" x="9639300" y="2913063"/>
          <p14:tracePt t="3962" x="9648825" y="2730500"/>
          <p14:tracePt t="3973" x="9680575" y="2601913"/>
          <p14:tracePt t="3978" x="9680575" y="2570163"/>
          <p14:tracePt t="3989" x="9717088" y="2455863"/>
          <p14:tracePt t="3991" x="9726613" y="2411413"/>
          <p14:tracePt t="4002" x="9758363" y="2265363"/>
          <p14:tracePt t="4013" x="9767888" y="2224088"/>
          <p14:tracePt t="4021" x="9767888" y="2192338"/>
          <p14:tracePt t="4030" x="9780588" y="2122488"/>
          <p14:tracePt t="4037" x="9780588" y="2090738"/>
          <p14:tracePt t="4046" x="9790113" y="2049463"/>
          <p14:tracePt t="4055" x="9799638" y="2022475"/>
          <p14:tracePt t="4077" x="9799638" y="1963738"/>
          <p14:tracePt t="4087" x="9799638" y="1944688"/>
          <p14:tracePt t="4095" x="9799638" y="1935163"/>
          <p14:tracePt t="4099" x="9799638" y="1922463"/>
          <p14:tracePt t="4108" x="9799638" y="1890713"/>
          <p14:tracePt t="4114" x="9799638" y="1881188"/>
          <p14:tracePt t="4124" x="9775825" y="1830388"/>
          <p14:tracePt t="4136" x="9753600" y="1789113"/>
          <p14:tracePt t="4141" x="9744075" y="1781175"/>
          <p14:tracePt t="4151" x="9702800" y="1725613"/>
          <p14:tracePt t="4156" x="9702800" y="1720850"/>
          <p14:tracePt t="4164" x="9685338" y="1671638"/>
          <p14:tracePt t="4174" x="9661525" y="1639888"/>
          <p14:tracePt t="4180" x="9644063" y="1620838"/>
          <p14:tracePt t="4190" x="9625013" y="1598613"/>
          <p14:tracePt t="4203" x="9617075" y="1593850"/>
          <p14:tracePt t="4212" x="9607550" y="1584325"/>
          <p14:tracePt t="4222" x="9602788" y="1566863"/>
          <p14:tracePt t="4423" x="9593263" y="1557338"/>
          <p14:tracePt t="4427" x="9585325" y="1552575"/>
          <p14:tracePt t="4433" x="9548813" y="1543050"/>
          <p14:tracePt t="4444" x="9529763" y="1533525"/>
          <p14:tracePt t="4447" x="9488488" y="1520825"/>
          <p14:tracePt t="4458" x="9393238" y="1493838"/>
          <p14:tracePt t="4462" x="9347200" y="1470025"/>
          <p14:tracePt t="4473" x="9215438" y="1443038"/>
          <p14:tracePt t="4478" x="9186863" y="1433513"/>
          <p14:tracePt t="4489" x="9072563" y="1433513"/>
          <p14:tracePt t="4498" x="8996363" y="1419225"/>
          <p14:tracePt t="4502" x="8963025" y="1419225"/>
          <p14:tracePt t="4512" x="8821738" y="1406525"/>
          <p14:tracePt t="4518" x="8789988" y="1397000"/>
          <p14:tracePt t="4528" x="8694738" y="1397000"/>
          <p14:tracePt t="4539" x="8634413" y="1397000"/>
          <p14:tracePt t="4542" x="8616950" y="1397000"/>
          <p14:tracePt t="4553" x="8561388" y="1397000"/>
          <p14:tracePt t="4558" x="8548688" y="1397000"/>
          <p14:tracePt t="4568" x="8475663" y="1397000"/>
          <p14:tracePt t="4578" x="8461375" y="1397000"/>
          <p14:tracePt t="4582" x="8429625" y="1397000"/>
          <p14:tracePt t="4595" x="8388350" y="1401763"/>
          <p14:tracePt t="4605" x="8356600" y="1411288"/>
          <p14:tracePt t="4608" x="8342313" y="1411288"/>
          <p14:tracePt t="4618" x="8310563" y="1433513"/>
          <p14:tracePt t="4624" x="8301038" y="1452563"/>
          <p14:tracePt t="4635" x="8256588" y="1484313"/>
          <p14:tracePt t="4644" x="8237538" y="1497013"/>
          <p14:tracePt t="4648" x="8220075" y="1506538"/>
          <p14:tracePt t="4659" x="8174038" y="1525588"/>
          <p14:tracePt t="4669" x="8154988" y="1557338"/>
          <p14:tracePt t="4675" x="8137525" y="1566863"/>
          <p14:tracePt t="4678" x="8113713" y="1574800"/>
          <p14:tracePt t="4689" x="8096250" y="1593850"/>
          <p14:tracePt t="4698" x="8077200" y="1606550"/>
          <p14:tracePt t="4706" x="8069263" y="1606550"/>
          <p14:tracePt t="4714" x="8032750" y="1616075"/>
          <p14:tracePt t="4721" x="8023225" y="1635125"/>
          <p14:tracePt t="4730" x="7996238" y="1652588"/>
          <p14:tracePt t="4744" x="7986713" y="1652588"/>
          <p14:tracePt t="4756" x="7967663" y="1671638"/>
          <p14:tracePt t="4760" x="7959725" y="1679575"/>
          <p14:tracePt t="4771" x="7945438" y="1689100"/>
          <p14:tracePt t="4780" x="7923213" y="1716088"/>
          <p14:tracePt t="4791" x="7904163" y="1739900"/>
          <p14:tracePt t="4794" x="7894638" y="1744663"/>
          <p14:tracePt t="4805" x="7877175" y="1752600"/>
          <p14:tracePt t="4810" x="7858125" y="1771650"/>
          <p14:tracePt t="4821" x="7840663" y="1803400"/>
          <p14:tracePt t="4830" x="7816850" y="1822450"/>
          <p14:tracePt t="4841" x="7808913" y="1839913"/>
          <p14:tracePt t="4851" x="7799388" y="1862138"/>
          <p14:tracePt t="4860" x="7789863" y="1866900"/>
          <p14:tracePt t="4872" x="7789863" y="1885950"/>
          <p14:tracePt t="4880" x="7789863" y="1895475"/>
          <p14:tracePt t="5022" x="7789863" y="1898650"/>
          <p14:tracePt t="5042" x="7789863" y="1908175"/>
          <p14:tracePt t="5053" x="7789863" y="1917700"/>
          <p14:tracePt t="5070" x="7789863" y="1922463"/>
          <p14:tracePt t="5078" x="7789863" y="1931988"/>
          <p14:tracePt t="5089" x="7789863" y="1939925"/>
          <p14:tracePt t="5099" x="7789863" y="1954213"/>
          <p14:tracePt t="5109" x="7789863" y="1963738"/>
          <p14:tracePt t="5118" x="7789863" y="1973263"/>
          <p14:tracePt t="5123" x="7794625" y="1981200"/>
          <p14:tracePt t="5155" x="7804150" y="1985963"/>
          <p14:tracePt t="5159" x="7813675" y="1995488"/>
          <p14:tracePt t="5175" x="7816850" y="1995488"/>
          <p14:tracePt t="5185" x="7826375" y="2005013"/>
          <p14:tracePt t="5194" x="7835900" y="2005013"/>
          <p14:tracePt t="5205" x="7840663" y="2005013"/>
          <p14:tracePt t="5255" x="7858125" y="2005013"/>
          <p14:tracePt t="5264" x="7867650" y="2005013"/>
          <p14:tracePt t="5268" x="7872413" y="2005013"/>
          <p14:tracePt t="5280" x="7881938" y="2005013"/>
          <p14:tracePt t="5291" x="7889875" y="2005013"/>
          <p14:tracePt t="5294" x="7899400" y="2005013"/>
          <p14:tracePt t="5305" x="7923213" y="2005013"/>
          <p14:tracePt t="5314" x="7931150" y="2005013"/>
          <p14:tracePt t="5322" x="7940675" y="2005013"/>
          <p14:tracePt t="5325" x="7945438" y="2005013"/>
          <p14:tracePt t="5335" x="7954963" y="2005013"/>
          <p14:tracePt t="5344" x="7962900" y="2005013"/>
          <p14:tracePt t="5352" x="7972425" y="2005013"/>
          <p14:tracePt t="5361" x="7977188" y="2005013"/>
          <p14:tracePt t="5364" x="7996238" y="2005013"/>
          <p14:tracePt t="5374" x="8004175" y="2005013"/>
          <p14:tracePt t="5385" x="8018463" y="2005013"/>
          <p14:tracePt t="5394" x="8027988" y="2005013"/>
          <p14:tracePt t="5407" x="8045450" y="2005013"/>
          <p14:tracePt t="5417" x="8050213" y="2005013"/>
          <p14:tracePt t="5426" x="8069263" y="2005013"/>
          <p14:tracePt t="5430" x="8077200" y="2005013"/>
          <p14:tracePt t="5441" x="8081963" y="2005013"/>
          <p14:tracePt t="5447" x="8091488" y="2005013"/>
          <p14:tracePt t="5457" x="8101013" y="2000250"/>
          <p14:tracePt t="5468" x="8105775" y="2000250"/>
          <p14:tracePt t="5470" x="8113713" y="2000250"/>
          <p14:tracePt t="5480" x="8150225" y="2000250"/>
          <p14:tracePt t="5487" x="8159750" y="2000250"/>
          <p14:tracePt t="5497" x="8186738" y="2000250"/>
          <p14:tracePt t="5508" x="8201025" y="2000250"/>
          <p14:tracePt t="5510" x="8210550" y="2000250"/>
          <p14:tracePt t="5524" x="8237538" y="2000250"/>
          <p14:tracePt t="5526" x="8247063" y="2000250"/>
          <p14:tracePt t="5537" x="8259763" y="2000250"/>
          <p14:tracePt t="5547" x="8293100" y="2000250"/>
          <p14:tracePt t="5553" x="8296275" y="2000250"/>
          <p14:tracePt t="5562" x="8305800" y="2000250"/>
          <p14:tracePt t="5568" x="8315325" y="2000250"/>
          <p14:tracePt t="5576" x="8320088" y="2000250"/>
          <p14:tracePt t="5587" x="8329613" y="2000250"/>
          <p14:tracePt t="5592" x="8337550" y="2000250"/>
          <p14:tracePt t="5604" x="8351838" y="2000250"/>
          <p14:tracePt t="5607" x="8361363" y="2000250"/>
          <p14:tracePt t="5618" x="8378825" y="2005013"/>
          <p14:tracePt t="5626" x="8397875" y="2005013"/>
          <p14:tracePt t="5633" x="8402638" y="2012950"/>
          <p14:tracePt t="5643" x="8429625" y="2012950"/>
          <p14:tracePt t="5648" x="8447088" y="2032000"/>
          <p14:tracePt t="5659" x="8456613" y="2032000"/>
          <p14:tracePt t="5678" x="8475663" y="2032000"/>
          <p14:tracePt t="5689" x="8483600" y="2032000"/>
          <p14:tracePt t="5698" x="8497888" y="2032000"/>
          <p14:tracePt t="5708" x="8515350" y="2041525"/>
          <p14:tracePt t="5712" x="8524875" y="2041525"/>
          <p14:tracePt t="5723" x="8575675" y="2049463"/>
          <p14:tracePt t="5733" x="8593138" y="2049463"/>
          <p14:tracePt t="5739" x="8621713" y="2058988"/>
          <p14:tracePt t="5748" x="8629650" y="2058988"/>
          <p14:tracePt t="5756" x="8639175" y="2058988"/>
          <p14:tracePt t="5764" x="8685213" y="2068513"/>
          <p14:tracePt t="5769" x="8694738" y="2068513"/>
          <p14:tracePt t="5778" x="8758238" y="2082800"/>
          <p14:tracePt t="5789" x="8799513" y="2082800"/>
          <p14:tracePt t="5794" x="8804275" y="2085975"/>
          <p14:tracePt t="5805" x="8853488" y="2100263"/>
          <p14:tracePt t="5808" x="8872538" y="2100263"/>
          <p14:tracePt t="5818" x="8913813" y="2100263"/>
          <p14:tracePt t="5828" x="8940800" y="2100263"/>
          <p14:tracePt t="5835" x="8950325" y="2100263"/>
          <p14:tracePt t="5844" x="8986838" y="2119313"/>
          <p14:tracePt t="5848" x="8996363" y="2119313"/>
          <p14:tracePt t="5859" x="9013825" y="2119313"/>
          <p14:tracePt t="5871" x="9018588" y="2119313"/>
          <p14:tracePt t="5880" x="9036050" y="2119313"/>
          <p14:tracePt t="5885" x="9055100" y="2119313"/>
          <p14:tracePt t="5902" x="9072563" y="2119313"/>
          <p14:tracePt t="5941" x="9077325" y="2119313"/>
          <p14:tracePt t="5986" x="9086850" y="2119313"/>
          <p14:tracePt t="6117" x="9105900" y="2119313"/>
          <p14:tracePt t="6146" x="9109075" y="2119313"/>
          <p14:tracePt t="6167" x="9118600" y="2119313"/>
          <p14:tracePt t="6176" x="9128125" y="2119313"/>
          <p14:tracePt t="6196" x="9137650" y="2119313"/>
          <p14:tracePt t="6219" x="9150350" y="2119313"/>
          <p14:tracePt t="6239" x="9159875" y="2119313"/>
          <p14:tracePt t="6258" x="9169400" y="2119313"/>
          <p14:tracePt t="6273" x="9174163" y="2122488"/>
          <p14:tracePt t="6302" x="9191625" y="2122488"/>
          <p14:tracePt t="6318" x="9210675" y="2122488"/>
          <p14:tracePt t="6339" x="9228138" y="2132013"/>
          <p14:tracePt t="6358" x="9237663" y="2132013"/>
          <p14:tracePt t="6378" x="9242425" y="2132013"/>
          <p14:tracePt t="6404" x="9251950" y="2132013"/>
          <p14:tracePt t="6408" x="9259888" y="2141538"/>
          <p14:tracePt t="6440" x="9264650" y="2141538"/>
          <p14:tracePt t="6450" x="9274175" y="2141538"/>
          <p14:tracePt t="6480" x="9283700" y="2141538"/>
          <p14:tracePt t="6611" x="9291638" y="2141538"/>
          <p14:tracePt t="6617" x="9296400" y="2141538"/>
          <p14:tracePt t="6626" x="9305925" y="2141538"/>
          <p14:tracePt t="6641" x="9315450" y="2141538"/>
          <p14:tracePt t="6650" x="9328150" y="2141538"/>
          <p14:tracePt t="6659" x="9337675" y="2141538"/>
          <p14:tracePt t="6673" x="9347200" y="2151063"/>
          <p14:tracePt t="6688" x="9351963" y="2151063"/>
          <p14:tracePt t="6704" x="9369425" y="2159000"/>
          <p14:tracePt t="6726" x="9378950" y="2159000"/>
          <p14:tracePt t="6733" x="9388475" y="2159000"/>
          <p14:tracePt t="6746" x="9393238" y="2159000"/>
          <p14:tracePt t="6762" x="9402763" y="2159000"/>
          <p14:tracePt t="6773" x="9410700" y="2159000"/>
          <p14:tracePt t="6803" x="9415463" y="2159000"/>
          <p14:tracePt t="6819" x="9424988" y="2159000"/>
          <p14:tracePt t="6828" x="9434513" y="2159000"/>
          <p14:tracePt t="6938" x="9447213" y="2159000"/>
          <p14:tracePt t="7071" x="9471025" y="2168525"/>
          <p14:tracePt t="7074" x="9471025" y="2178050"/>
          <p14:tracePt t="7084" x="9471025" y="2209800"/>
          <p14:tracePt t="7094" x="9471025" y="2241550"/>
          <p14:tracePt t="7101" x="9471025" y="2260600"/>
          <p14:tracePt t="7111" x="9471025" y="2314575"/>
          <p14:tracePt t="7115" x="9471025" y="2341563"/>
          <p14:tracePt t="7126" x="9471025" y="2443163"/>
          <p14:tracePt t="7138" x="9471025" y="2533650"/>
          <p14:tracePt t="7142" x="9471025" y="2562225"/>
          <p14:tracePt t="7152" x="9471025" y="2689225"/>
          <p14:tracePt t="7158" x="9478963" y="2735263"/>
          <p14:tracePt t="7169" x="9512300" y="2940050"/>
          <p14:tracePt t="7176" x="9525000" y="3032125"/>
          <p14:tracePt t="7180" x="9525000" y="3090863"/>
          <p14:tracePt t="7191" x="9551988" y="3255963"/>
          <p14:tracePt t="7197" x="9566275" y="3287713"/>
          <p14:tracePt t="7207" x="9588500" y="3414713"/>
          <p14:tracePt t="7219" x="9602788" y="3492500"/>
          <p14:tracePt t="7223" x="9602788" y="3511550"/>
          <p14:tracePt t="7230" x="9625013" y="3584575"/>
          <p14:tracePt t="7238" x="9625013" y="3602038"/>
          <p14:tracePt t="7246" x="9639300" y="3657600"/>
          <p14:tracePt t="7257" x="9639300" y="3675063"/>
          <p14:tracePt t="7267" x="9639300" y="3679825"/>
          <p14:tracePt t="7272" x="9644063" y="3689350"/>
          <p14:tracePt t="7287" x="9644063" y="3698875"/>
          <p14:tracePt t="7296" x="9644063" y="3706813"/>
          <p14:tracePt t="7317" x="9644063" y="3711575"/>
          <p14:tracePt t="7326" x="9644063" y="3730625"/>
          <p14:tracePt t="7346" x="9653588" y="3740150"/>
          <p14:tracePt t="7383" x="9653588" y="3743325"/>
          <p14:tracePt t="7403" x="9653588" y="3752850"/>
          <p14:tracePt t="7419" x="9653588" y="3762375"/>
          <p14:tracePt t="7505" x="9653588" y="3767138"/>
          <p14:tracePt t="7516" x="9653588" y="3776663"/>
          <p14:tracePt t="7530" x="9653588" y="3784600"/>
          <p14:tracePt t="7550" x="9653588" y="3798888"/>
          <p14:tracePt t="7556" x="9653588" y="3808413"/>
          <p14:tracePt t="7562" x="9653588" y="3816350"/>
          <p14:tracePt t="7580" x="9653588" y="3825875"/>
          <p14:tracePt t="7592" x="9653588" y="3840163"/>
          <p14:tracePt t="7605" x="9653588" y="3849688"/>
          <p14:tracePt t="7610" x="9653588" y="3857625"/>
          <p14:tracePt t="7620" x="9653588" y="3871913"/>
          <p14:tracePt t="7917" x="9671050" y="3881438"/>
          <p14:tracePt t="7926" x="9690100" y="3881438"/>
          <p14:tracePt t="7933" x="9731375" y="3881438"/>
          <p14:tracePt t="7943" x="9799638" y="3881438"/>
          <p14:tracePt t="7949" x="9877425" y="3881438"/>
          <p14:tracePt t="7959" x="10059988" y="3871913"/>
          <p14:tracePt t="7962" x="10096500" y="3871913"/>
          <p14:tracePt t="7974" x="10347325" y="3840163"/>
          <p14:tracePt t="7983" x="10529888" y="3825875"/>
          <p14:tracePt t="7989" x="10607675" y="3813175"/>
          <p14:tracePt t="7999" x="10885488" y="3794125"/>
          <p14:tracePt t="8003" x="10945813" y="3784600"/>
          <p14:tracePt t="8012" x="11145838" y="3767138"/>
          <p14:tracePt t="8023" x="11187113" y="3767138"/>
          <p14:tracePt t="8028" x="11218863" y="3767138"/>
          <p14:tracePt t="8039" x="11223625" y="3767138"/>
          <p14:tracePt t="8138" x="11233150" y="3771900"/>
          <p14:tracePt t="8148" x="11250613" y="3789363"/>
          <p14:tracePt t="8181" x="11250613" y="3808413"/>
          <p14:tracePt t="8184" x="11269663" y="3816350"/>
          <p14:tracePt t="8194" x="11269663" y="3844925"/>
          <p14:tracePt t="8210" x="11279188" y="3852863"/>
          <p14:tracePt t="8214" x="11279188" y="3857625"/>
          <p14:tracePt t="8224" x="11279188" y="3867150"/>
          <p14:tracePt t="8235" x="11279188" y="3876675"/>
          <p14:tracePt t="8841" x="11279188" y="3886200"/>
          <p14:tracePt t="8845" x="11264900" y="3886200"/>
          <p14:tracePt t="8858" x="11233150" y="3867150"/>
          <p14:tracePt t="8860" x="11228388" y="3857625"/>
          <p14:tracePt t="8870" x="11210925" y="3840163"/>
          <p14:tracePt t="8876" x="11177588" y="3830638"/>
          <p14:tracePt t="8887" x="11160125" y="3821113"/>
          <p14:tracePt t="8890" x="11141075" y="3813175"/>
          <p14:tracePt t="8900" x="11082338" y="3789363"/>
          <p14:tracePt t="8907" x="11055350" y="3779838"/>
          <p14:tracePt t="8917" x="11009313" y="3748088"/>
          <p14:tracePt t="8926" x="10945813" y="3706813"/>
          <p14:tracePt t="8930" x="10936288" y="3706813"/>
          <p14:tracePt t="8940" x="10836275" y="3662363"/>
          <p14:tracePt t="8946" x="10804525" y="3630613"/>
          <p14:tracePt t="8956" x="10585450" y="3548063"/>
          <p14:tracePt t="8967" x="10466388" y="3502025"/>
          <p14:tracePt t="8970" x="10437813" y="3492500"/>
          <p14:tracePt t="8984" x="10291763" y="3438525"/>
          <p14:tracePt t="8988" x="10215563" y="3414713"/>
          <p14:tracePt t="8996" x="10064750" y="3351213"/>
          <p14:tracePt t="9007" x="9963150" y="3324225"/>
          <p14:tracePt t="9012" x="9921875" y="3300413"/>
          <p14:tracePt t="9024" x="9753600" y="3255963"/>
          <p14:tracePt t="9026" x="9712325" y="3246438"/>
          <p14:tracePt t="9037" x="9544050" y="3187700"/>
          <p14:tracePt t="9046" x="9466263" y="3159125"/>
          <p14:tracePt t="9053" x="9420225" y="3136900"/>
          <p14:tracePt t="9062" x="9337675" y="3109913"/>
          <p14:tracePt t="9070" x="9305925" y="3078163"/>
          <p14:tracePt t="9076" x="9191625" y="3036888"/>
          <p14:tracePt t="9087" x="9109075" y="2995613"/>
          <p14:tracePt t="9092" x="9069388" y="2986088"/>
          <p14:tracePt t="9102" x="8967788" y="2898775"/>
          <p14:tracePt t="9108" x="8909050" y="2886075"/>
          <p14:tracePt t="9119" x="8772525" y="2813050"/>
          <p14:tracePt t="9128" x="8675688" y="2767013"/>
          <p14:tracePt t="9133" x="8643938" y="2757488"/>
          <p14:tracePt t="9143" x="8524875" y="2679700"/>
          <p14:tracePt t="9148" x="8512175" y="2679700"/>
          <p14:tracePt t="9159" x="8434388" y="2630488"/>
          <p14:tracePt t="9168" x="8415338" y="2620963"/>
          <p14:tracePt t="9173" x="8405813" y="2601913"/>
          <p14:tracePt t="9182" x="8397875" y="2593975"/>
          <p14:tracePt t="9218" x="8393113" y="2589213"/>
          <p14:tracePt t="9320" x="8393113" y="2579688"/>
          <p14:tracePt t="9360" x="8393113" y="2562225"/>
          <p14:tracePt t="9421" x="8393113" y="2552700"/>
          <p14:tracePt t="9470" x="8393113" y="2547938"/>
          <p14:tracePt t="9520" x="8393113" y="2520950"/>
          <p14:tracePt t="9563" x="8393113" y="2501900"/>
          <p14:tracePt t="9628" x="8393113" y="2492375"/>
          <p14:tracePt t="10863" x="8383588" y="2489200"/>
          <p14:tracePt t="10869" x="8374063" y="2489200"/>
          <p14:tracePt t="10903" x="8369300" y="2479675"/>
          <p14:tracePt t="11312" x="8378825" y="2484438"/>
          <p14:tracePt t="11332" x="8397875" y="2484438"/>
          <p14:tracePt t="11342" x="8415338" y="2501900"/>
          <p14:tracePt t="11373" x="8424863" y="2501900"/>
          <p14:tracePt t="11404" x="8439150" y="2501900"/>
          <p14:tracePt t="11412" x="8447088" y="2501900"/>
          <p14:tracePt t="11422" x="8475663" y="2501900"/>
          <p14:tracePt t="11433" x="8478838" y="2501900"/>
          <p14:tracePt t="11442" x="8497888" y="2501900"/>
          <p14:tracePt t="11449" x="8507413" y="2501900"/>
          <p14:tracePt t="11453" x="8512175" y="2501900"/>
          <p14:tracePt t="11462" x="8529638" y="2501900"/>
          <p14:tracePt t="11492" x="8548688" y="2501900"/>
          <p14:tracePt t="11503" x="8556625" y="2501900"/>
          <p14:tracePt t="11515" x="8570913" y="2501900"/>
          <p14:tracePt t="11525" x="8580438" y="2501900"/>
          <p14:tracePt t="11545" x="8589963" y="2501900"/>
          <p14:tracePt t="11555" x="8602663" y="2501900"/>
          <p14:tracePt t="11558" x="8612188" y="2501900"/>
          <p14:tracePt t="11595" x="8629650" y="2501900"/>
          <p14:tracePt t="11608" x="8634413" y="2501900"/>
          <p14:tracePt t="11624" x="8643938" y="2501900"/>
          <p14:tracePt t="11635" x="8653463" y="2501900"/>
          <p14:tracePt t="11641" x="8658225" y="2501900"/>
          <p14:tracePt t="11651" x="8675688" y="2501900"/>
          <p14:tracePt t="11660" x="8685213" y="2501900"/>
          <p14:tracePt t="11664" x="8712200" y="2501900"/>
          <p14:tracePt t="11675" x="8716963" y="2501900"/>
          <p14:tracePt t="11680" x="8743950" y="2501900"/>
          <p14:tracePt t="11691" x="8804275" y="2484438"/>
          <p14:tracePt t="11701" x="8809038" y="2484438"/>
          <p14:tracePt t="11705" x="8836025" y="2484438"/>
          <p14:tracePt t="11714" x="8894763" y="2460625"/>
          <p14:tracePt t="11721" x="8904288" y="2460625"/>
          <p14:tracePt t="11730" x="8977313" y="2438400"/>
          <p14:tracePt t="11741" x="9004300" y="2438400"/>
          <p14:tracePt t="11746" x="9013825" y="2438400"/>
          <p14:tracePt t="11757" x="9032875" y="2438400"/>
          <p14:tracePt t="11760" x="9036050" y="2438400"/>
          <p14:tracePt t="11772" x="9045575" y="2438400"/>
          <p14:tracePt t="11830" x="9055100" y="2438400"/>
          <p14:tracePt t="11851" x="9064625" y="2438400"/>
          <p14:tracePt t="11873" x="9086850" y="2438400"/>
          <p14:tracePt t="11993" x="9105900" y="2438400"/>
          <p14:tracePt t="12008" x="9113838" y="2438400"/>
          <p14:tracePt t="12013" x="9132888" y="2443163"/>
          <p14:tracePt t="12029" x="9137650" y="2443163"/>
          <p14:tracePt t="12040" x="9155113" y="2443163"/>
          <p14:tracePt t="12049" x="9164638" y="2443163"/>
          <p14:tracePt t="12055" x="9169400" y="2443163"/>
          <p14:tracePt t="12059" x="9186863" y="2443163"/>
          <p14:tracePt t="12069" x="9205913" y="2443163"/>
          <p14:tracePt t="12094" x="9242425" y="2443163"/>
          <p14:tracePt t="12104" x="9251950" y="2443163"/>
          <p14:tracePt t="12348" x="9264650" y="2443163"/>
          <p14:tracePt t="12353" x="9274175" y="2443163"/>
          <p14:tracePt t="12362" x="9291638" y="2443163"/>
          <p14:tracePt t="12369" x="9296400" y="2443163"/>
          <p14:tracePt t="12377" x="9324975" y="2443163"/>
          <p14:tracePt t="12380" x="9332913" y="2443163"/>
          <p14:tracePt t="12390" x="9378950" y="2443163"/>
          <p14:tracePt t="12395" x="9388475" y="2443163"/>
          <p14:tracePt t="12406" x="9424988" y="2438400"/>
          <p14:tracePt t="12417" x="9456738" y="2428875"/>
          <p14:tracePt t="12420" x="9471025" y="2428875"/>
          <p14:tracePt t="12430" x="9493250" y="2411413"/>
          <p14:tracePt t="12436" x="9498013" y="2411413"/>
          <p14:tracePt t="12446" x="9525000" y="2401888"/>
          <p14:tracePt t="12458" x="9534525" y="2401888"/>
          <p14:tracePt t="12468" x="9551988" y="2392363"/>
          <p14:tracePt t="12476" x="9571038" y="2382838"/>
          <p14:tracePt t="12503" x="9580563" y="2382838"/>
          <p14:tracePt t="12619" x="9585325" y="2382838"/>
          <p14:tracePt t="13454" x="9575800" y="2382838"/>
          <p14:tracePt t="13466" x="9566275" y="2382838"/>
          <p14:tracePt t="13472" x="9556750" y="2382838"/>
          <p14:tracePt t="13482" x="9551988" y="2382838"/>
          <p14:tracePt t="13490" x="9534525" y="2382838"/>
          <p14:tracePt t="13502" x="9525000" y="2382838"/>
          <p14:tracePt t="13511" x="9502775" y="2382838"/>
          <p14:tracePt t="13527" x="9483725" y="2382838"/>
          <p14:tracePt t="13538" x="9466263" y="2382838"/>
          <p14:tracePt t="13542" x="9447213" y="2387600"/>
          <p14:tracePt t="13550" x="9429750" y="2397125"/>
          <p14:tracePt t="13566" x="9420225" y="2401888"/>
          <p14:tracePt t="13576" x="9410700" y="2401888"/>
          <p14:tracePt t="13579" x="9405938" y="2411413"/>
          <p14:tracePt t="13593" x="9388475" y="2428875"/>
          <p14:tracePt t="13603" x="9378950" y="2428875"/>
          <p14:tracePt t="13627" x="9369425" y="2428875"/>
          <p14:tracePt t="13673" x="9366250" y="2428875"/>
          <p14:tracePt t="13683" x="9356725" y="2428875"/>
          <p14:tracePt t="13689" x="9337675" y="2428875"/>
          <p14:tracePt t="13696" x="9332913" y="2428875"/>
          <p14:tracePt t="13708" x="9324975" y="2428875"/>
          <p14:tracePt t="13712" x="9315450" y="2438400"/>
          <p14:tracePt t="13733" x="9296400" y="2447925"/>
          <p14:tracePt t="13758" x="9291638" y="2447925"/>
          <p14:tracePt t="13802" x="9274175" y="2447925"/>
          <p14:tracePt t="13812" x="9264650" y="2452688"/>
          <p14:tracePt t="15079" x="9251950" y="2452688"/>
          <p14:tracePt t="16458" x="9251950" y="2470150"/>
          <p14:tracePt t="16462" x="9251950" y="2479675"/>
          <p14:tracePt t="16478" x="9251950" y="2489200"/>
          <p14:tracePt t="16488" x="9251950" y="2501900"/>
          <p14:tracePt t="16497" x="9251950" y="2533650"/>
          <p14:tracePt t="16509" x="9251950" y="2538413"/>
          <p14:tracePt t="16519" x="9251950" y="2601913"/>
          <p14:tracePt t="16527" x="9251950" y="2630488"/>
          <p14:tracePt t="16535" x="9251950" y="2657475"/>
          <p14:tracePt t="16543" x="9255125" y="2730500"/>
          <p14:tracePt t="16547" x="9269413" y="2762250"/>
          <p14:tracePt t="16558" x="9278938" y="2830513"/>
          <p14:tracePt t="16569" x="9291638" y="2908300"/>
          <p14:tracePt t="16573" x="9291638" y="2927350"/>
          <p14:tracePt t="16584" x="9305925" y="3041650"/>
          <p14:tracePt t="16589" x="9305925" y="3059113"/>
          <p14:tracePt t="16598" x="9328150" y="3187700"/>
          <p14:tracePt t="16607" x="9356725" y="3263900"/>
          <p14:tracePt t="16611" x="9366250" y="3297238"/>
          <p14:tracePt t="16622" x="9393238" y="3397250"/>
          <p14:tracePt t="16627" x="9402763" y="3414713"/>
          <p14:tracePt t="16639" x="9429750" y="3516313"/>
          <p14:tracePt t="16647" x="9451975" y="3579813"/>
          <p14:tracePt t="16652" x="9471025" y="3597275"/>
          <p14:tracePt t="16662" x="9483725" y="3670300"/>
          <p14:tracePt t="16671" x="9502775" y="3689350"/>
          <p14:tracePt t="16678" x="9512300" y="3721100"/>
          <p14:tracePt t="16689" x="9534525" y="3776663"/>
          <p14:tracePt t="16692" x="9544050" y="3794125"/>
          <p14:tracePt t="16705" x="9580563" y="3852863"/>
          <p14:tracePt t="16708" x="9588500" y="3871913"/>
          <p14:tracePt t="16719" x="9634538" y="3922713"/>
          <p14:tracePt t="16728" x="9675813" y="3986213"/>
          <p14:tracePt t="16734" x="9680575" y="3990975"/>
          <p14:tracePt t="16744" x="9721850" y="4032250"/>
          <p14:tracePt t="16748" x="9744075" y="4049713"/>
          <p14:tracePt t="16758" x="9785350" y="4086225"/>
          <p14:tracePt t="16769" x="9831388" y="4110038"/>
          <p14:tracePt t="16774" x="9848850" y="4117975"/>
          <p14:tracePt t="16784" x="9913938" y="4164013"/>
          <p14:tracePt t="16794" x="9918700" y="4173538"/>
          <p14:tracePt t="16799" x="9955213" y="4183063"/>
          <p14:tracePt t="16808" x="9963150" y="4191000"/>
          <p14:tracePt t="16824" x="9991725" y="4200525"/>
          <p14:tracePt t="16841" x="10009188" y="4200525"/>
          <p14:tracePt t="16850" x="10013950" y="4200525"/>
          <p14:tracePt t="16856" x="10031413" y="4200525"/>
          <p14:tracePt t="16864" x="10064750" y="4200525"/>
          <p14:tracePt t="16875" x="10077450" y="4200525"/>
          <p14:tracePt t="16880" x="10086975" y="4200525"/>
          <p14:tracePt t="16891" x="10104438" y="4200525"/>
          <p14:tracePt t="16894" x="10109200" y="4200525"/>
          <p14:tracePt t="16905" x="10145713" y="4200525"/>
          <p14:tracePt t="16910" x="10155238" y="4195763"/>
          <p14:tracePt t="16921" x="10164763" y="4186238"/>
          <p14:tracePt t="16930" x="10179050" y="4178300"/>
          <p14:tracePt t="16940" x="10201275" y="4149725"/>
          <p14:tracePt t="16951" x="10210800" y="4141788"/>
          <p14:tracePt t="16960" x="10215563" y="4132263"/>
          <p14:tracePt t="16971" x="10223500" y="4127500"/>
          <p14:tracePt t="16976" x="10233025" y="4117975"/>
          <p14:tracePt t="16987" x="10237788" y="4110038"/>
          <p14:tracePt t="16991" x="10255250" y="4081463"/>
          <p14:tracePt t="17001" x="10264775" y="4073525"/>
          <p14:tracePt t="17010" x="10283825" y="4059238"/>
          <p14:tracePt t="17021" x="10291763" y="4049713"/>
          <p14:tracePt t="17030" x="10291763" y="4040188"/>
          <p14:tracePt t="17040" x="10310813" y="4022725"/>
          <p14:tracePt t="17057" x="10320338" y="4003675"/>
          <p14:tracePt t="17067" x="10320338" y="3986213"/>
          <p14:tracePt t="17085" x="10325100" y="3963988"/>
          <p14:tracePt t="17092" x="10333038" y="3954463"/>
          <p14:tracePt t="17096" x="10333038" y="3949700"/>
          <p14:tracePt t="17107" x="10333038" y="3930650"/>
          <p14:tracePt t="17123" x="10342563" y="3922713"/>
          <p14:tracePt t="17143" x="10342563" y="3908425"/>
          <p14:tracePt t="17163" x="10342563" y="3889375"/>
          <p14:tracePt t="17174" x="10342563" y="3881438"/>
          <p14:tracePt t="17183" x="10342563" y="3852863"/>
          <p14:tracePt t="17192" x="10342563" y="3849688"/>
          <p14:tracePt t="17202" x="10342563" y="3830638"/>
          <p14:tracePt t="17212" x="10342563" y="3821113"/>
          <p14:tracePt t="17218" x="10342563" y="3816350"/>
          <p14:tracePt t="17228" x="10342563" y="3798888"/>
          <p14:tracePt t="17239" x="10342563" y="3779838"/>
          <p14:tracePt t="17242" x="10342563" y="3771900"/>
          <p14:tracePt t="17252" x="10342563" y="3767138"/>
          <p14:tracePt t="17262" x="10342563" y="3748088"/>
          <p14:tracePt t="17278" x="10337800" y="3740150"/>
          <p14:tracePt t="17294" x="10328275" y="3735388"/>
          <p14:tracePt t="17305" x="10328275" y="3725863"/>
          <p14:tracePt t="17328" x="10325100" y="3706813"/>
          <p14:tracePt t="17335" x="10315575" y="3698875"/>
          <p14:tracePt t="17339" x="10306050" y="3694113"/>
          <p14:tracePt t="17358" x="10288588" y="3684588"/>
          <p14:tracePt t="17374" x="10283825" y="3675063"/>
          <p14:tracePt t="17384" x="10274300" y="3667125"/>
          <p14:tracePt t="17394" x="10264775" y="3662363"/>
          <p14:tracePt t="17405" x="10252075" y="3652838"/>
          <p14:tracePt t="17424" x="10233025" y="3652838"/>
          <p14:tracePt t="17430" x="10223500" y="3633788"/>
          <p14:tracePt t="17444" x="10215563" y="3633788"/>
          <p14:tracePt t="17455" x="10206038" y="3633788"/>
          <p14:tracePt t="17465" x="10191750" y="3633788"/>
          <p14:tracePt t="17471" x="10182225" y="3633788"/>
          <p14:tracePt t="17481" x="10164763" y="3633788"/>
          <p14:tracePt t="17484" x="10145713" y="3633788"/>
          <p14:tracePt t="17495" x="10118725" y="3633788"/>
          <p14:tracePt t="17501" x="10101263" y="3633788"/>
          <p14:tracePt t="17511" x="10059988" y="3633788"/>
          <p14:tracePt t="17517" x="10055225" y="3633788"/>
          <p14:tracePt t="17526" x="10028238" y="3633788"/>
          <p14:tracePt t="17537" x="9986963" y="3633788"/>
          <p14:tracePt t="17540" x="9967913" y="3648075"/>
          <p14:tracePt t="17550" x="9950450" y="3657600"/>
          <p14:tracePt t="17556" x="9940925" y="3657600"/>
          <p14:tracePt t="17567" x="9931400" y="3662363"/>
          <p14:tracePt t="17576" x="9918700" y="3662363"/>
          <p14:tracePt t="17580" x="9909175" y="3670300"/>
          <p14:tracePt t="17591" x="9890125" y="3689350"/>
          <p14:tracePt t="17607" x="9872663" y="3721100"/>
          <p14:tracePt t="17617" x="9863138" y="3725863"/>
          <p14:tracePt t="17622" x="9853613" y="3735388"/>
          <p14:tracePt t="17634" x="9826625" y="3776663"/>
          <p14:tracePt t="17642" x="9817100" y="3794125"/>
          <p14:tracePt t="17646" x="9817100" y="3813175"/>
          <p14:tracePt t="17657" x="9804400" y="3840163"/>
          <p14:tracePt t="17662" x="9804400" y="3857625"/>
          <p14:tracePt t="17673" x="9794875" y="3913188"/>
          <p14:tracePt t="17676" x="9794875" y="3922713"/>
          <p14:tracePt t="17688" x="9794875" y="3967163"/>
          <p14:tracePt t="17696" x="9794875" y="3986213"/>
          <p14:tracePt t="17703" x="9794875" y="4003675"/>
          <p14:tracePt t="17712" x="9794875" y="4037013"/>
          <p14:tracePt t="17717" x="9794875" y="4049713"/>
          <p14:tracePt t="17726" x="9794875" y="4081463"/>
          <p14:tracePt t="17739" x="9794875" y="4100513"/>
          <p14:tracePt t="17742" x="9794875" y="4105275"/>
          <p14:tracePt t="17753" x="9799638" y="4132263"/>
          <p14:tracePt t="17758" x="9809163" y="4149725"/>
          <p14:tracePt t="17769" x="9882188" y="4214813"/>
          <p14:tracePt t="17778" x="9890125" y="4232275"/>
          <p14:tracePt t="17789" x="9913938" y="4251325"/>
          <p14:tracePt t="17799" x="9918700" y="4251325"/>
          <p14:tracePt t="17808" x="9945688" y="4268788"/>
          <p14:tracePt t="17819" x="9955213" y="4268788"/>
          <p14:tracePt t="17823" x="9982200" y="4278313"/>
          <p14:tracePt t="17834" x="10023475" y="4278313"/>
          <p14:tracePt t="17842" x="10040938" y="4278313"/>
          <p14:tracePt t="17849" x="10059988" y="4287838"/>
          <p14:tracePt t="17858" x="10077450" y="4287838"/>
          <p14:tracePt t="17864" x="10091738" y="4287838"/>
          <p14:tracePt t="17875" x="10123488" y="4300538"/>
          <p14:tracePt t="17878" x="10133013" y="4300538"/>
          <p14:tracePt t="17889" x="10169525" y="4300538"/>
          <p14:tracePt t="17905" x="10174288" y="4300538"/>
          <p14:tracePt t="17914" x="10191750" y="4300538"/>
          <p14:tracePt t="17928" x="10210800" y="4300538"/>
          <p14:tracePt t="17944" x="10218738" y="4300538"/>
          <p14:tracePt t="17958" x="10223500" y="4300538"/>
          <p14:tracePt t="17972" x="10242550" y="4300538"/>
          <p14:tracePt t="17980" x="10260013" y="4292600"/>
          <p14:tracePt t="17990" x="10279063" y="4283075"/>
          <p14:tracePt t="18001" x="10288588" y="4278313"/>
          <p14:tracePt t="18011" x="10306050" y="4268788"/>
          <p14:tracePt t="18024" x="10310813" y="4268788"/>
          <p14:tracePt t="18034" x="10320338" y="4259263"/>
          <p14:tracePt t="18055" x="10328275" y="4241800"/>
          <p14:tracePt t="18071" x="10337800" y="4237038"/>
          <p14:tracePt t="18080" x="10337800" y="4227513"/>
          <p14:tracePt t="18091" x="10337800" y="4219575"/>
          <p14:tracePt t="18101" x="10337800" y="4214813"/>
          <p14:tracePt t="18110" x="10337800" y="4195763"/>
          <p14:tracePt t="18116" x="10337800" y="4186238"/>
          <p14:tracePt t="18121" x="10337800" y="4173538"/>
          <p14:tracePt t="18130" x="10347325" y="4149725"/>
          <p14:tracePt t="18150" x="10347325" y="4146550"/>
          <p14:tracePt t="18166" x="10347325" y="4137025"/>
          <p14:tracePt t="18180" x="10347325" y="4127500"/>
          <p14:tracePt t="18197" x="10347325" y="4122738"/>
          <p14:tracePt t="18207" x="10347325" y="4113213"/>
          <p14:tracePt t="18223" x="10347325" y="4095750"/>
          <p14:tracePt t="18237" x="10347325" y="4076700"/>
          <p14:tracePt t="18252" x="10347325" y="4073525"/>
          <p14:tracePt t="18267" x="10347325" y="4064000"/>
          <p14:tracePt t="18276" x="10347325" y="4054475"/>
          <p14:tracePt t="18287" x="10347325" y="4049713"/>
          <p14:tracePt t="18358" x="10347325" y="4022725"/>
          <p14:tracePt t="18454" x="10347325" y="4003675"/>
          <p14:tracePt t="19761" x="10347325" y="3995738"/>
          <p14:tracePt t="22336" x="10288588" y="3986213"/>
          <p14:tracePt t="22342" x="10140950" y="3986213"/>
          <p14:tracePt t="22347" x="10050463" y="3986213"/>
          <p14:tracePt t="22354" x="9921875" y="3986213"/>
          <p14:tracePt t="22363" x="9320213" y="3986213"/>
          <p14:tracePt t="22369" x="9155113" y="3986213"/>
          <p14:tracePt t="22379" x="8799513" y="3986213"/>
          <p14:tracePt t="22389" x="8242300" y="3986213"/>
          <p14:tracePt t="22392" x="8183563" y="3986213"/>
          <p14:tracePt t="22404" x="8035925" y="3986213"/>
          <p14:tracePt t="22412" x="8023225" y="3986213"/>
          <p14:tracePt t="22421" x="8013700" y="3986213"/>
          <p14:tracePt t="22538" x="7996238" y="3967163"/>
          <p14:tracePt t="22721" x="7986713" y="3949700"/>
          <p14:tracePt t="22732" x="7967663" y="3940175"/>
          <p14:tracePt t="22742" x="7967663" y="3930650"/>
          <p14:tracePt t="22751" x="7940675" y="3903663"/>
          <p14:tracePt t="22758" x="7931150" y="3886200"/>
          <p14:tracePt t="22768" x="7867650" y="3798888"/>
          <p14:tracePt t="22774" x="7858125" y="3789363"/>
          <p14:tracePt t="22782" x="7813675" y="3711575"/>
          <p14:tracePt t="22790" x="7731125" y="3630613"/>
          <p14:tracePt t="22796" x="7707313" y="3597275"/>
          <p14:tracePt t="22806" x="7658100" y="3479800"/>
          <p14:tracePt t="22810" x="7634288" y="3448050"/>
          <p14:tracePt t="22822" x="7589838" y="3373438"/>
          <p14:tracePt t="22832" x="7512050" y="3241675"/>
          <p14:tracePt t="22836" x="7502525" y="3224213"/>
          <p14:tracePt t="22845" x="7466013" y="3090863"/>
          <p14:tracePt t="22852" x="7443788" y="3059113"/>
          <p14:tracePt t="22863" x="7434263" y="3032125"/>
          <p14:tracePt t="22874" x="7397750" y="2959100"/>
          <p14:tracePt t="22877" x="7397750" y="2949575"/>
          <p14:tracePt t="22889" x="7388225" y="2930525"/>
          <p14:tracePt t="22898" x="7378700" y="2922588"/>
          <p14:tracePt t="23341" x="7378700" y="2917825"/>
          <p14:tracePt t="23407" x="7383463" y="2917825"/>
          <p14:tracePt t="23447" x="7402513" y="2917825"/>
          <p14:tracePt t="23503" x="7407275" y="2917825"/>
          <p14:tracePt t="23523" x="7415213" y="2917825"/>
          <p14:tracePt t="23533" x="7424738" y="2908300"/>
          <p14:tracePt t="23543" x="7434263" y="2890838"/>
          <p14:tracePt t="23549" x="7439025" y="2890838"/>
          <p14:tracePt t="23555" x="7446963" y="2890838"/>
          <p14:tracePt t="23563" x="7456488" y="2881313"/>
          <p14:tracePt t="23573" x="7483475" y="2876550"/>
          <p14:tracePt t="23585" x="7502525" y="2862263"/>
          <p14:tracePt t="23592" x="7507288" y="2862263"/>
          <p14:tracePt t="23604" x="7516813" y="2857500"/>
          <p14:tracePt t="23613" x="7534275" y="2840038"/>
          <p14:tracePt t="23931" x="7543800" y="2830513"/>
          <p14:tracePt t="23941" x="7539038" y="2813050"/>
          <p14:tracePt t="23951" x="7497763" y="2803525"/>
          <p14:tracePt t="23957" x="7488238" y="2803525"/>
          <p14:tracePt t="23967" x="7470775" y="2803525"/>
          <p14:tracePt t="23976" x="7443788" y="2794000"/>
          <p14:tracePt t="23982" x="7434263" y="2794000"/>
          <p14:tracePt t="23992" x="7407275" y="2784475"/>
          <p14:tracePt t="23996" x="7397750" y="2784475"/>
          <p14:tracePt t="24006" x="7392988" y="2784475"/>
          <p14:tracePt t="24017" x="7366000" y="2776538"/>
          <p14:tracePt t="24026" x="7334250" y="2776538"/>
          <p14:tracePt t="24034" x="7329488" y="2776538"/>
          <p14:tracePt t="24037" x="7319963" y="2776538"/>
          <p14:tracePt t="24046" x="7292975" y="2767013"/>
          <p14:tracePt t="24057" x="7251700" y="2757488"/>
          <p14:tracePt t="24070" x="7242175" y="2747963"/>
          <p14:tracePt t="24073" x="7169150" y="2725738"/>
          <p14:tracePt t="24076" x="7146925" y="2708275"/>
          <p14:tracePt t="24089" x="7105650" y="2708275"/>
          <p14:tracePt t="24100" x="7023100" y="2684463"/>
          <p14:tracePt t="24103" x="6977063" y="2671763"/>
          <p14:tracePt t="24112" x="6899275" y="2662238"/>
          <p14:tracePt t="24121" x="6894513" y="2662238"/>
          <p14:tracePt t="24129" x="6867525" y="2652713"/>
          <p14:tracePt t="24139" x="6821488" y="2616200"/>
          <p14:tracePt t="24142" x="6794500" y="2616200"/>
          <p14:tracePt t="24153" x="6772275" y="2598738"/>
          <p14:tracePt t="24159" x="6767513" y="2598738"/>
          <p14:tracePt t="24169" x="6757988" y="2589213"/>
          <p14:tracePt t="24178" x="6748463" y="2584450"/>
          <p14:tracePt t="24215" x="6748463" y="2574925"/>
          <p14:tracePt t="24218" x="6740525" y="2538413"/>
          <p14:tracePt t="24234" x="6740525" y="2506663"/>
          <p14:tracePt t="24239" x="6740525" y="2492375"/>
          <p14:tracePt t="24250" x="6740525" y="2438400"/>
          <p14:tracePt t="24258" x="6740525" y="2292350"/>
          <p14:tracePt t="24265" x="6740525" y="2251075"/>
          <p14:tracePt t="24275" x="6740525" y="2058988"/>
          <p14:tracePt t="24278" x="6740525" y="2017713"/>
          <p14:tracePt t="24289" x="6740525" y="1917700"/>
          <p14:tracePt t="24300" x="6740525" y="1671638"/>
          <p14:tracePt t="24305" x="6740525" y="1639888"/>
          <p14:tracePt t="24315" x="6740525" y="1484313"/>
          <p14:tracePt t="24321" x="6740525" y="1452563"/>
          <p14:tracePt t="24331" x="6740525" y="1382713"/>
          <p14:tracePt t="24340" x="6886575" y="1338263"/>
          <p14:tracePt t="24345" x="6886575" y="1319213"/>
          <p14:tracePt t="24355" x="6858000" y="1273175"/>
          <p14:tracePt t="24365" x="6858000" y="1270000"/>
          <p14:tracePt t="24372" x="6850063" y="1260475"/>
          <p14:tracePt t="24380" x="6821488" y="1241425"/>
          <p14:tracePt t="24385" x="6813550" y="1233488"/>
          <p14:tracePt t="24395" x="6784975" y="1223963"/>
          <p14:tracePt t="24400" x="6757988" y="1223963"/>
          <p14:tracePt t="24410" x="6670675" y="1214438"/>
          <p14:tracePt t="24422" x="6575425" y="1187450"/>
          <p14:tracePt t="24424" x="6534150" y="1187450"/>
          <p14:tracePt t="24437" x="6361113" y="1173163"/>
          <p14:tracePt t="24440" x="6305550" y="1173163"/>
          <p14:tracePt t="24450" x="6210300" y="1146175"/>
          <p14:tracePt t="24461" x="5922963" y="1109663"/>
          <p14:tracePt t="24467" x="5862638" y="1095375"/>
          <p14:tracePt t="24476" x="5580063" y="1058863"/>
          <p14:tracePt t="24480" x="5502275" y="1050925"/>
          <p14:tracePt t="24491" x="5338763" y="1017588"/>
          <p14:tracePt t="24500" x="4995863" y="981075"/>
          <p14:tracePt t="24507" x="4918075" y="968375"/>
          <p14:tracePt t="24518" x="4611688" y="949325"/>
          <p14:tracePt t="24521" x="4557713" y="949325"/>
          <p14:tracePt t="24530" x="4387850" y="917575"/>
          <p14:tracePt t="24541" x="4110038" y="903288"/>
          <p14:tracePt t="24546" x="4049713" y="903288"/>
          <p14:tracePt t="24556" x="3825875" y="885825"/>
          <p14:tracePt t="24562" x="3767138" y="885825"/>
          <p14:tracePt t="24572" x="3657600" y="885825"/>
          <p14:tracePt t="24583" x="3455988" y="871538"/>
          <p14:tracePt t="24587" x="3382963" y="871538"/>
          <p14:tracePt t="24596" x="3163888" y="871538"/>
          <p14:tracePt t="24603" x="3122613" y="871538"/>
          <p14:tracePt t="24612" x="2995613" y="871538"/>
          <p14:tracePt t="24623" x="2744788" y="871538"/>
          <p14:tracePt t="24626" x="2703513" y="871538"/>
          <p14:tracePt t="24638" x="2489200" y="871538"/>
          <p14:tracePt t="24642" x="2428875" y="871538"/>
          <p14:tracePt t="24653" x="2301875" y="871538"/>
          <p14:tracePt t="24662" x="2082800" y="871538"/>
          <p14:tracePt t="24670" x="2022475" y="871538"/>
          <p14:tracePt t="24678" x="1793875" y="835025"/>
          <p14:tracePt t="24684" x="1735138" y="827088"/>
          <p14:tracePt t="24692" x="1589088" y="827088"/>
          <p14:tracePt t="24703" x="1406525" y="808038"/>
          <p14:tracePt t="24708" x="1360488" y="798513"/>
          <p14:tracePt t="24719" x="1196975" y="785813"/>
          <p14:tracePt t="24723" x="1141413" y="785813"/>
          <p14:tracePt t="24734" x="1050925" y="785813"/>
          <p14:tracePt t="24742" x="922338" y="785813"/>
          <p14:tracePt t="24750" x="881063" y="785813"/>
          <p14:tracePt t="24758" x="793750" y="785813"/>
          <p14:tracePt t="24762" x="776288" y="790575"/>
          <p14:tracePt t="24773" x="708025" y="803275"/>
          <p14:tracePt t="24785" x="608013" y="844550"/>
          <p14:tracePt t="24788" x="579438" y="863600"/>
          <p14:tracePt t="24800" x="461963" y="917575"/>
          <p14:tracePt t="24805" x="442913" y="927100"/>
          <p14:tracePt t="24814" x="411163" y="944563"/>
          <p14:tracePt t="24824" x="311150" y="1009650"/>
          <p14:tracePt t="24837" x="277813" y="1041400"/>
          <p14:tracePt t="24839" x="246063" y="1063625"/>
          <p14:tracePt t="24844" x="223838" y="1104900"/>
          <p14:tracePt t="24855" x="192088" y="1136650"/>
          <p14:tracePt t="24865" x="136525" y="1219200"/>
          <p14:tracePt t="24870" x="119063" y="1241425"/>
          <p14:tracePt t="24878" x="95250" y="1309688"/>
          <p14:tracePt t="24885" x="87313" y="1319213"/>
          <p14:tracePt t="24894" x="63500" y="1370013"/>
          <p14:tracePt t="24905" x="55563" y="1447800"/>
          <p14:tracePt t="24910" x="46038" y="1465263"/>
          <p14:tracePt t="24921" x="31750" y="1538288"/>
          <p14:tracePt t="24924" x="31750" y="1566863"/>
          <p14:tracePt t="24935" x="19050" y="1635125"/>
          <p14:tracePt t="24944" x="19050" y="1676400"/>
          <p14:tracePt t="24950" x="19050" y="1708150"/>
          <p14:tracePt t="24960" x="9525" y="1776413"/>
          <p14:tracePt t="24965" x="9525" y="1785938"/>
          <p14:tracePt t="24974" x="9525" y="1844675"/>
          <p14:tracePt t="24986" x="9525" y="1939925"/>
          <p14:tracePt t="24990" x="9525" y="1954213"/>
          <p14:tracePt t="25000" x="9525" y="2068513"/>
          <p14:tracePt t="25005" x="9525" y="2100263"/>
          <p14:tracePt t="25017" x="14288" y="2168525"/>
          <p14:tracePt t="25026" x="14288" y="2260600"/>
          <p14:tracePt t="25030" x="14288" y="2278063"/>
          <p14:tracePt t="25040" x="14288" y="2438400"/>
          <p14:tracePt t="25046" x="26988" y="2479675"/>
          <p14:tracePt t="25057" x="26988" y="2570163"/>
          <p14:tracePt t="25068" x="41275" y="2716213"/>
          <p14:tracePt t="25071" x="41275" y="2747963"/>
          <p14:tracePt t="25080" x="41275" y="2890838"/>
          <p14:tracePt t="25087" x="41275" y="2922588"/>
          <p14:tracePt t="25096" x="41275" y="2990850"/>
          <p14:tracePt t="25107" x="41275" y="3136900"/>
          <p14:tracePt t="25110" x="41275" y="3178175"/>
          <p14:tracePt t="25134" x="50800" y="3333750"/>
          <p14:tracePt t="25139" x="50800" y="3433763"/>
          <p14:tracePt t="25146" x="63500" y="3560763"/>
          <p14:tracePt t="25154" x="77788" y="3606800"/>
          <p14:tracePt t="25162" x="77788" y="3698875"/>
          <p14:tracePt t="25167" x="87313" y="3757613"/>
          <p14:tracePt t="25177" x="100013" y="3867150"/>
          <p14:tracePt t="25187" x="131763" y="3981450"/>
          <p14:tracePt t="25193" x="131763" y="4022725"/>
          <p14:tracePt t="25203" x="131763" y="4137025"/>
          <p14:tracePt t="25207" x="141288" y="4195763"/>
          <p14:tracePt t="25216" x="141288" y="4305300"/>
          <p14:tracePt t="25226" x="192088" y="4543425"/>
          <p14:tracePt t="25233" x="219075" y="4606925"/>
          <p14:tracePt t="25242" x="282575" y="4821238"/>
          <p14:tracePt t="25249" x="311150" y="4881563"/>
          <p14:tracePt t="25259" x="355600" y="5049838"/>
          <p14:tracePt t="25269" x="465138" y="5324475"/>
          <p14:tracePt t="25273" x="501650" y="5373688"/>
          <p14:tracePt t="25283" x="652463" y="5657850"/>
          <p14:tracePt t="25289" x="684213" y="5689600"/>
          <p14:tracePt t="25300" x="744538" y="5821363"/>
          <p14:tracePt t="25309" x="854075" y="5999163"/>
          <p14:tracePt t="25312" x="895350" y="6064250"/>
          <p14:tracePt t="25323" x="981075" y="6181725"/>
          <p14:tracePt t="25328" x="1014413" y="6213475"/>
          <p14:tracePt t="25340" x="1068388" y="6278563"/>
          <p14:tracePt t="25350" x="1150938" y="6364288"/>
          <p14:tracePt t="25359" x="1187450" y="6410325"/>
          <p14:tracePt t="25364" x="1219200" y="6442075"/>
          <p14:tracePt t="25369" x="1228725" y="6461125"/>
          <p14:tracePt t="25378" x="1292225" y="6538913"/>
          <p14:tracePt t="25389" x="1328738" y="6583363"/>
          <p14:tracePt t="25394" x="1360488" y="6616700"/>
          <p14:tracePt t="25405" x="1443038" y="6702425"/>
          <p14:tracePt t="25408" x="1465263" y="6734175"/>
          <p14:tracePt t="25420" x="1484313" y="6753225"/>
          <p14:tracePt t="25428" x="1530350" y="6799263"/>
          <p14:tracePt t="25436" x="1562100" y="6831013"/>
          <p14:tracePt t="25444" x="1570038" y="6848475"/>
          <p14:tracePt t="29291" x="4178300" y="6680200"/>
          <p14:tracePt t="29300" x="4141788" y="6616700"/>
          <p14:tracePt t="29303" x="4068763" y="6515100"/>
          <p14:tracePt t="29314" x="4000500" y="6434138"/>
          <p14:tracePt t="29325" x="3913188" y="6346825"/>
          <p14:tracePt t="29329" x="3903663" y="6327775"/>
          <p14:tracePt t="29341" x="3871913" y="6296025"/>
          <p14:tracePt t="29342" x="3844925" y="6278563"/>
          <p14:tracePt t="29352" x="3822700" y="6269038"/>
          <p14:tracePt t="29361" x="3803650" y="6254750"/>
          <p14:tracePt t="29369" x="3798888" y="6254750"/>
          <p14:tracePt t="29377" x="3789363" y="6242050"/>
          <p14:tracePt t="29383" x="3781425" y="6242050"/>
          <p14:tracePt t="29394" x="3771900" y="6242050"/>
          <p14:tracePt t="29406" x="3749675" y="6242050"/>
          <p14:tracePt t="29409" x="3740150" y="6242050"/>
          <p14:tracePt t="29419" x="3721100" y="6242050"/>
          <p14:tracePt t="29426" x="3694113" y="6232525"/>
          <p14:tracePt t="29435" x="3648075" y="6218238"/>
          <p14:tracePt t="29446" x="3594100" y="6218238"/>
          <p14:tracePt t="29453" x="3575050" y="6218238"/>
          <p14:tracePt t="29460" x="3557588" y="6210300"/>
          <p14:tracePt t="29466" x="3529013" y="6210300"/>
          <p14:tracePt t="29476" x="3497263" y="6210300"/>
          <p14:tracePt t="29485" x="3470275" y="6210300"/>
          <p14:tracePt t="29646" x="3475038" y="6210300"/>
          <p14:tracePt t="29649" x="3479800" y="6210300"/>
          <p14:tracePt t="29660" x="3489325" y="6210300"/>
          <p14:tracePt t="29667" x="3516313" y="6210300"/>
          <p14:tracePt t="29676" x="3543300" y="6210300"/>
          <p14:tracePt t="29687" x="3575050" y="6200775"/>
          <p14:tracePt t="29690" x="3594100" y="6200775"/>
          <p14:tracePt t="29700" x="3598863" y="6200775"/>
          <p14:tracePt t="29706" x="3635375" y="6200775"/>
          <p14:tracePt t="29716" x="3652838" y="6191250"/>
          <p14:tracePt t="29726" x="3662363" y="6191250"/>
          <p14:tracePt t="29737" x="3679825" y="6181725"/>
          <p14:tracePt t="29767" x="3684588" y="6181725"/>
          <p14:tracePt t="29782" x="3694113" y="6181725"/>
          <p14:tracePt t="29787" x="3703638" y="6181725"/>
          <p14:tracePt t="29797" x="3713163" y="6181725"/>
          <p14:tracePt t="29807" x="3716338" y="6173788"/>
          <p14:tracePt t="29823" x="3725863" y="6173788"/>
          <p14:tracePt t="29826" x="3735388" y="6173788"/>
          <p14:tracePt t="29878" x="3740150" y="6173788"/>
          <p14:tracePt t="29888" x="3767138" y="6154738"/>
          <p14:tracePt t="29908" x="3786188" y="6145213"/>
          <p14:tracePt t="30008" x="3776663" y="6145213"/>
          <p14:tracePt t="30014" x="3767138" y="6145213"/>
          <p14:tracePt t="30024" x="3757613" y="6145213"/>
          <p14:tracePt t="30028" x="3744913" y="6145213"/>
          <p14:tracePt t="30039" x="3735388" y="6145213"/>
          <p14:tracePt t="30050" x="3716338" y="6145213"/>
          <p14:tracePt t="30067" x="3703638" y="6145213"/>
          <p14:tracePt t="30070" x="3694113" y="6145213"/>
          <p14:tracePt t="30094" x="3684588" y="6145213"/>
          <p14:tracePt t="30174" x="3684588" y="6140450"/>
          <p14:tracePt t="30185" x="3698875" y="6122988"/>
          <p14:tracePt t="30190" x="3744913" y="6086475"/>
          <p14:tracePt t="30201" x="3762375" y="6067425"/>
          <p14:tracePt t="30210" x="3822700" y="6045200"/>
          <p14:tracePt t="30216" x="3840163" y="6035675"/>
          <p14:tracePt t="30226" x="3859213" y="6027738"/>
          <p14:tracePt t="30231" x="3890963" y="6018213"/>
          <p14:tracePt t="30240" x="3908425" y="6008688"/>
          <p14:tracePt t="30250" x="3927475" y="5999163"/>
          <p14:tracePt t="30356" x="3922713" y="5999163"/>
          <p14:tracePt t="30362" x="3917950" y="6008688"/>
          <p14:tracePt t="30373" x="3908425" y="6018213"/>
          <p14:tracePt t="30376" x="3898900" y="6022975"/>
          <p14:tracePt t="30387" x="3895725" y="6030913"/>
          <p14:tracePt t="30392" x="3876675" y="6059488"/>
          <p14:tracePt t="30403" x="3854450" y="6067425"/>
          <p14:tracePt t="30412" x="3835400" y="6086475"/>
          <p14:tracePt t="30424" x="3817938" y="6096000"/>
          <p14:tracePt t="30433" x="3808413" y="6103938"/>
          <p14:tracePt t="30492" x="3813175" y="6103938"/>
          <p14:tracePt t="30499" x="3822700" y="6100763"/>
          <p14:tracePt t="30512" x="3830638" y="6096000"/>
          <p14:tracePt t="30523" x="3835400" y="6086475"/>
          <p14:tracePt t="30675" x="3817938" y="6086475"/>
          <p14:tracePt t="30685" x="3798888" y="6091238"/>
          <p14:tracePt t="30692" x="3781425" y="6091238"/>
          <p14:tracePt t="30701" x="3762375" y="6108700"/>
          <p14:tracePt t="30712" x="3744913" y="6118225"/>
          <p14:tracePt t="30721" x="3735388" y="6118225"/>
          <p14:tracePt t="30733" x="3725863" y="6137275"/>
          <p14:tracePt t="31527" x="3730625" y="6132513"/>
          <p14:tracePt t="31547" x="3735388" y="6127750"/>
          <p14:tracePt t="31554" x="3744913" y="6118225"/>
          <p14:tracePt t="31563" x="3752850" y="6108700"/>
          <p14:tracePt t="31573" x="3762375" y="6103938"/>
          <p14:tracePt t="31576" x="3767138" y="6096000"/>
          <p14:tracePt t="31590" x="3776663" y="6086475"/>
          <p14:tracePt t="31599" x="3786188" y="6067425"/>
          <p14:tracePt t="31608" x="3803650" y="6059488"/>
          <p14:tracePt t="31623" x="3813175" y="6054725"/>
          <p14:tracePt t="31643" x="3817938" y="6045200"/>
          <p14:tracePt t="31654" x="3825875" y="6035675"/>
          <p14:tracePt t="31672" x="3835400" y="6030913"/>
          <p14:tracePt t="32561" x="3835400" y="6040438"/>
          <p14:tracePt t="32866" x="3822700" y="6067425"/>
          <p14:tracePt t="32899" x="3803650" y="6076950"/>
          <p14:tracePt t="33097" x="3808413" y="6064250"/>
          <p14:tracePt t="33100" x="3813175" y="6054725"/>
          <p14:tracePt t="33110" x="3859213" y="5976938"/>
          <p14:tracePt t="33117" x="3917950" y="5881688"/>
          <p14:tracePt t="33127" x="3935413" y="5848350"/>
          <p14:tracePt t="36502" x="3954463" y="5848350"/>
          <p14:tracePt t="36508" x="3954463" y="5853113"/>
          <p14:tracePt t="36511" x="3963988" y="5857875"/>
          <p14:tracePt t="36521" x="3963988" y="5876925"/>
          <p14:tracePt t="36524" x="3963988" y="5884863"/>
          <p14:tracePt t="36535" x="3963988" y="5889625"/>
          <p14:tracePt t="36540" x="3963988" y="5899150"/>
          <p14:tracePt t="36567" x="3963988" y="5908675"/>
          <p14:tracePt t="36575" x="3963988" y="5921375"/>
          <p14:tracePt t="36580" x="3981450" y="5945188"/>
          <p14:tracePt t="36599" x="3981450" y="5949950"/>
          <p14:tracePt t="36602" x="3981450" y="5957888"/>
          <p14:tracePt t="36608" x="3981450" y="5967413"/>
          <p14:tracePt t="36619" x="3981450" y="6003925"/>
          <p14:tracePt t="36627" x="3981450" y="6008688"/>
          <p14:tracePt t="36631" x="3981450" y="6018213"/>
          <p14:tracePt t="36642" x="3976688" y="6045200"/>
          <p14:tracePt t="36647" x="3968750" y="6054725"/>
          <p14:tracePt t="36659" x="3940175" y="6091238"/>
          <p14:tracePt t="36668" x="3932238" y="6100763"/>
          <p14:tracePt t="36682" x="3922713" y="6108700"/>
          <p14:tracePt t="36696" x="3917950" y="6108700"/>
          <p14:tracePt t="37065" x="3898900" y="6108700"/>
          <p14:tracePt t="37368" x="3890963" y="6113463"/>
          <p14:tracePt t="37400" x="3886200" y="6122988"/>
          <p14:tracePt t="37419" x="3876675" y="6122988"/>
          <p14:tracePt t="37429" x="3867150" y="6132513"/>
          <p14:tracePt t="37439" x="3859213" y="6137275"/>
          <p14:tracePt t="38155" x="3859213" y="6154738"/>
          <p14:tracePt t="38260" x="3859213" y="6149975"/>
          <p14:tracePt t="38265" x="3881438" y="6132513"/>
          <p14:tracePt t="38277" x="3944938" y="6086475"/>
          <p14:tracePt t="38287" x="4078288" y="5981700"/>
          <p14:tracePt t="38291" x="4127500" y="5930900"/>
          <p14:tracePt t="38300" x="4305300" y="5816600"/>
          <p14:tracePt t="38307" x="4356100" y="5780088"/>
          <p14:tracePt t="38318" x="4506913" y="5689600"/>
          <p14:tracePt t="38326" x="4821238" y="5514975"/>
          <p14:tracePt t="38331" x="4886325" y="5475288"/>
          <p14:tracePt t="38341" x="5141913" y="5327650"/>
          <p14:tracePt t="38346" x="5187950" y="5305425"/>
          <p14:tracePt t="38356" x="5338763" y="5227638"/>
          <p14:tracePt t="38367" x="5653088" y="5032375"/>
          <p14:tracePt t="38370" x="5716588" y="4981575"/>
          <p14:tracePt t="38380" x="6069013" y="4694238"/>
          <p14:tracePt t="38387" x="6151563" y="4621213"/>
          <p14:tracePt t="38396" x="6365875" y="4465638"/>
          <p14:tracePt t="38406" x="6845300" y="4159250"/>
          <p14:tracePt t="38412" x="6927850" y="4105275"/>
          <p14:tracePt t="38423" x="7210425" y="3935413"/>
          <p14:tracePt t="38426" x="7273925" y="3894138"/>
          <p14:tracePt t="38438" x="7407275" y="3835400"/>
          <p14:tracePt t="38446" x="7602538" y="3757613"/>
          <p14:tracePt t="38453" x="7648575" y="3735388"/>
          <p14:tracePt t="38462" x="7816850" y="3689350"/>
          <p14:tracePt t="38468" x="7835900" y="3679825"/>
          <p14:tracePt t="38476" x="7904163" y="3667125"/>
          <p14:tracePt t="38487" x="7999413" y="3638550"/>
          <p14:tracePt t="38492" x="8050213" y="3602038"/>
          <p14:tracePt t="38503" x="8132763" y="3548063"/>
          <p14:tracePt t="38508" x="8137525" y="3543300"/>
          <p14:tracePt t="38519" x="8178800" y="3502025"/>
          <p14:tracePt t="38528" x="8259763" y="3448050"/>
          <p14:tracePt t="38533" x="8269288" y="3438525"/>
          <p14:tracePt t="38542" x="8324850" y="3373438"/>
          <p14:tracePt t="38549" x="8342313" y="3351213"/>
          <p14:tracePt t="38558" x="8378825" y="3309938"/>
          <p14:tracePt t="38570" x="8478838" y="3236913"/>
          <p14:tracePt t="38572" x="8497888" y="3219450"/>
          <p14:tracePt t="38583" x="8575675" y="3114675"/>
          <p14:tracePt t="38589" x="8585200" y="3105150"/>
          <p14:tracePt t="38600" x="8634413" y="3049588"/>
          <p14:tracePt t="38608" x="8721725" y="2968625"/>
          <p14:tracePt t="38612" x="8753475" y="2944813"/>
          <p14:tracePt t="38624" x="8799513" y="2913063"/>
          <p14:tracePt t="38628" x="8804275" y="2903538"/>
          <p14:tracePt t="38639" x="8831263" y="2876550"/>
          <p14:tracePt t="38651" x="8863013" y="2844800"/>
          <p14:tracePt t="38655" x="8885238" y="2825750"/>
          <p14:tracePt t="38666" x="8904288" y="2781300"/>
          <p14:tracePt t="38670" x="8913813" y="2776538"/>
          <p14:tracePt t="38678" x="8921750" y="2757488"/>
          <p14:tracePt t="38689" x="8931275" y="2740025"/>
          <p14:tracePt t="38699" x="8931275" y="2730500"/>
          <p14:tracePt t="38705" x="8931275" y="2720975"/>
          <p14:tracePt t="38719" x="8940800" y="2708275"/>
          <p14:tracePt t="39122" x="8926513" y="2716213"/>
          <p14:tracePt t="39162" x="8909050" y="2735263"/>
          <p14:tracePt t="39195" x="8890000" y="2757488"/>
          <p14:tracePt t="39204" x="8882063" y="2762250"/>
          <p14:tracePt t="39219" x="8872538" y="2781300"/>
          <p14:tracePt t="39228" x="8840788" y="2803525"/>
          <p14:tracePt t="39245" x="8821738" y="2820988"/>
          <p14:tracePt t="39249" x="8812213" y="2830513"/>
          <p14:tracePt t="39267" x="8794750" y="2844800"/>
          <p14:tracePt t="39274" x="8785225" y="2867025"/>
          <p14:tracePt t="39285" x="8758238" y="2894013"/>
          <p14:tracePt t="39294" x="8736013" y="2917825"/>
          <p14:tracePt t="39299" x="8731250" y="2922588"/>
          <p14:tracePt t="39311" x="8699500" y="2963863"/>
          <p14:tracePt t="39316" x="8680450" y="2971800"/>
          <p14:tracePt t="39324" x="8621713" y="3032125"/>
          <p14:tracePt t="39330" x="8612188" y="3054350"/>
          <p14:tracePt t="39340" x="8561388" y="3100388"/>
          <p14:tracePt t="39351" x="8507413" y="3182938"/>
          <p14:tracePt t="39355" x="8461375" y="3219450"/>
          <p14:tracePt t="39366" x="8374063" y="3319463"/>
          <p14:tracePt t="39371" x="8356600" y="3336925"/>
          <p14:tracePt t="39381" x="8310563" y="3373438"/>
          <p14:tracePt t="39390" x="8205788" y="3475038"/>
          <p14:tracePt t="39394" x="8186738" y="3492500"/>
          <p14:tracePt t="39405" x="8108950" y="3584575"/>
          <p14:tracePt t="39410" x="8101013" y="3594100"/>
          <p14:tracePt t="39421" x="8045450" y="3657600"/>
          <p14:tracePt t="39430" x="7972425" y="3776663"/>
          <p14:tracePt t="39437" x="7962900" y="3794125"/>
          <p14:tracePt t="39447" x="7899400" y="3881438"/>
          <p14:tracePt t="39452" x="7889875" y="3913188"/>
          <p14:tracePt t="39460" x="7853363" y="3986213"/>
          <p14:tracePt t="39471" x="7804150" y="4054475"/>
          <p14:tracePt t="39476" x="7789863" y="4081463"/>
          <p14:tracePt t="39487" x="7753350" y="4154488"/>
          <p14:tracePt t="39490" x="7743825" y="4173538"/>
          <p14:tracePt t="39502" x="7726363" y="4205288"/>
          <p14:tracePt t="39510" x="7702550" y="4278313"/>
          <p14:tracePt t="39517" x="7702550" y="4283075"/>
          <p14:tracePt t="39526" x="7685088" y="4310063"/>
          <p14:tracePt t="39530" x="7685088" y="4319588"/>
          <p14:tracePt t="39543" x="7675563" y="4329113"/>
          <p14:tracePt t="39554" x="7643813" y="4365625"/>
          <p14:tracePt t="39562" x="7639050" y="4373563"/>
          <p14:tracePt t="39566" x="7629525" y="4392613"/>
          <p14:tracePt t="39587" x="7629525" y="4410075"/>
          <p14:tracePt t="39593" x="7621588" y="4414838"/>
          <p14:tracePt t="39657" x="7612063" y="4414838"/>
          <p14:tracePt t="39779" x="7607300" y="4414838"/>
          <p14:tracePt t="39789" x="7597775" y="4414838"/>
          <p14:tracePt t="39799" x="7580313" y="4397375"/>
          <p14:tracePt t="39809" x="7570788" y="4356100"/>
          <p14:tracePt t="65124" x="7575550" y="4356100"/>
        </p14:tracePtLst>
      </p14:laserTraceLst>
    </p:ext>
  </p:extLs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0.2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0.4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4</Words>
  <Application>Microsoft Office PowerPoint</Application>
  <PresentationFormat>Widescreen</PresentationFormat>
  <Paragraphs>119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9</cp:revision>
  <dcterms:created xsi:type="dcterms:W3CDTF">2020-11-13T04:21:00Z</dcterms:created>
  <dcterms:modified xsi:type="dcterms:W3CDTF">2021-08-19T05:11:21Z</dcterms:modified>
</cp:coreProperties>
</file>